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notesSlides/notesSlide1.xml" ContentType="application/vnd.openxmlformats-officedocument.presentationml.notesSlide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7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notesSlides/notesSlide3.xml" ContentType="application/vnd.openxmlformats-officedocument.presentationml.notesSlide+xml"/>
  <Override PartName="/ppt/charts/chart8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9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0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1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2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69" r:id="rId2"/>
    <p:sldId id="270" r:id="rId3"/>
    <p:sldId id="271" r:id="rId4"/>
    <p:sldId id="261" r:id="rId5"/>
    <p:sldId id="259" r:id="rId6"/>
    <p:sldId id="272" r:id="rId7"/>
    <p:sldId id="274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4" userDrawn="1">
          <p15:clr>
            <a:srgbClr val="A4A3A4"/>
          </p15:clr>
        </p15:guide>
        <p15:guide id="2" pos="285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MOU" lastIdx="7" clrIdx="0">
    <p:extLst/>
  </p:cmAuthor>
  <p:cmAuthor id="2" name="Microsoft Office User" initials="Office" lastIdx="0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432FF"/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941"/>
    <p:restoredTop sz="93667"/>
  </p:normalViewPr>
  <p:slideViewPr>
    <p:cSldViewPr snapToGrid="0" snapToObjects="1" showGuides="1">
      <p:cViewPr varScale="1">
        <p:scale>
          <a:sx n="64" d="100"/>
          <a:sy n="64" d="100"/>
        </p:scale>
        <p:origin x="1596" y="52"/>
      </p:cViewPr>
      <p:guideLst>
        <p:guide orient="horz" pos="2184"/>
        <p:guide pos="285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punamdalai\Documents\AKRON\DATA\Plate%20Reader\Na+,%20K+%20Channel\Na-K%20Kinetics%20-%20SBFI-PBFI%20new\DOPC-OA%20(5-1)%20+%20SBFI-PBFI%20(with%20Oxonol)_04-15-2019_Xianfeng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punamdalai\Documents\AKRON\Manuscript%20and%20Protocols\Na+%20-%20K+%20Channel%20Paper\Manuscript\data%20from%20Xianfeng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punamdalai\Documents\AKRON\Manuscript%20and%20Protocols\Na+%20-%20K+%20Channel%20Paper\Manuscript\XZ_PD%20Data%202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punamdalai\Documents\AKRON\Manuscript%20and%20Protocols\Na+%20-%20K+%20Channel%20Paper\Manuscript\XZ_PD%20Data%202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punamdalai\Documents\AKRON\Manuscript%20and%20Protocols\Na+%20-%20K+%20Channel%20Paper\Manuscript\supporting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punamdalai\Documents\AKRON\Manuscript%20and%20Protocols\Na+%20-%20K+%20Channel%20Paper\Manuscript\data%20from%20Xianfeng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punamdalai\Documents\AKRON\Manuscript%20and%20Protocols\Na+%20-%20K+%20Channel%20Paper\Manuscript\data%20from%20Xianfeng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punamdalai\Documents\AKRON\Manuscript%20and%20Protocols\Na+%20-%20K+%20Channel%20Paper\Manuscript\data%20from%20Xianfeng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punamdalai\Documents\AKRON\Manuscript%20and%20Protocols\Na+%20-%20K+%20Channel%20Paper\Manuscript\XZ_PD%20Data%20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punamdalai\Documents\AKRON\Manuscript%20and%20Protocols\Na+%20-%20K+%20Channel%20Paper\Manuscript\XZ_PD%20Data%202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punamdalai\Documents\AKRON\Manuscript%20and%20Protocols\Na+%20-%20K+%20Channel%20Paper\Manuscript\data%20from%20Xianfeng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punamdalai\Documents\AKRON\Manuscript%20and%20Protocols\Na+%20-%20K+%20Channel%20Paper\Manuscript\data%20from%20Xianfeng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2077165354331"/>
          <c:y val="5.9023836549375701E-2"/>
          <c:w val="0.80297401574803096"/>
          <c:h val="0.755928749541948"/>
        </c:manualLayout>
      </c:layout>
      <c:scatterChart>
        <c:scatterStyle val="lineMarker"/>
        <c:varyColors val="0"/>
        <c:ser>
          <c:idx val="0"/>
          <c:order val="0"/>
          <c:tx>
            <c:v>PBFI (Ex 336 nm / Em 508 nm)</c:v>
          </c:tx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Plate 1 - Sheet1'!$C$51:$C$146</c:f>
              <c:numCache>
                <c:formatCode>General</c:formatCode>
                <c:ptCount val="9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</c:numCache>
            </c:numRef>
          </c:xVal>
          <c:yVal>
            <c:numRef>
              <c:f>'Plate 1 - Sheet1'!$D$51:$D$146</c:f>
              <c:numCache>
                <c:formatCode>General</c:formatCode>
                <c:ptCount val="96"/>
                <c:pt idx="0">
                  <c:v>268</c:v>
                </c:pt>
                <c:pt idx="1">
                  <c:v>276</c:v>
                </c:pt>
                <c:pt idx="2">
                  <c:v>244</c:v>
                </c:pt>
                <c:pt idx="3">
                  <c:v>263</c:v>
                </c:pt>
                <c:pt idx="4">
                  <c:v>193</c:v>
                </c:pt>
                <c:pt idx="5">
                  <c:v>212</c:v>
                </c:pt>
                <c:pt idx="6">
                  <c:v>227</c:v>
                </c:pt>
                <c:pt idx="7">
                  <c:v>226</c:v>
                </c:pt>
                <c:pt idx="8">
                  <c:v>220</c:v>
                </c:pt>
                <c:pt idx="9">
                  <c:v>278</c:v>
                </c:pt>
                <c:pt idx="10">
                  <c:v>291</c:v>
                </c:pt>
                <c:pt idx="11">
                  <c:v>306</c:v>
                </c:pt>
                <c:pt idx="12">
                  <c:v>205</c:v>
                </c:pt>
                <c:pt idx="13">
                  <c:v>187</c:v>
                </c:pt>
                <c:pt idx="14">
                  <c:v>198</c:v>
                </c:pt>
                <c:pt idx="15">
                  <c:v>274</c:v>
                </c:pt>
                <c:pt idx="16">
                  <c:v>240</c:v>
                </c:pt>
                <c:pt idx="17">
                  <c:v>232</c:v>
                </c:pt>
                <c:pt idx="18">
                  <c:v>242</c:v>
                </c:pt>
                <c:pt idx="19">
                  <c:v>229</c:v>
                </c:pt>
                <c:pt idx="20">
                  <c:v>300</c:v>
                </c:pt>
                <c:pt idx="21">
                  <c:v>943</c:v>
                </c:pt>
                <c:pt idx="22">
                  <c:v>3011</c:v>
                </c:pt>
                <c:pt idx="23">
                  <c:v>8070</c:v>
                </c:pt>
                <c:pt idx="24">
                  <c:v>19843</c:v>
                </c:pt>
                <c:pt idx="25">
                  <c:v>36298</c:v>
                </c:pt>
                <c:pt idx="26">
                  <c:v>52272</c:v>
                </c:pt>
                <c:pt idx="27">
                  <c:v>60214</c:v>
                </c:pt>
                <c:pt idx="28">
                  <c:v>63854</c:v>
                </c:pt>
                <c:pt idx="29">
                  <c:v>62037</c:v>
                </c:pt>
                <c:pt idx="30">
                  <c:v>57139</c:v>
                </c:pt>
                <c:pt idx="31">
                  <c:v>52650</c:v>
                </c:pt>
                <c:pt idx="32">
                  <c:v>45967</c:v>
                </c:pt>
                <c:pt idx="33">
                  <c:v>37932</c:v>
                </c:pt>
                <c:pt idx="34">
                  <c:v>31037</c:v>
                </c:pt>
                <c:pt idx="35">
                  <c:v>25715</c:v>
                </c:pt>
                <c:pt idx="36">
                  <c:v>20947</c:v>
                </c:pt>
                <c:pt idx="37">
                  <c:v>16999</c:v>
                </c:pt>
                <c:pt idx="38">
                  <c:v>13298</c:v>
                </c:pt>
                <c:pt idx="39">
                  <c:v>10764</c:v>
                </c:pt>
                <c:pt idx="40">
                  <c:v>9226</c:v>
                </c:pt>
                <c:pt idx="41">
                  <c:v>7885</c:v>
                </c:pt>
                <c:pt idx="42">
                  <c:v>7252</c:v>
                </c:pt>
                <c:pt idx="43">
                  <c:v>6505</c:v>
                </c:pt>
                <c:pt idx="44">
                  <c:v>6538</c:v>
                </c:pt>
                <c:pt idx="45">
                  <c:v>5893</c:v>
                </c:pt>
                <c:pt idx="46">
                  <c:v>6077</c:v>
                </c:pt>
                <c:pt idx="47">
                  <c:v>6536</c:v>
                </c:pt>
                <c:pt idx="48">
                  <c:v>7454</c:v>
                </c:pt>
                <c:pt idx="49">
                  <c:v>8154</c:v>
                </c:pt>
                <c:pt idx="50">
                  <c:v>9084</c:v>
                </c:pt>
                <c:pt idx="51">
                  <c:v>10164</c:v>
                </c:pt>
                <c:pt idx="52">
                  <c:v>10753</c:v>
                </c:pt>
                <c:pt idx="53">
                  <c:v>11786</c:v>
                </c:pt>
                <c:pt idx="54">
                  <c:v>13005</c:v>
                </c:pt>
                <c:pt idx="55">
                  <c:v>14265</c:v>
                </c:pt>
                <c:pt idx="56">
                  <c:v>15094</c:v>
                </c:pt>
                <c:pt idx="57">
                  <c:v>15230</c:v>
                </c:pt>
                <c:pt idx="58">
                  <c:v>16261</c:v>
                </c:pt>
                <c:pt idx="59">
                  <c:v>17727</c:v>
                </c:pt>
                <c:pt idx="60">
                  <c:v>18881</c:v>
                </c:pt>
                <c:pt idx="61">
                  <c:v>19456</c:v>
                </c:pt>
                <c:pt idx="62">
                  <c:v>20994</c:v>
                </c:pt>
                <c:pt idx="63">
                  <c:v>20856</c:v>
                </c:pt>
                <c:pt idx="64">
                  <c:v>21591</c:v>
                </c:pt>
                <c:pt idx="65">
                  <c:v>21132</c:v>
                </c:pt>
                <c:pt idx="66">
                  <c:v>21484</c:v>
                </c:pt>
                <c:pt idx="67">
                  <c:v>21190</c:v>
                </c:pt>
                <c:pt idx="68">
                  <c:v>21002</c:v>
                </c:pt>
                <c:pt idx="69">
                  <c:v>21139</c:v>
                </c:pt>
                <c:pt idx="70">
                  <c:v>20580</c:v>
                </c:pt>
                <c:pt idx="71">
                  <c:v>20245</c:v>
                </c:pt>
                <c:pt idx="72">
                  <c:v>19642</c:v>
                </c:pt>
                <c:pt idx="73">
                  <c:v>19346</c:v>
                </c:pt>
                <c:pt idx="74">
                  <c:v>19236</c:v>
                </c:pt>
                <c:pt idx="75">
                  <c:v>18767</c:v>
                </c:pt>
                <c:pt idx="76">
                  <c:v>17878</c:v>
                </c:pt>
                <c:pt idx="77">
                  <c:v>17140</c:v>
                </c:pt>
                <c:pt idx="78">
                  <c:v>16078</c:v>
                </c:pt>
                <c:pt idx="79">
                  <c:v>15576</c:v>
                </c:pt>
                <c:pt idx="80">
                  <c:v>14770</c:v>
                </c:pt>
                <c:pt idx="81">
                  <c:v>13862</c:v>
                </c:pt>
                <c:pt idx="82">
                  <c:v>13279</c:v>
                </c:pt>
                <c:pt idx="83">
                  <c:v>12829</c:v>
                </c:pt>
                <c:pt idx="84">
                  <c:v>11770</c:v>
                </c:pt>
                <c:pt idx="85">
                  <c:v>11444</c:v>
                </c:pt>
                <c:pt idx="86">
                  <c:v>11027</c:v>
                </c:pt>
                <c:pt idx="87">
                  <c:v>10371</c:v>
                </c:pt>
                <c:pt idx="88">
                  <c:v>9882</c:v>
                </c:pt>
                <c:pt idx="89">
                  <c:v>9442</c:v>
                </c:pt>
                <c:pt idx="90">
                  <c:v>8895</c:v>
                </c:pt>
                <c:pt idx="91">
                  <c:v>8629</c:v>
                </c:pt>
                <c:pt idx="92">
                  <c:v>7940</c:v>
                </c:pt>
                <c:pt idx="93">
                  <c:v>7494</c:v>
                </c:pt>
                <c:pt idx="94">
                  <c:v>7005</c:v>
                </c:pt>
                <c:pt idx="95">
                  <c:v>645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2F9-B94D-977D-4BFB49FFF7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92325872"/>
        <c:axId val="1192388096"/>
      </c:scatterChart>
      <c:valAx>
        <c:axId val="1192325872"/>
        <c:scaling>
          <c:orientation val="minMax"/>
          <c:max val="90"/>
          <c:min val="1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Fractions</a:t>
                </a:r>
              </a:p>
            </c:rich>
          </c:tx>
          <c:layout>
            <c:manualLayout>
              <c:xMode val="edge"/>
              <c:yMode val="edge"/>
              <c:x val="0.441170275590551"/>
              <c:y val="0.9082631583651360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1192388096"/>
        <c:crosses val="autoZero"/>
        <c:crossBetween val="midCat"/>
      </c:valAx>
      <c:valAx>
        <c:axId val="119238809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Fluorescence Intensity</a:t>
                </a:r>
              </a:p>
            </c:rich>
          </c:tx>
          <c:layout>
            <c:manualLayout>
              <c:xMode val="edge"/>
              <c:yMode val="edge"/>
              <c:x val="1.7500000000000002E-2"/>
              <c:y val="0.26963275447549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119232587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9177618110236196"/>
          <c:y val="0.36814321592320798"/>
          <c:w val="0.368223818897638"/>
          <c:h val="0.146042346295816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3344925634295705E-2"/>
          <c:y val="2.54283318751823E-2"/>
          <c:w val="0.77967856181438799"/>
          <c:h val="0.92714858559346702"/>
        </c:manualLayout>
      </c:layout>
      <c:scatterChart>
        <c:scatterStyle val="smoothMarker"/>
        <c:varyColors val="0"/>
        <c:ser>
          <c:idx val="0"/>
          <c:order val="0"/>
          <c:tx>
            <c:v>Vesicles (OA-POPC (1:5))</c:v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P$2:$P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Q$2:$Q$53</c:f>
              <c:numCache>
                <c:formatCode>General</c:formatCode>
                <c:ptCount val="52"/>
                <c:pt idx="0">
                  <c:v>0</c:v>
                </c:pt>
                <c:pt idx="1">
                  <c:v>-6.5570000000000003E-2</c:v>
                </c:pt>
                <c:pt idx="2">
                  <c:v>-6.386E-2</c:v>
                </c:pt>
                <c:pt idx="3">
                  <c:v>-3.6409999999999998E-2</c:v>
                </c:pt>
                <c:pt idx="4">
                  <c:v>-4.215E-2</c:v>
                </c:pt>
                <c:pt idx="5">
                  <c:v>-0.11074000000000001</c:v>
                </c:pt>
                <c:pt idx="6">
                  <c:v>-0.11802</c:v>
                </c:pt>
                <c:pt idx="7">
                  <c:v>-0.10541</c:v>
                </c:pt>
                <c:pt idx="8">
                  <c:v>-0.10878</c:v>
                </c:pt>
                <c:pt idx="9">
                  <c:v>-9.0499999999999997E-2</c:v>
                </c:pt>
                <c:pt idx="10">
                  <c:v>-0.15468000000000001</c:v>
                </c:pt>
                <c:pt idx="11">
                  <c:v>-0.14804999999999999</c:v>
                </c:pt>
                <c:pt idx="12">
                  <c:v>-0.13278999999999999</c:v>
                </c:pt>
                <c:pt idx="13">
                  <c:v>-0.16378000000000001</c:v>
                </c:pt>
                <c:pt idx="14">
                  <c:v>-0.14473</c:v>
                </c:pt>
                <c:pt idx="15">
                  <c:v>-0.14196</c:v>
                </c:pt>
                <c:pt idx="16">
                  <c:v>-0.19742999999999999</c:v>
                </c:pt>
                <c:pt idx="17">
                  <c:v>-0.1522</c:v>
                </c:pt>
                <c:pt idx="18">
                  <c:v>-0.17996999999999999</c:v>
                </c:pt>
                <c:pt idx="19">
                  <c:v>-0.17968999999999999</c:v>
                </c:pt>
                <c:pt idx="20">
                  <c:v>-0.17723</c:v>
                </c:pt>
                <c:pt idx="21">
                  <c:v>-0.23043</c:v>
                </c:pt>
                <c:pt idx="22">
                  <c:v>-0.21154000000000001</c:v>
                </c:pt>
                <c:pt idx="23">
                  <c:v>-0.19825000000000001</c:v>
                </c:pt>
                <c:pt idx="24">
                  <c:v>-0.18570999999999999</c:v>
                </c:pt>
                <c:pt idx="25">
                  <c:v>-0.18134</c:v>
                </c:pt>
                <c:pt idx="26">
                  <c:v>-0.20829</c:v>
                </c:pt>
                <c:pt idx="27">
                  <c:v>-0.19361999999999999</c:v>
                </c:pt>
                <c:pt idx="28">
                  <c:v>-0.23311999999999999</c:v>
                </c:pt>
                <c:pt idx="29">
                  <c:v>-0.20612</c:v>
                </c:pt>
                <c:pt idx="30">
                  <c:v>-0.20748</c:v>
                </c:pt>
                <c:pt idx="31">
                  <c:v>-0.21398</c:v>
                </c:pt>
                <c:pt idx="32">
                  <c:v>-0.22611999999999999</c:v>
                </c:pt>
                <c:pt idx="33">
                  <c:v>-0.19170999999999999</c:v>
                </c:pt>
                <c:pt idx="34">
                  <c:v>-0.20096</c:v>
                </c:pt>
                <c:pt idx="35">
                  <c:v>-0.15744</c:v>
                </c:pt>
                <c:pt idx="36">
                  <c:v>-0.14998</c:v>
                </c:pt>
                <c:pt idx="37">
                  <c:v>-0.13557</c:v>
                </c:pt>
                <c:pt idx="38">
                  <c:v>-0.16844999999999999</c:v>
                </c:pt>
                <c:pt idx="39">
                  <c:v>-0.16102</c:v>
                </c:pt>
                <c:pt idx="40">
                  <c:v>-0.1613</c:v>
                </c:pt>
                <c:pt idx="41">
                  <c:v>-0.19225999999999999</c:v>
                </c:pt>
                <c:pt idx="42">
                  <c:v>-0.17366999999999999</c:v>
                </c:pt>
                <c:pt idx="43">
                  <c:v>-0.15634000000000001</c:v>
                </c:pt>
                <c:pt idx="44">
                  <c:v>-0.23069999999999999</c:v>
                </c:pt>
                <c:pt idx="45">
                  <c:v>-0.19253000000000001</c:v>
                </c:pt>
                <c:pt idx="46">
                  <c:v>-0.21289</c:v>
                </c:pt>
                <c:pt idx="47">
                  <c:v>-0.13167999999999999</c:v>
                </c:pt>
                <c:pt idx="48">
                  <c:v>-0.21965000000000001</c:v>
                </c:pt>
                <c:pt idx="49">
                  <c:v>-0.18325</c:v>
                </c:pt>
                <c:pt idx="50">
                  <c:v>-0.20041999999999999</c:v>
                </c:pt>
                <c:pt idx="51">
                  <c:v>-0.18706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910-7E44-9707-0579363EAB3E}"/>
            </c:ext>
          </c:extLst>
        </c:ser>
        <c:ser>
          <c:idx val="1"/>
          <c:order val="1"/>
          <c:tx>
            <c:v>Vesicles + Na+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P$2:$P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S$2:$S$53</c:f>
              <c:numCache>
                <c:formatCode>General</c:formatCode>
                <c:ptCount val="52"/>
                <c:pt idx="0">
                  <c:v>0</c:v>
                </c:pt>
                <c:pt idx="1">
                  <c:v>2.1676500000000001</c:v>
                </c:pt>
                <c:pt idx="2">
                  <c:v>4.1249099999999617</c:v>
                </c:pt>
                <c:pt idx="3">
                  <c:v>6.3984199999999847</c:v>
                </c:pt>
                <c:pt idx="4">
                  <c:v>7.53742</c:v>
                </c:pt>
                <c:pt idx="5">
                  <c:v>7.7408400000000004</c:v>
                </c:pt>
                <c:pt idx="6">
                  <c:v>7.9765600000000001</c:v>
                </c:pt>
                <c:pt idx="7">
                  <c:v>7.6487600000000002</c:v>
                </c:pt>
                <c:pt idx="8">
                  <c:v>7.2688199999999856</c:v>
                </c:pt>
                <c:pt idx="9">
                  <c:v>7.4292299999999996</c:v>
                </c:pt>
                <c:pt idx="10">
                  <c:v>7.33596</c:v>
                </c:pt>
                <c:pt idx="11">
                  <c:v>7.1365299999999996</c:v>
                </c:pt>
                <c:pt idx="12">
                  <c:v>6.7513899999999998</c:v>
                </c:pt>
                <c:pt idx="13">
                  <c:v>7.2884900000000004</c:v>
                </c:pt>
                <c:pt idx="14">
                  <c:v>6.7744200000000001</c:v>
                </c:pt>
                <c:pt idx="15">
                  <c:v>6.4351399999999996</c:v>
                </c:pt>
                <c:pt idx="16">
                  <c:v>6.3301499999999997</c:v>
                </c:pt>
                <c:pt idx="17">
                  <c:v>5.9336700000000002</c:v>
                </c:pt>
                <c:pt idx="18">
                  <c:v>5.9273099999999976</c:v>
                </c:pt>
                <c:pt idx="19">
                  <c:v>6.2191299999999998</c:v>
                </c:pt>
                <c:pt idx="20">
                  <c:v>5.7860300000000002</c:v>
                </c:pt>
                <c:pt idx="21">
                  <c:v>5.5122799999999996</c:v>
                </c:pt>
                <c:pt idx="22">
                  <c:v>5.9029999999999996</c:v>
                </c:pt>
                <c:pt idx="23">
                  <c:v>5.2236399999999996</c:v>
                </c:pt>
                <c:pt idx="24">
                  <c:v>5.2330300000000003</c:v>
                </c:pt>
                <c:pt idx="25">
                  <c:v>5.5797699999999999</c:v>
                </c:pt>
                <c:pt idx="26">
                  <c:v>5.8536400000000004</c:v>
                </c:pt>
                <c:pt idx="27">
                  <c:v>5.7581799999999976</c:v>
                </c:pt>
                <c:pt idx="28">
                  <c:v>6.3064299999999998</c:v>
                </c:pt>
                <c:pt idx="29">
                  <c:v>6.1035399999999944</c:v>
                </c:pt>
                <c:pt idx="30">
                  <c:v>6.1682199999999856</c:v>
                </c:pt>
                <c:pt idx="31">
                  <c:v>6.3471499999999956</c:v>
                </c:pt>
                <c:pt idx="32">
                  <c:v>5.8599199999999856</c:v>
                </c:pt>
                <c:pt idx="33">
                  <c:v>6.3233600000000001</c:v>
                </c:pt>
                <c:pt idx="34">
                  <c:v>6.4917800000000003</c:v>
                </c:pt>
                <c:pt idx="35">
                  <c:v>6.6887799999999986</c:v>
                </c:pt>
                <c:pt idx="36">
                  <c:v>6.6636600000000001</c:v>
                </c:pt>
                <c:pt idx="37">
                  <c:v>6.6291499999999957</c:v>
                </c:pt>
                <c:pt idx="38">
                  <c:v>6.4593499999999997</c:v>
                </c:pt>
                <c:pt idx="39">
                  <c:v>6.3687399999999856</c:v>
                </c:pt>
                <c:pt idx="40">
                  <c:v>6.8133900000000001</c:v>
                </c:pt>
                <c:pt idx="41">
                  <c:v>6.6398400000000004</c:v>
                </c:pt>
                <c:pt idx="42">
                  <c:v>6.50108</c:v>
                </c:pt>
                <c:pt idx="43">
                  <c:v>6.2224699999999986</c:v>
                </c:pt>
                <c:pt idx="44">
                  <c:v>6.5583299999999998</c:v>
                </c:pt>
                <c:pt idx="45">
                  <c:v>6.4052899999999999</c:v>
                </c:pt>
                <c:pt idx="46">
                  <c:v>6.9880000000000004</c:v>
                </c:pt>
                <c:pt idx="47">
                  <c:v>7.0573999999999986</c:v>
                </c:pt>
                <c:pt idx="48">
                  <c:v>7.1019600000000001</c:v>
                </c:pt>
                <c:pt idx="49">
                  <c:v>7.3121799999999846</c:v>
                </c:pt>
                <c:pt idx="50">
                  <c:v>6.7987500000000001</c:v>
                </c:pt>
                <c:pt idx="51">
                  <c:v>7.098129999999997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910-7E44-9707-0579363EAB3E}"/>
            </c:ext>
          </c:extLst>
        </c:ser>
        <c:ser>
          <c:idx val="2"/>
          <c:order val="2"/>
          <c:tx>
            <c:v>Vesicles + Na+ + Monensin</c:v>
          </c:tx>
          <c:spPr>
            <a:ln w="19050" cap="rnd">
              <a:solidFill>
                <a:srgbClr val="0432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432FF"/>
              </a:solidFill>
              <a:ln w="9525">
                <a:solidFill>
                  <a:srgbClr val="0432FF"/>
                </a:solidFill>
              </a:ln>
              <a:effectLst/>
            </c:spPr>
          </c:marker>
          <c:xVal>
            <c:numRef>
              <c:f>Sheet1!$P$2:$P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R$2:$R$53</c:f>
              <c:numCache>
                <c:formatCode>General</c:formatCode>
                <c:ptCount val="52"/>
                <c:pt idx="0">
                  <c:v>0</c:v>
                </c:pt>
                <c:pt idx="1">
                  <c:v>1.04586</c:v>
                </c:pt>
                <c:pt idx="2">
                  <c:v>2.48386</c:v>
                </c:pt>
                <c:pt idx="3">
                  <c:v>3.6105399999999999</c:v>
                </c:pt>
                <c:pt idx="4">
                  <c:v>4.6486999999999998</c:v>
                </c:pt>
                <c:pt idx="5">
                  <c:v>5.1734900000000001</c:v>
                </c:pt>
                <c:pt idx="6">
                  <c:v>5.5255299999999874</c:v>
                </c:pt>
                <c:pt idx="7">
                  <c:v>6.1245399999999552</c:v>
                </c:pt>
                <c:pt idx="8">
                  <c:v>6.1918699999999998</c:v>
                </c:pt>
                <c:pt idx="9">
                  <c:v>7.3050499999999996</c:v>
                </c:pt>
                <c:pt idx="10">
                  <c:v>7.0067899999999996</c:v>
                </c:pt>
                <c:pt idx="11">
                  <c:v>6.9656599999999997</c:v>
                </c:pt>
                <c:pt idx="12">
                  <c:v>7.1852499999999999</c:v>
                </c:pt>
                <c:pt idx="13">
                  <c:v>6.9506399999999999</c:v>
                </c:pt>
                <c:pt idx="14">
                  <c:v>7.7159399999999856</c:v>
                </c:pt>
                <c:pt idx="15">
                  <c:v>7.2206799999999998</c:v>
                </c:pt>
                <c:pt idx="16">
                  <c:v>6.7863899999999999</c:v>
                </c:pt>
                <c:pt idx="17">
                  <c:v>6.8814700000000002</c:v>
                </c:pt>
                <c:pt idx="18">
                  <c:v>7.48</c:v>
                </c:pt>
                <c:pt idx="19">
                  <c:v>7.8877899999999856</c:v>
                </c:pt>
                <c:pt idx="20">
                  <c:v>7.7205299999999957</c:v>
                </c:pt>
                <c:pt idx="21">
                  <c:v>7.6157599999999857</c:v>
                </c:pt>
                <c:pt idx="22">
                  <c:v>7.5095999999999998</c:v>
                </c:pt>
                <c:pt idx="23">
                  <c:v>8.2134500000000035</c:v>
                </c:pt>
                <c:pt idx="24">
                  <c:v>8.86768</c:v>
                </c:pt>
                <c:pt idx="25">
                  <c:v>9.6026799999999994</c:v>
                </c:pt>
                <c:pt idx="26">
                  <c:v>9.8450799999999994</c:v>
                </c:pt>
                <c:pt idx="27">
                  <c:v>9.8669500000000028</c:v>
                </c:pt>
                <c:pt idx="28">
                  <c:v>9.9338700000000006</c:v>
                </c:pt>
                <c:pt idx="29">
                  <c:v>9.5612600000000008</c:v>
                </c:pt>
                <c:pt idx="30">
                  <c:v>9.4286300000000001</c:v>
                </c:pt>
                <c:pt idx="31">
                  <c:v>9.0109300000000001</c:v>
                </c:pt>
                <c:pt idx="32">
                  <c:v>8.4470600000000005</c:v>
                </c:pt>
                <c:pt idx="33">
                  <c:v>8.8211300000000001</c:v>
                </c:pt>
                <c:pt idx="34">
                  <c:v>8.0978300000000001</c:v>
                </c:pt>
                <c:pt idx="35">
                  <c:v>8.4301200000000005</c:v>
                </c:pt>
                <c:pt idx="36">
                  <c:v>7.6793399999999998</c:v>
                </c:pt>
                <c:pt idx="37">
                  <c:v>8.1611000000000011</c:v>
                </c:pt>
                <c:pt idx="38">
                  <c:v>8.3460100000000015</c:v>
                </c:pt>
                <c:pt idx="39">
                  <c:v>8.1253400000000013</c:v>
                </c:pt>
                <c:pt idx="40">
                  <c:v>8.6482499999999973</c:v>
                </c:pt>
                <c:pt idx="41">
                  <c:v>7.9888399999999997</c:v>
                </c:pt>
                <c:pt idx="42">
                  <c:v>8.3711400000000005</c:v>
                </c:pt>
                <c:pt idx="43">
                  <c:v>8.7253699999999998</c:v>
                </c:pt>
                <c:pt idx="44">
                  <c:v>8.5805700000000016</c:v>
                </c:pt>
                <c:pt idx="45">
                  <c:v>8.5719400000000014</c:v>
                </c:pt>
                <c:pt idx="46">
                  <c:v>8.6186699999999963</c:v>
                </c:pt>
                <c:pt idx="47">
                  <c:v>9.2603100000000005</c:v>
                </c:pt>
                <c:pt idx="48">
                  <c:v>9.1067300000000007</c:v>
                </c:pt>
                <c:pt idx="49">
                  <c:v>8.8139900000000004</c:v>
                </c:pt>
                <c:pt idx="50">
                  <c:v>8.6657100000000007</c:v>
                </c:pt>
                <c:pt idx="51">
                  <c:v>9.3344500000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2910-7E44-9707-0579363EAB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91001248"/>
        <c:axId val="1091003296"/>
      </c:scatterChart>
      <c:valAx>
        <c:axId val="1091001248"/>
        <c:scaling>
          <c:orientation val="minMax"/>
          <c:max val="10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1003296"/>
        <c:crosses val="autoZero"/>
        <c:crossBetween val="midCat"/>
        <c:majorUnit val="20"/>
      </c:valAx>
      <c:valAx>
        <c:axId val="1091003296"/>
        <c:scaling>
          <c:orientation val="minMax"/>
          <c:max val="15"/>
          <c:min val="-0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1001248"/>
        <c:crosses val="autoZero"/>
        <c:crossBetween val="midCat"/>
        <c:majorUnit val="2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2485849352654"/>
          <c:y val="2.54283318751823E-2"/>
          <c:w val="0.764497197765031"/>
          <c:h val="0.87657818688001399"/>
        </c:manualLayout>
      </c:layout>
      <c:scatterChart>
        <c:scatterStyle val="smoothMarker"/>
        <c:varyColors val="0"/>
        <c:ser>
          <c:idx val="0"/>
          <c:order val="0"/>
          <c:tx>
            <c:v>OA/DOPC (1:1)</c:v>
          </c:tx>
          <c:spPr>
            <a:ln w="19050" cap="rnd">
              <a:solidFill>
                <a:srgbClr val="0432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432FF"/>
              </a:solidFill>
              <a:ln w="9525">
                <a:solidFill>
                  <a:srgbClr val="0432FF"/>
                </a:solidFill>
              </a:ln>
              <a:effectLst/>
            </c:spPr>
          </c:marker>
          <c:xVal>
            <c:numRef>
              <c:f>Sheet1!$F$2:$F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I$2:$I$53</c:f>
              <c:numCache>
                <c:formatCode>General</c:formatCode>
                <c:ptCount val="52"/>
                <c:pt idx="0">
                  <c:v>0</c:v>
                </c:pt>
                <c:pt idx="1">
                  <c:v>3.33616</c:v>
                </c:pt>
                <c:pt idx="2">
                  <c:v>4.8586600000000004</c:v>
                </c:pt>
                <c:pt idx="3">
                  <c:v>6.3992300000000002</c:v>
                </c:pt>
                <c:pt idx="4">
                  <c:v>7.3617600000000003</c:v>
                </c:pt>
                <c:pt idx="5">
                  <c:v>7.5203699999999998</c:v>
                </c:pt>
                <c:pt idx="6">
                  <c:v>7.5292000000000003</c:v>
                </c:pt>
                <c:pt idx="7">
                  <c:v>7.4851900000000002</c:v>
                </c:pt>
                <c:pt idx="8">
                  <c:v>7.5433399999999997</c:v>
                </c:pt>
                <c:pt idx="9">
                  <c:v>6.8817500000000003</c:v>
                </c:pt>
                <c:pt idx="10">
                  <c:v>6.2453500000000002</c:v>
                </c:pt>
                <c:pt idx="11">
                  <c:v>5.9597600000000002</c:v>
                </c:pt>
                <c:pt idx="12">
                  <c:v>5.5748300000000004</c:v>
                </c:pt>
                <c:pt idx="13">
                  <c:v>5.0510599999999997</c:v>
                </c:pt>
                <c:pt idx="14">
                  <c:v>4.98773</c:v>
                </c:pt>
                <c:pt idx="15">
                  <c:v>5.0605099999999954</c:v>
                </c:pt>
                <c:pt idx="16">
                  <c:v>5.4115700000000002</c:v>
                </c:pt>
                <c:pt idx="17">
                  <c:v>5.40151</c:v>
                </c:pt>
                <c:pt idx="18">
                  <c:v>5.7083000000000004</c:v>
                </c:pt>
                <c:pt idx="19">
                  <c:v>6.2020799999999996</c:v>
                </c:pt>
                <c:pt idx="20">
                  <c:v>6.1405799999999946</c:v>
                </c:pt>
                <c:pt idx="21">
                  <c:v>6.4454099999999999</c:v>
                </c:pt>
                <c:pt idx="22">
                  <c:v>5.9680499999999999</c:v>
                </c:pt>
                <c:pt idx="23">
                  <c:v>5.4760600000000004</c:v>
                </c:pt>
                <c:pt idx="24">
                  <c:v>5.5503</c:v>
                </c:pt>
                <c:pt idx="25">
                  <c:v>5.48752</c:v>
                </c:pt>
                <c:pt idx="26">
                  <c:v>5.3217299999999996</c:v>
                </c:pt>
                <c:pt idx="27">
                  <c:v>5.3877199999999936</c:v>
                </c:pt>
                <c:pt idx="28">
                  <c:v>5.2381799999999998</c:v>
                </c:pt>
                <c:pt idx="29">
                  <c:v>5.22234</c:v>
                </c:pt>
                <c:pt idx="30">
                  <c:v>5.5425700000000004</c:v>
                </c:pt>
                <c:pt idx="31">
                  <c:v>5.5425700000000004</c:v>
                </c:pt>
                <c:pt idx="32">
                  <c:v>5.5890700000000004</c:v>
                </c:pt>
                <c:pt idx="33">
                  <c:v>5.4557500000000001</c:v>
                </c:pt>
                <c:pt idx="34">
                  <c:v>5.6660999999999957</c:v>
                </c:pt>
                <c:pt idx="35">
                  <c:v>5.59816</c:v>
                </c:pt>
                <c:pt idx="36">
                  <c:v>5.4342499999999996</c:v>
                </c:pt>
                <c:pt idx="37">
                  <c:v>5.40151</c:v>
                </c:pt>
                <c:pt idx="38">
                  <c:v>5.22356</c:v>
                </c:pt>
                <c:pt idx="39">
                  <c:v>5.22234</c:v>
                </c:pt>
                <c:pt idx="40">
                  <c:v>5.3167799999999996</c:v>
                </c:pt>
                <c:pt idx="41">
                  <c:v>5.6516599999999997</c:v>
                </c:pt>
                <c:pt idx="42">
                  <c:v>5.5066600000000001</c:v>
                </c:pt>
                <c:pt idx="43">
                  <c:v>5.0687799999999976</c:v>
                </c:pt>
                <c:pt idx="44">
                  <c:v>5.3589899999999862</c:v>
                </c:pt>
                <c:pt idx="45">
                  <c:v>5.1294599999999946</c:v>
                </c:pt>
                <c:pt idx="46">
                  <c:v>5.3852200000000003</c:v>
                </c:pt>
                <c:pt idx="47">
                  <c:v>5.1294599999999946</c:v>
                </c:pt>
                <c:pt idx="48">
                  <c:v>5.14384</c:v>
                </c:pt>
                <c:pt idx="49">
                  <c:v>5.0984499999999997</c:v>
                </c:pt>
                <c:pt idx="50">
                  <c:v>5.2150499999999997</c:v>
                </c:pt>
                <c:pt idx="51">
                  <c:v>4.88377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6E2-F943-932B-DDE97EB5857F}"/>
            </c:ext>
          </c:extLst>
        </c:ser>
        <c:ser>
          <c:idx val="1"/>
          <c:order val="1"/>
          <c:tx>
            <c:v>OA/DOPC (1:5)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heet1!$R$2:$R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U$2:$U$53</c:f>
              <c:numCache>
                <c:formatCode>General</c:formatCode>
                <c:ptCount val="52"/>
                <c:pt idx="0">
                  <c:v>0</c:v>
                </c:pt>
                <c:pt idx="1">
                  <c:v>1.04586</c:v>
                </c:pt>
                <c:pt idx="2">
                  <c:v>2.48386</c:v>
                </c:pt>
                <c:pt idx="3">
                  <c:v>3.6105399999999999</c:v>
                </c:pt>
                <c:pt idx="4">
                  <c:v>4.6486999999999998</c:v>
                </c:pt>
                <c:pt idx="5">
                  <c:v>5.1734900000000001</c:v>
                </c:pt>
                <c:pt idx="6">
                  <c:v>5.5255299999999936</c:v>
                </c:pt>
                <c:pt idx="7">
                  <c:v>6.1245399999999766</c:v>
                </c:pt>
                <c:pt idx="8">
                  <c:v>6.1918699999999998</c:v>
                </c:pt>
                <c:pt idx="9">
                  <c:v>7.3050499999999996</c:v>
                </c:pt>
                <c:pt idx="10">
                  <c:v>7.0067899999999996</c:v>
                </c:pt>
                <c:pt idx="11">
                  <c:v>6.9656599999999997</c:v>
                </c:pt>
                <c:pt idx="12">
                  <c:v>7.1852499999999999</c:v>
                </c:pt>
                <c:pt idx="13">
                  <c:v>6.9506399999999999</c:v>
                </c:pt>
                <c:pt idx="14">
                  <c:v>7.7159399999999936</c:v>
                </c:pt>
                <c:pt idx="15">
                  <c:v>7.2206799999999998</c:v>
                </c:pt>
                <c:pt idx="16">
                  <c:v>6.7863899999999999</c:v>
                </c:pt>
                <c:pt idx="17">
                  <c:v>6.8814700000000002</c:v>
                </c:pt>
                <c:pt idx="18">
                  <c:v>7.48</c:v>
                </c:pt>
                <c:pt idx="19">
                  <c:v>7.8877899999999936</c:v>
                </c:pt>
                <c:pt idx="20">
                  <c:v>7.7205299999999957</c:v>
                </c:pt>
                <c:pt idx="21">
                  <c:v>7.6157599999999936</c:v>
                </c:pt>
                <c:pt idx="22">
                  <c:v>7.5095999999999998</c:v>
                </c:pt>
                <c:pt idx="23">
                  <c:v>8.2134500000000035</c:v>
                </c:pt>
                <c:pt idx="24">
                  <c:v>8.86768</c:v>
                </c:pt>
                <c:pt idx="25">
                  <c:v>9.6026799999999994</c:v>
                </c:pt>
                <c:pt idx="26">
                  <c:v>9.8450799999999994</c:v>
                </c:pt>
                <c:pt idx="27">
                  <c:v>9.8669500000000028</c:v>
                </c:pt>
                <c:pt idx="28">
                  <c:v>9.9338700000000006</c:v>
                </c:pt>
                <c:pt idx="29">
                  <c:v>9.5612600000000008</c:v>
                </c:pt>
                <c:pt idx="30">
                  <c:v>9.4286300000000001</c:v>
                </c:pt>
                <c:pt idx="31">
                  <c:v>9.0109300000000001</c:v>
                </c:pt>
                <c:pt idx="32">
                  <c:v>8.4470599999999987</c:v>
                </c:pt>
                <c:pt idx="33">
                  <c:v>8.8211300000000001</c:v>
                </c:pt>
                <c:pt idx="34">
                  <c:v>8.0978300000000001</c:v>
                </c:pt>
                <c:pt idx="35">
                  <c:v>8.4301199999999987</c:v>
                </c:pt>
                <c:pt idx="36">
                  <c:v>7.6793399999999998</c:v>
                </c:pt>
                <c:pt idx="37">
                  <c:v>8.1611000000000011</c:v>
                </c:pt>
                <c:pt idx="38">
                  <c:v>8.3460100000000015</c:v>
                </c:pt>
                <c:pt idx="39">
                  <c:v>8.1253400000000013</c:v>
                </c:pt>
                <c:pt idx="40">
                  <c:v>8.6482499999999973</c:v>
                </c:pt>
                <c:pt idx="41">
                  <c:v>7.9888399999999997</c:v>
                </c:pt>
                <c:pt idx="42">
                  <c:v>8.3711400000000005</c:v>
                </c:pt>
                <c:pt idx="43">
                  <c:v>8.7253699999999998</c:v>
                </c:pt>
                <c:pt idx="44">
                  <c:v>8.5805700000000016</c:v>
                </c:pt>
                <c:pt idx="45">
                  <c:v>8.5719400000000014</c:v>
                </c:pt>
                <c:pt idx="46">
                  <c:v>8.6186699999999963</c:v>
                </c:pt>
                <c:pt idx="47">
                  <c:v>9.2603099999999987</c:v>
                </c:pt>
                <c:pt idx="48">
                  <c:v>9.1067300000000007</c:v>
                </c:pt>
                <c:pt idx="49">
                  <c:v>8.8139900000000004</c:v>
                </c:pt>
                <c:pt idx="50">
                  <c:v>8.6657100000000007</c:v>
                </c:pt>
                <c:pt idx="51">
                  <c:v>9.3344500000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6E2-F943-932B-DDE97EB5857F}"/>
            </c:ext>
          </c:extLst>
        </c:ser>
        <c:ser>
          <c:idx val="2"/>
          <c:order val="2"/>
          <c:tx>
            <c:v>OA/DOPC (1:10)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Sheet1!$AD$2:$AD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AG$2:$AG$53</c:f>
              <c:numCache>
                <c:formatCode>General</c:formatCode>
                <c:ptCount val="52"/>
                <c:pt idx="0">
                  <c:v>0</c:v>
                </c:pt>
                <c:pt idx="1">
                  <c:v>2.16683</c:v>
                </c:pt>
                <c:pt idx="2">
                  <c:v>5.7904299999999997</c:v>
                </c:pt>
                <c:pt idx="3">
                  <c:v>9.6634900000000012</c:v>
                </c:pt>
                <c:pt idx="4">
                  <c:v>11.60017</c:v>
                </c:pt>
                <c:pt idx="5">
                  <c:v>12.06621</c:v>
                </c:pt>
                <c:pt idx="6">
                  <c:v>12.78462</c:v>
                </c:pt>
                <c:pt idx="7">
                  <c:v>13.17686</c:v>
                </c:pt>
                <c:pt idx="8">
                  <c:v>12.781029999999999</c:v>
                </c:pt>
                <c:pt idx="9">
                  <c:v>12.27455</c:v>
                </c:pt>
                <c:pt idx="10">
                  <c:v>11.628590000000001</c:v>
                </c:pt>
                <c:pt idx="11">
                  <c:v>12.342779999999999</c:v>
                </c:pt>
                <c:pt idx="12">
                  <c:v>12.561070000000001</c:v>
                </c:pt>
                <c:pt idx="13">
                  <c:v>11.95069</c:v>
                </c:pt>
                <c:pt idx="14">
                  <c:v>11.549860000000001</c:v>
                </c:pt>
                <c:pt idx="15">
                  <c:v>11.57498</c:v>
                </c:pt>
                <c:pt idx="16">
                  <c:v>12.05625</c:v>
                </c:pt>
                <c:pt idx="17">
                  <c:v>10.728</c:v>
                </c:pt>
                <c:pt idx="18">
                  <c:v>10.74511</c:v>
                </c:pt>
                <c:pt idx="19">
                  <c:v>11.16351</c:v>
                </c:pt>
                <c:pt idx="20">
                  <c:v>10.773709999999999</c:v>
                </c:pt>
                <c:pt idx="21">
                  <c:v>10.97077</c:v>
                </c:pt>
                <c:pt idx="22">
                  <c:v>10.99132</c:v>
                </c:pt>
                <c:pt idx="23">
                  <c:v>11.80753</c:v>
                </c:pt>
                <c:pt idx="24">
                  <c:v>12.339359999999999</c:v>
                </c:pt>
                <c:pt idx="25">
                  <c:v>11.817220000000001</c:v>
                </c:pt>
                <c:pt idx="26">
                  <c:v>11.41916</c:v>
                </c:pt>
                <c:pt idx="27">
                  <c:v>11.49361</c:v>
                </c:pt>
                <c:pt idx="28">
                  <c:v>11.19055</c:v>
                </c:pt>
                <c:pt idx="29">
                  <c:v>10.903600000000001</c:v>
                </c:pt>
                <c:pt idx="30">
                  <c:v>11.60017</c:v>
                </c:pt>
                <c:pt idx="31">
                  <c:v>12.933009999999999</c:v>
                </c:pt>
                <c:pt idx="32">
                  <c:v>13.4887</c:v>
                </c:pt>
                <c:pt idx="33">
                  <c:v>14.1067</c:v>
                </c:pt>
                <c:pt idx="34">
                  <c:v>13.065239999999999</c:v>
                </c:pt>
                <c:pt idx="35">
                  <c:v>11.062150000000001</c:v>
                </c:pt>
                <c:pt idx="36">
                  <c:v>11.12462</c:v>
                </c:pt>
                <c:pt idx="37">
                  <c:v>10.67404</c:v>
                </c:pt>
                <c:pt idx="38">
                  <c:v>10.131779999999999</c:v>
                </c:pt>
                <c:pt idx="39">
                  <c:v>12.18324</c:v>
                </c:pt>
                <c:pt idx="40">
                  <c:v>12.196709999999999</c:v>
                </c:pt>
                <c:pt idx="41">
                  <c:v>12.315429999999999</c:v>
                </c:pt>
                <c:pt idx="42">
                  <c:v>11.62227</c:v>
                </c:pt>
                <c:pt idx="43">
                  <c:v>12.01322</c:v>
                </c:pt>
                <c:pt idx="44">
                  <c:v>11.41916</c:v>
                </c:pt>
                <c:pt idx="45">
                  <c:v>11.717610000000001</c:v>
                </c:pt>
                <c:pt idx="46">
                  <c:v>11.58756</c:v>
                </c:pt>
                <c:pt idx="47">
                  <c:v>11.094810000000001</c:v>
                </c:pt>
                <c:pt idx="48">
                  <c:v>11.299530000000001</c:v>
                </c:pt>
                <c:pt idx="49">
                  <c:v>12.220330000000001</c:v>
                </c:pt>
                <c:pt idx="50">
                  <c:v>12.179869999999999</c:v>
                </c:pt>
                <c:pt idx="51">
                  <c:v>11.2873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6E2-F943-932B-DDE97EB585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90943408"/>
        <c:axId val="1090941488"/>
      </c:scatterChart>
      <c:valAx>
        <c:axId val="1090943408"/>
        <c:scaling>
          <c:orientation val="minMax"/>
          <c:max val="100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0941488"/>
        <c:crosses val="autoZero"/>
        <c:crossBetween val="midCat"/>
        <c:majorUnit val="20"/>
      </c:valAx>
      <c:valAx>
        <c:axId val="1090941488"/>
        <c:scaling>
          <c:orientation val="minMax"/>
          <c:max val="16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[Na</a:t>
                </a:r>
                <a:r>
                  <a:rPr lang="en-US" b="1" baseline="30000"/>
                  <a:t>+</a:t>
                </a:r>
                <a:r>
                  <a:rPr lang="en-US" b="1"/>
                  <a:t>] mM +</a:t>
                </a:r>
                <a:r>
                  <a:rPr lang="en-US" b="1" baseline="0"/>
                  <a:t> Io</a:t>
                </a:r>
                <a:r>
                  <a:rPr lang="en-US" b="1"/>
                  <a:t>nophore</a:t>
                </a:r>
              </a:p>
            </c:rich>
          </c:tx>
          <c:layout>
            <c:manualLayout>
              <c:xMode val="edge"/>
              <c:yMode val="edge"/>
              <c:x val="1.38734465878666E-2"/>
              <c:y val="0.2175100521591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0943408"/>
        <c:crosses val="autoZero"/>
        <c:crossBetween val="midCat"/>
        <c:majorUnit val="3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41465135361935002"/>
          <c:y val="0.64670056867891501"/>
          <c:w val="0.53520944507766699"/>
          <c:h val="0.201001843533084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  <a:latin typeface="+mn-lt"/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6238162161528"/>
          <c:y val="2.54283318751823E-2"/>
          <c:w val="0.77008410851425202"/>
          <c:h val="0.81063283756197102"/>
        </c:manualLayout>
      </c:layout>
      <c:scatterChart>
        <c:scatterStyle val="smoothMarker"/>
        <c:varyColors val="0"/>
        <c:ser>
          <c:idx val="0"/>
          <c:order val="0"/>
          <c:tx>
            <c:v>OA/DOPC (1:1)</c:v>
          </c:tx>
          <c:spPr>
            <a:ln w="19050" cap="rnd">
              <a:solidFill>
                <a:srgbClr val="0432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432FF"/>
              </a:solidFill>
              <a:ln w="9525">
                <a:solidFill>
                  <a:srgbClr val="0432FF"/>
                </a:solidFill>
              </a:ln>
              <a:effectLst/>
            </c:spPr>
          </c:marker>
          <c:xVal>
            <c:numRef>
              <c:f>Sheet1!$F$2:$F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H$2:$H$53</c:f>
              <c:numCache>
                <c:formatCode>General</c:formatCode>
                <c:ptCount val="52"/>
                <c:pt idx="0">
                  <c:v>0</c:v>
                </c:pt>
                <c:pt idx="1">
                  <c:v>3.67726</c:v>
                </c:pt>
                <c:pt idx="2">
                  <c:v>5.4622900000000003</c:v>
                </c:pt>
                <c:pt idx="3">
                  <c:v>6.4920299999999997</c:v>
                </c:pt>
                <c:pt idx="4">
                  <c:v>7.20723</c:v>
                </c:pt>
                <c:pt idx="5">
                  <c:v>7.8813199999999997</c:v>
                </c:pt>
                <c:pt idx="6">
                  <c:v>7.3002399999999996</c:v>
                </c:pt>
                <c:pt idx="7">
                  <c:v>7.4016200000000003</c:v>
                </c:pt>
                <c:pt idx="8">
                  <c:v>6.527339999999989</c:v>
                </c:pt>
                <c:pt idx="9">
                  <c:v>6.0761900000000004</c:v>
                </c:pt>
                <c:pt idx="10">
                  <c:v>5.5167000000000002</c:v>
                </c:pt>
                <c:pt idx="11">
                  <c:v>5.2908299999999997</c:v>
                </c:pt>
                <c:pt idx="12">
                  <c:v>5.2945899999999861</c:v>
                </c:pt>
                <c:pt idx="13">
                  <c:v>5.1122799999999966</c:v>
                </c:pt>
                <c:pt idx="14">
                  <c:v>5.5388700000000002</c:v>
                </c:pt>
                <c:pt idx="15">
                  <c:v>5.6403600000000003</c:v>
                </c:pt>
                <c:pt idx="16">
                  <c:v>5.7680499999999997</c:v>
                </c:pt>
                <c:pt idx="17">
                  <c:v>5.9306000000000001</c:v>
                </c:pt>
                <c:pt idx="18">
                  <c:v>6.3797800000000002</c:v>
                </c:pt>
                <c:pt idx="19">
                  <c:v>6.8737500000000002</c:v>
                </c:pt>
                <c:pt idx="20">
                  <c:v>6.3139799999999946</c:v>
                </c:pt>
                <c:pt idx="21">
                  <c:v>5.8763800000000002</c:v>
                </c:pt>
                <c:pt idx="22">
                  <c:v>5.8597999999999999</c:v>
                </c:pt>
                <c:pt idx="23">
                  <c:v>5.4352799999999997</c:v>
                </c:pt>
                <c:pt idx="24">
                  <c:v>5.4700300000000004</c:v>
                </c:pt>
                <c:pt idx="25">
                  <c:v>5.3398399999999997</c:v>
                </c:pt>
                <c:pt idx="26">
                  <c:v>5.1940799999999872</c:v>
                </c:pt>
                <c:pt idx="27">
                  <c:v>5.30837</c:v>
                </c:pt>
                <c:pt idx="28">
                  <c:v>5.20146</c:v>
                </c:pt>
                <c:pt idx="29">
                  <c:v>5.3297499999999998</c:v>
                </c:pt>
                <c:pt idx="30">
                  <c:v>5.126839999999989</c:v>
                </c:pt>
                <c:pt idx="31">
                  <c:v>5.1463200000000002</c:v>
                </c:pt>
                <c:pt idx="32">
                  <c:v>5.1719799999999996</c:v>
                </c:pt>
                <c:pt idx="33">
                  <c:v>5.154859999999986</c:v>
                </c:pt>
                <c:pt idx="34">
                  <c:v>5.1414400000000002</c:v>
                </c:pt>
                <c:pt idx="35">
                  <c:v>5.2385299999999999</c:v>
                </c:pt>
                <c:pt idx="36">
                  <c:v>5.0268799999999976</c:v>
                </c:pt>
                <c:pt idx="37">
                  <c:v>5.0724200000000002</c:v>
                </c:pt>
                <c:pt idx="38">
                  <c:v>4.9746199999999998</c:v>
                </c:pt>
                <c:pt idx="39">
                  <c:v>4.8081199999999891</c:v>
                </c:pt>
                <c:pt idx="40">
                  <c:v>4.9053100000000001</c:v>
                </c:pt>
                <c:pt idx="41">
                  <c:v>4.9076399999999998</c:v>
                </c:pt>
                <c:pt idx="42">
                  <c:v>5.0892999999999997</c:v>
                </c:pt>
                <c:pt idx="43">
                  <c:v>4.9451400000000003</c:v>
                </c:pt>
                <c:pt idx="44">
                  <c:v>5.0568</c:v>
                </c:pt>
                <c:pt idx="45">
                  <c:v>4.8541799999999862</c:v>
                </c:pt>
                <c:pt idx="46">
                  <c:v>4.8322500000000002</c:v>
                </c:pt>
                <c:pt idx="47">
                  <c:v>4.9817200000000001</c:v>
                </c:pt>
                <c:pt idx="48">
                  <c:v>4.7488099999999998</c:v>
                </c:pt>
                <c:pt idx="49">
                  <c:v>4.87852</c:v>
                </c:pt>
                <c:pt idx="50">
                  <c:v>4.9580900000000003</c:v>
                </c:pt>
                <c:pt idx="51">
                  <c:v>4.98052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0379-BF43-839C-0219AF94A184}"/>
            </c:ext>
          </c:extLst>
        </c:ser>
        <c:ser>
          <c:idx val="1"/>
          <c:order val="1"/>
          <c:tx>
            <c:v>OA/DOPC (1:5)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heet1!$R$2:$R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T$2:$T$53</c:f>
              <c:numCache>
                <c:formatCode>General</c:formatCode>
                <c:ptCount val="52"/>
                <c:pt idx="0">
                  <c:v>0</c:v>
                </c:pt>
                <c:pt idx="1">
                  <c:v>2.1676500000000001</c:v>
                </c:pt>
                <c:pt idx="2">
                  <c:v>4.1249099999999812</c:v>
                </c:pt>
                <c:pt idx="3">
                  <c:v>6.3984199999999891</c:v>
                </c:pt>
                <c:pt idx="4">
                  <c:v>7.53742</c:v>
                </c:pt>
                <c:pt idx="5">
                  <c:v>7.84084</c:v>
                </c:pt>
                <c:pt idx="6">
                  <c:v>7.9765600000000001</c:v>
                </c:pt>
                <c:pt idx="7">
                  <c:v>7.6487600000000002</c:v>
                </c:pt>
                <c:pt idx="8">
                  <c:v>7.2688199999999936</c:v>
                </c:pt>
                <c:pt idx="9">
                  <c:v>7.4292299999999996</c:v>
                </c:pt>
                <c:pt idx="10">
                  <c:v>7.33596</c:v>
                </c:pt>
                <c:pt idx="11">
                  <c:v>7.1365299999999996</c:v>
                </c:pt>
                <c:pt idx="12">
                  <c:v>6.95139</c:v>
                </c:pt>
                <c:pt idx="13">
                  <c:v>7.2884900000000004</c:v>
                </c:pt>
                <c:pt idx="14">
                  <c:v>6.7744200000000001</c:v>
                </c:pt>
                <c:pt idx="15">
                  <c:v>6.4351399999999996</c:v>
                </c:pt>
                <c:pt idx="16">
                  <c:v>6.3301499999999997</c:v>
                </c:pt>
                <c:pt idx="17">
                  <c:v>5.9336700000000002</c:v>
                </c:pt>
                <c:pt idx="18">
                  <c:v>5.9273099999999976</c:v>
                </c:pt>
                <c:pt idx="19">
                  <c:v>6.2191299999999998</c:v>
                </c:pt>
                <c:pt idx="20">
                  <c:v>5.7860300000000002</c:v>
                </c:pt>
                <c:pt idx="21">
                  <c:v>5.5122799999999996</c:v>
                </c:pt>
                <c:pt idx="22">
                  <c:v>5.9029999999999996</c:v>
                </c:pt>
                <c:pt idx="23">
                  <c:v>5.2236399999999996</c:v>
                </c:pt>
                <c:pt idx="24">
                  <c:v>5.2330300000000003</c:v>
                </c:pt>
                <c:pt idx="25">
                  <c:v>5.5797699999999999</c:v>
                </c:pt>
                <c:pt idx="26">
                  <c:v>5.8536400000000004</c:v>
                </c:pt>
                <c:pt idx="27">
                  <c:v>5.7581799999999976</c:v>
                </c:pt>
                <c:pt idx="28">
                  <c:v>6.3064299999999998</c:v>
                </c:pt>
                <c:pt idx="29">
                  <c:v>6.1035399999999944</c:v>
                </c:pt>
                <c:pt idx="30">
                  <c:v>6.1682199999999936</c:v>
                </c:pt>
                <c:pt idx="31">
                  <c:v>6.3471499999999956</c:v>
                </c:pt>
                <c:pt idx="32">
                  <c:v>5.8599199999999936</c:v>
                </c:pt>
                <c:pt idx="33">
                  <c:v>6.3233600000000001</c:v>
                </c:pt>
                <c:pt idx="34">
                  <c:v>6.4917800000000003</c:v>
                </c:pt>
                <c:pt idx="35">
                  <c:v>6.6887799999999986</c:v>
                </c:pt>
                <c:pt idx="36">
                  <c:v>6.6636600000000001</c:v>
                </c:pt>
                <c:pt idx="37">
                  <c:v>6.6291499999999957</c:v>
                </c:pt>
                <c:pt idx="38">
                  <c:v>6.4593499999999997</c:v>
                </c:pt>
                <c:pt idx="39">
                  <c:v>6.3687399999999936</c:v>
                </c:pt>
                <c:pt idx="40">
                  <c:v>6.8133900000000001</c:v>
                </c:pt>
                <c:pt idx="41">
                  <c:v>6.6398400000000004</c:v>
                </c:pt>
                <c:pt idx="42">
                  <c:v>6.50108</c:v>
                </c:pt>
                <c:pt idx="43">
                  <c:v>6.2224699999999986</c:v>
                </c:pt>
                <c:pt idx="44">
                  <c:v>6.5583299999999998</c:v>
                </c:pt>
                <c:pt idx="45">
                  <c:v>6.4052899999999999</c:v>
                </c:pt>
                <c:pt idx="46">
                  <c:v>6.9880000000000004</c:v>
                </c:pt>
                <c:pt idx="47">
                  <c:v>7.0573999999999986</c:v>
                </c:pt>
                <c:pt idx="48">
                  <c:v>7.1019600000000001</c:v>
                </c:pt>
                <c:pt idx="49">
                  <c:v>7.3121799999999872</c:v>
                </c:pt>
                <c:pt idx="50">
                  <c:v>6.7987500000000001</c:v>
                </c:pt>
                <c:pt idx="51">
                  <c:v>7.098129999999997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0379-BF43-839C-0219AF94A184}"/>
            </c:ext>
          </c:extLst>
        </c:ser>
        <c:ser>
          <c:idx val="2"/>
          <c:order val="2"/>
          <c:tx>
            <c:v>OA/DOPC (1:10)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Sheet1!$AD$2:$AD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AF$2:$AF$53</c:f>
              <c:numCache>
                <c:formatCode>General</c:formatCode>
                <c:ptCount val="52"/>
                <c:pt idx="0">
                  <c:v>0</c:v>
                </c:pt>
                <c:pt idx="1">
                  <c:v>0.77610999999999997</c:v>
                </c:pt>
                <c:pt idx="2">
                  <c:v>1.3458600000000001</c:v>
                </c:pt>
                <c:pt idx="3">
                  <c:v>2.0249100000000002</c:v>
                </c:pt>
                <c:pt idx="4">
                  <c:v>2.409419999999999</c:v>
                </c:pt>
                <c:pt idx="5">
                  <c:v>2.4816500000000001</c:v>
                </c:pt>
                <c:pt idx="6">
                  <c:v>2.7121300000000002</c:v>
                </c:pt>
                <c:pt idx="7">
                  <c:v>3.09754</c:v>
                </c:pt>
                <c:pt idx="8">
                  <c:v>3.2257199999999999</c:v>
                </c:pt>
                <c:pt idx="9">
                  <c:v>3.5005199999999999</c:v>
                </c:pt>
                <c:pt idx="10">
                  <c:v>3.69523</c:v>
                </c:pt>
                <c:pt idx="11">
                  <c:v>3.5571199999999998</c:v>
                </c:pt>
                <c:pt idx="12">
                  <c:v>3.6311300000000002</c:v>
                </c:pt>
                <c:pt idx="13">
                  <c:v>3.875989999999998</c:v>
                </c:pt>
                <c:pt idx="14">
                  <c:v>3.9990700000000001</c:v>
                </c:pt>
                <c:pt idx="15">
                  <c:v>3.975649999999987</c:v>
                </c:pt>
                <c:pt idx="16">
                  <c:v>3.80254</c:v>
                </c:pt>
                <c:pt idx="17">
                  <c:v>3.8347600000000002</c:v>
                </c:pt>
                <c:pt idx="18">
                  <c:v>3.8531399999999998</c:v>
                </c:pt>
                <c:pt idx="19">
                  <c:v>3.99546</c:v>
                </c:pt>
                <c:pt idx="20">
                  <c:v>3.9936600000000002</c:v>
                </c:pt>
                <c:pt idx="21">
                  <c:v>3.98915</c:v>
                </c:pt>
                <c:pt idx="22">
                  <c:v>4.0207899999999954</c:v>
                </c:pt>
                <c:pt idx="23">
                  <c:v>4.08284</c:v>
                </c:pt>
                <c:pt idx="24">
                  <c:v>4.0883500000000002</c:v>
                </c:pt>
                <c:pt idx="25">
                  <c:v>3.9738500000000001</c:v>
                </c:pt>
                <c:pt idx="26">
                  <c:v>4.2736700000000001</c:v>
                </c:pt>
                <c:pt idx="27">
                  <c:v>4.2243399999999944</c:v>
                </c:pt>
                <c:pt idx="28">
                  <c:v>4.5717800000000004</c:v>
                </c:pt>
                <c:pt idx="29">
                  <c:v>4.510589999999989</c:v>
                </c:pt>
                <c:pt idx="30">
                  <c:v>4.5225699999999964</c:v>
                </c:pt>
                <c:pt idx="31">
                  <c:v>4.5506399999999996</c:v>
                </c:pt>
                <c:pt idx="32">
                  <c:v>4.8227799999999936</c:v>
                </c:pt>
                <c:pt idx="33">
                  <c:v>4.7461399999999996</c:v>
                </c:pt>
                <c:pt idx="34">
                  <c:v>4.5879499999999984</c:v>
                </c:pt>
                <c:pt idx="35">
                  <c:v>4.5576799999999986</c:v>
                </c:pt>
                <c:pt idx="36">
                  <c:v>4.6153499999999976</c:v>
                </c:pt>
                <c:pt idx="37">
                  <c:v>4.8259499999999873</c:v>
                </c:pt>
                <c:pt idx="38">
                  <c:v>4.8027299999999986</c:v>
                </c:pt>
                <c:pt idx="39">
                  <c:v>5.0472599999999996</c:v>
                </c:pt>
                <c:pt idx="40">
                  <c:v>5.2138499999999999</c:v>
                </c:pt>
                <c:pt idx="41">
                  <c:v>5.0066499999999996</c:v>
                </c:pt>
                <c:pt idx="42">
                  <c:v>4.7357199999999997</c:v>
                </c:pt>
                <c:pt idx="43">
                  <c:v>4.6245099999999786</c:v>
                </c:pt>
                <c:pt idx="44">
                  <c:v>4.7880000000000003</c:v>
                </c:pt>
                <c:pt idx="45">
                  <c:v>4.99573</c:v>
                </c:pt>
                <c:pt idx="46">
                  <c:v>4.8791099999999998</c:v>
                </c:pt>
                <c:pt idx="47">
                  <c:v>4.9349499999999997</c:v>
                </c:pt>
                <c:pt idx="48">
                  <c:v>4.9468300000000003</c:v>
                </c:pt>
                <c:pt idx="49">
                  <c:v>4.8429099999999936</c:v>
                </c:pt>
                <c:pt idx="50">
                  <c:v>4.8027299999999986</c:v>
                </c:pt>
                <c:pt idx="51">
                  <c:v>5.08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0379-BF43-839C-0219AF94A1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90877200"/>
        <c:axId val="1090873696"/>
      </c:scatterChart>
      <c:valAx>
        <c:axId val="1090877200"/>
        <c:scaling>
          <c:orientation val="minMax"/>
          <c:max val="100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0873696"/>
        <c:crosses val="autoZero"/>
        <c:crossBetween val="midCat"/>
        <c:majorUnit val="20"/>
      </c:valAx>
      <c:valAx>
        <c:axId val="1090873696"/>
        <c:scaling>
          <c:orientation val="minMax"/>
          <c:max val="11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[Na</a:t>
                </a:r>
                <a:r>
                  <a:rPr lang="en-US" b="1" baseline="30000"/>
                  <a:t>+</a:t>
                </a:r>
                <a:r>
                  <a:rPr lang="en-US" b="1"/>
                  <a:t>] mM</a:t>
                </a:r>
              </a:p>
            </c:rich>
          </c:tx>
          <c:layout>
            <c:manualLayout>
              <c:xMode val="edge"/>
              <c:yMode val="edge"/>
              <c:x val="1.3873527017620201E-2"/>
              <c:y val="0.353400431100323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0877200"/>
        <c:crosses val="autoZero"/>
        <c:crossBetween val="midCat"/>
        <c:majorUnit val="3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461761411725153"/>
          <c:y val="0.60025754062870296"/>
          <c:w val="0.48809951505176902"/>
          <c:h val="0.19285697307022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  <a:latin typeface="+mn-lt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627502182776501"/>
          <c:y val="4.20168067226891E-2"/>
          <c:w val="0.868170552943344"/>
          <c:h val="0.83220362160612305"/>
        </c:manualLayout>
      </c:layout>
      <c:scatterChart>
        <c:scatterStyle val="smoothMarker"/>
        <c:varyColors val="0"/>
        <c:ser>
          <c:idx val="1"/>
          <c:order val="0"/>
          <c:tx>
            <c:v>DA-DOH (2:1)</c:v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2:$C$18</c:f>
                <c:numCache>
                  <c:formatCode>General</c:formatCode>
                  <c:ptCount val="17"/>
                  <c:pt idx="0">
                    <c:v>0</c:v>
                  </c:pt>
                  <c:pt idx="1">
                    <c:v>0.71218000000000004</c:v>
                  </c:pt>
                  <c:pt idx="2">
                    <c:v>1.1052599999999999</c:v>
                  </c:pt>
                  <c:pt idx="3">
                    <c:v>1.66215</c:v>
                  </c:pt>
                  <c:pt idx="4">
                    <c:v>1.8391</c:v>
                  </c:pt>
                  <c:pt idx="5">
                    <c:v>2.29535</c:v>
                  </c:pt>
                  <c:pt idx="6">
                    <c:v>2.2435</c:v>
                  </c:pt>
                  <c:pt idx="7">
                    <c:v>1.2636799999999999</c:v>
                  </c:pt>
                  <c:pt idx="8">
                    <c:v>1.54939</c:v>
                  </c:pt>
                  <c:pt idx="9">
                    <c:v>1.38605</c:v>
                  </c:pt>
                  <c:pt idx="10">
                    <c:v>2.1411600000000002</c:v>
                  </c:pt>
                  <c:pt idx="11">
                    <c:v>1.0341400000000001</c:v>
                  </c:pt>
                  <c:pt idx="12">
                    <c:v>1.68584</c:v>
                  </c:pt>
                  <c:pt idx="13">
                    <c:v>2.73942</c:v>
                  </c:pt>
                  <c:pt idx="14">
                    <c:v>5.3062100000000001</c:v>
                  </c:pt>
                  <c:pt idx="15">
                    <c:v>7.8833900000000003</c:v>
                  </c:pt>
                  <c:pt idx="16">
                    <c:v>10.200379999999999</c:v>
                  </c:pt>
                </c:numCache>
              </c:numRef>
            </c:plus>
            <c:minus>
              <c:numRef>
                <c:f>Sheet1!$C$2:$C$18</c:f>
                <c:numCache>
                  <c:formatCode>General</c:formatCode>
                  <c:ptCount val="17"/>
                  <c:pt idx="0">
                    <c:v>0</c:v>
                  </c:pt>
                  <c:pt idx="1">
                    <c:v>0.71218000000000004</c:v>
                  </c:pt>
                  <c:pt idx="2">
                    <c:v>1.1052599999999999</c:v>
                  </c:pt>
                  <c:pt idx="3">
                    <c:v>1.66215</c:v>
                  </c:pt>
                  <c:pt idx="4">
                    <c:v>1.8391</c:v>
                  </c:pt>
                  <c:pt idx="5">
                    <c:v>2.29535</c:v>
                  </c:pt>
                  <c:pt idx="6">
                    <c:v>2.2435</c:v>
                  </c:pt>
                  <c:pt idx="7">
                    <c:v>1.2636799999999999</c:v>
                  </c:pt>
                  <c:pt idx="8">
                    <c:v>1.54939</c:v>
                  </c:pt>
                  <c:pt idx="9">
                    <c:v>1.38605</c:v>
                  </c:pt>
                  <c:pt idx="10">
                    <c:v>2.1411600000000002</c:v>
                  </c:pt>
                  <c:pt idx="11">
                    <c:v>1.0341400000000001</c:v>
                  </c:pt>
                  <c:pt idx="12">
                    <c:v>1.68584</c:v>
                  </c:pt>
                  <c:pt idx="13">
                    <c:v>2.73942</c:v>
                  </c:pt>
                  <c:pt idx="14">
                    <c:v>5.3062100000000001</c:v>
                  </c:pt>
                  <c:pt idx="15">
                    <c:v>7.8833900000000003</c:v>
                  </c:pt>
                  <c:pt idx="16">
                    <c:v>10.20037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$2:$A$21</c:f>
              <c:numCache>
                <c:formatCode>General</c:formatCode>
                <c:ptCount val="20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25</c:v>
                </c:pt>
                <c:pt idx="6">
                  <c:v>1.5</c:v>
                </c:pt>
                <c:pt idx="7">
                  <c:v>1.75</c:v>
                </c:pt>
                <c:pt idx="8">
                  <c:v>2</c:v>
                </c:pt>
                <c:pt idx="9">
                  <c:v>2.25</c:v>
                </c:pt>
                <c:pt idx="10">
                  <c:v>2.5</c:v>
                </c:pt>
                <c:pt idx="11">
                  <c:v>2.75</c:v>
                </c:pt>
                <c:pt idx="12">
                  <c:v>3</c:v>
                </c:pt>
                <c:pt idx="13">
                  <c:v>3.25</c:v>
                </c:pt>
                <c:pt idx="14">
                  <c:v>3.5</c:v>
                </c:pt>
                <c:pt idx="15">
                  <c:v>3.75</c:v>
                </c:pt>
                <c:pt idx="16">
                  <c:v>4</c:v>
                </c:pt>
                <c:pt idx="17">
                  <c:v>8</c:v>
                </c:pt>
                <c:pt idx="18">
                  <c:v>16</c:v>
                </c:pt>
                <c:pt idx="19">
                  <c:v>24</c:v>
                </c:pt>
              </c:numCache>
            </c:numRef>
          </c:xVal>
          <c:yVal>
            <c:numRef>
              <c:f>Sheet1!$B$2:$B$21</c:f>
              <c:numCache>
                <c:formatCode>General</c:formatCode>
                <c:ptCount val="20"/>
                <c:pt idx="0">
                  <c:v>100</c:v>
                </c:pt>
                <c:pt idx="1">
                  <c:v>96.063980000000001</c:v>
                </c:pt>
                <c:pt idx="2">
                  <c:v>92.951759999999993</c:v>
                </c:pt>
                <c:pt idx="3">
                  <c:v>89.727509999999995</c:v>
                </c:pt>
                <c:pt idx="4">
                  <c:v>87.262439999999998</c:v>
                </c:pt>
                <c:pt idx="5">
                  <c:v>84.344049999999996</c:v>
                </c:pt>
                <c:pt idx="6">
                  <c:v>82.431740000000005</c:v>
                </c:pt>
                <c:pt idx="7">
                  <c:v>78.732439999999983</c:v>
                </c:pt>
                <c:pt idx="8">
                  <c:v>73.148479999999978</c:v>
                </c:pt>
                <c:pt idx="9">
                  <c:v>65.240620000000007</c:v>
                </c:pt>
                <c:pt idx="10">
                  <c:v>55.89282</c:v>
                </c:pt>
                <c:pt idx="11">
                  <c:v>46.295169999999999</c:v>
                </c:pt>
                <c:pt idx="12">
                  <c:v>36.316459999999999</c:v>
                </c:pt>
                <c:pt idx="13">
                  <c:v>28.14573</c:v>
                </c:pt>
                <c:pt idx="14">
                  <c:v>20.22569</c:v>
                </c:pt>
                <c:pt idx="15">
                  <c:v>14.175689999999999</c:v>
                </c:pt>
                <c:pt idx="16">
                  <c:v>10.114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D14-FD4D-9E31-2F7CDF9112B9}"/>
            </c:ext>
          </c:extLst>
        </c:ser>
        <c:ser>
          <c:idx val="3"/>
          <c:order val="1"/>
          <c:tx>
            <c:v>OA</c:v>
          </c:tx>
          <c:spPr>
            <a:ln w="19050" cap="rnd">
              <a:solidFill>
                <a:srgbClr val="0432FF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0432FF"/>
              </a:solidFill>
              <a:ln w="9525">
                <a:solidFill>
                  <a:srgbClr val="0432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E$2:$E$21</c:f>
                <c:numCache>
                  <c:formatCode>General</c:formatCode>
                  <c:ptCount val="20"/>
                  <c:pt idx="0">
                    <c:v>0</c:v>
                  </c:pt>
                  <c:pt idx="4">
                    <c:v>1.0389999999999999</c:v>
                  </c:pt>
                  <c:pt idx="8">
                    <c:v>1.0229999999999999</c:v>
                  </c:pt>
                  <c:pt idx="12">
                    <c:v>3.2559999999999998</c:v>
                  </c:pt>
                  <c:pt idx="16">
                    <c:v>2.2210000000000001</c:v>
                  </c:pt>
                  <c:pt idx="17">
                    <c:v>1.2250000000000001</c:v>
                  </c:pt>
                  <c:pt idx="18">
                    <c:v>1.887</c:v>
                  </c:pt>
                  <c:pt idx="19">
                    <c:v>1.5680000000000001</c:v>
                  </c:pt>
                </c:numCache>
              </c:numRef>
            </c:plus>
            <c:minus>
              <c:numRef>
                <c:f>Sheet1!$E$2:$E$21</c:f>
                <c:numCache>
                  <c:formatCode>General</c:formatCode>
                  <c:ptCount val="20"/>
                  <c:pt idx="0">
                    <c:v>0</c:v>
                  </c:pt>
                  <c:pt idx="4">
                    <c:v>1.0389999999999999</c:v>
                  </c:pt>
                  <c:pt idx="8">
                    <c:v>1.0229999999999999</c:v>
                  </c:pt>
                  <c:pt idx="12">
                    <c:v>3.2559999999999998</c:v>
                  </c:pt>
                  <c:pt idx="16">
                    <c:v>2.2210000000000001</c:v>
                  </c:pt>
                  <c:pt idx="17">
                    <c:v>1.2250000000000001</c:v>
                  </c:pt>
                  <c:pt idx="18">
                    <c:v>1.887</c:v>
                  </c:pt>
                  <c:pt idx="19">
                    <c:v>1.5680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$2:$A$21</c:f>
              <c:numCache>
                <c:formatCode>General</c:formatCode>
                <c:ptCount val="20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25</c:v>
                </c:pt>
                <c:pt idx="6">
                  <c:v>1.5</c:v>
                </c:pt>
                <c:pt idx="7">
                  <c:v>1.75</c:v>
                </c:pt>
                <c:pt idx="8">
                  <c:v>2</c:v>
                </c:pt>
                <c:pt idx="9">
                  <c:v>2.25</c:v>
                </c:pt>
                <c:pt idx="10">
                  <c:v>2.5</c:v>
                </c:pt>
                <c:pt idx="11">
                  <c:v>2.75</c:v>
                </c:pt>
                <c:pt idx="12">
                  <c:v>3</c:v>
                </c:pt>
                <c:pt idx="13">
                  <c:v>3.25</c:v>
                </c:pt>
                <c:pt idx="14">
                  <c:v>3.5</c:v>
                </c:pt>
                <c:pt idx="15">
                  <c:v>3.75</c:v>
                </c:pt>
                <c:pt idx="16">
                  <c:v>4</c:v>
                </c:pt>
                <c:pt idx="17">
                  <c:v>8</c:v>
                </c:pt>
                <c:pt idx="18">
                  <c:v>16</c:v>
                </c:pt>
                <c:pt idx="19">
                  <c:v>24</c:v>
                </c:pt>
              </c:numCache>
            </c:numRef>
          </c:xVal>
          <c:yVal>
            <c:numRef>
              <c:f>Sheet1!$D$2:$D$21</c:f>
              <c:numCache>
                <c:formatCode>General</c:formatCode>
                <c:ptCount val="20"/>
                <c:pt idx="0">
                  <c:v>100</c:v>
                </c:pt>
                <c:pt idx="4">
                  <c:v>100.896</c:v>
                </c:pt>
                <c:pt idx="8">
                  <c:v>99.998000000000005</c:v>
                </c:pt>
                <c:pt idx="12">
                  <c:v>102.256</c:v>
                </c:pt>
                <c:pt idx="16">
                  <c:v>98.998000000000005</c:v>
                </c:pt>
                <c:pt idx="17">
                  <c:v>97.458000000000013</c:v>
                </c:pt>
                <c:pt idx="18">
                  <c:v>97.006</c:v>
                </c:pt>
                <c:pt idx="19">
                  <c:v>96.55800000000000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D14-FD4D-9E31-2F7CDF9112B9}"/>
            </c:ext>
          </c:extLst>
        </c:ser>
        <c:ser>
          <c:idx val="5"/>
          <c:order val="2"/>
          <c:tx>
            <c:v>EA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triangle"/>
            <c:size val="7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G$2:$G$21</c:f>
                <c:numCache>
                  <c:formatCode>General</c:formatCode>
                  <c:ptCount val="20"/>
                  <c:pt idx="0">
                    <c:v>0</c:v>
                  </c:pt>
                  <c:pt idx="4">
                    <c:v>1.0549999999999999</c:v>
                  </c:pt>
                  <c:pt idx="8">
                    <c:v>0.88900000000000001</c:v>
                  </c:pt>
                  <c:pt idx="12">
                    <c:v>1.589</c:v>
                  </c:pt>
                  <c:pt idx="16">
                    <c:v>1.004</c:v>
                  </c:pt>
                  <c:pt idx="17">
                    <c:v>2.5579999999999998</c:v>
                  </c:pt>
                  <c:pt idx="18">
                    <c:v>2.5539999999999998</c:v>
                  </c:pt>
                  <c:pt idx="19">
                    <c:v>2.1139999999999999</c:v>
                  </c:pt>
                </c:numCache>
              </c:numRef>
            </c:plus>
            <c:minus>
              <c:numRef>
                <c:f>Sheet1!$G$2:$G$21</c:f>
                <c:numCache>
                  <c:formatCode>General</c:formatCode>
                  <c:ptCount val="20"/>
                  <c:pt idx="0">
                    <c:v>0</c:v>
                  </c:pt>
                  <c:pt idx="4">
                    <c:v>1.0549999999999999</c:v>
                  </c:pt>
                  <c:pt idx="8">
                    <c:v>0.88900000000000001</c:v>
                  </c:pt>
                  <c:pt idx="12">
                    <c:v>1.589</c:v>
                  </c:pt>
                  <c:pt idx="16">
                    <c:v>1.004</c:v>
                  </c:pt>
                  <c:pt idx="17">
                    <c:v>2.5579999999999998</c:v>
                  </c:pt>
                  <c:pt idx="18">
                    <c:v>2.5539999999999998</c:v>
                  </c:pt>
                  <c:pt idx="19">
                    <c:v>2.11399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$2:$A$21</c:f>
              <c:numCache>
                <c:formatCode>General</c:formatCode>
                <c:ptCount val="20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25</c:v>
                </c:pt>
                <c:pt idx="6">
                  <c:v>1.5</c:v>
                </c:pt>
                <c:pt idx="7">
                  <c:v>1.75</c:v>
                </c:pt>
                <c:pt idx="8">
                  <c:v>2</c:v>
                </c:pt>
                <c:pt idx="9">
                  <c:v>2.25</c:v>
                </c:pt>
                <c:pt idx="10">
                  <c:v>2.5</c:v>
                </c:pt>
                <c:pt idx="11">
                  <c:v>2.75</c:v>
                </c:pt>
                <c:pt idx="12">
                  <c:v>3</c:v>
                </c:pt>
                <c:pt idx="13">
                  <c:v>3.25</c:v>
                </c:pt>
                <c:pt idx="14">
                  <c:v>3.5</c:v>
                </c:pt>
                <c:pt idx="15">
                  <c:v>3.75</c:v>
                </c:pt>
                <c:pt idx="16">
                  <c:v>4</c:v>
                </c:pt>
                <c:pt idx="17">
                  <c:v>8</c:v>
                </c:pt>
                <c:pt idx="18">
                  <c:v>16</c:v>
                </c:pt>
                <c:pt idx="19">
                  <c:v>24</c:v>
                </c:pt>
              </c:numCache>
            </c:numRef>
          </c:xVal>
          <c:yVal>
            <c:numRef>
              <c:f>Sheet1!$F$2:$F$21</c:f>
              <c:numCache>
                <c:formatCode>General</c:formatCode>
                <c:ptCount val="20"/>
                <c:pt idx="0">
                  <c:v>100</c:v>
                </c:pt>
                <c:pt idx="4">
                  <c:v>99.256</c:v>
                </c:pt>
                <c:pt idx="8">
                  <c:v>98.888999999999982</c:v>
                </c:pt>
                <c:pt idx="12">
                  <c:v>99.985000000000014</c:v>
                </c:pt>
                <c:pt idx="16">
                  <c:v>100.22499999999999</c:v>
                </c:pt>
                <c:pt idx="17">
                  <c:v>98.224999999999994</c:v>
                </c:pt>
                <c:pt idx="18">
                  <c:v>96.558000000000007</c:v>
                </c:pt>
                <c:pt idx="19">
                  <c:v>95.489000000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D14-FD4D-9E31-2F7CDF9112B9}"/>
            </c:ext>
          </c:extLst>
        </c:ser>
        <c:ser>
          <c:idx val="7"/>
          <c:order val="3"/>
          <c:tx>
            <c:v>DOPC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diamond"/>
            <c:size val="7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2:$I$21</c:f>
                <c:numCache>
                  <c:formatCode>General</c:formatCode>
                  <c:ptCount val="20"/>
                  <c:pt idx="0">
                    <c:v>0</c:v>
                  </c:pt>
                  <c:pt idx="4">
                    <c:v>1.0129999999999999</c:v>
                  </c:pt>
                  <c:pt idx="8">
                    <c:v>0.77900000000000003</c:v>
                  </c:pt>
                  <c:pt idx="12">
                    <c:v>0.998</c:v>
                  </c:pt>
                  <c:pt idx="16">
                    <c:v>0.99199999999999999</c:v>
                  </c:pt>
                  <c:pt idx="17">
                    <c:v>1.224</c:v>
                  </c:pt>
                  <c:pt idx="18">
                    <c:v>1.2290000000000001</c:v>
                  </c:pt>
                  <c:pt idx="19">
                    <c:v>1.115</c:v>
                  </c:pt>
                </c:numCache>
              </c:numRef>
            </c:plus>
            <c:minus>
              <c:numRef>
                <c:f>Sheet1!$I$2:$I$21</c:f>
                <c:numCache>
                  <c:formatCode>General</c:formatCode>
                  <c:ptCount val="20"/>
                  <c:pt idx="0">
                    <c:v>0</c:v>
                  </c:pt>
                  <c:pt idx="4">
                    <c:v>1.0129999999999999</c:v>
                  </c:pt>
                  <c:pt idx="8">
                    <c:v>0.77900000000000003</c:v>
                  </c:pt>
                  <c:pt idx="12">
                    <c:v>0.998</c:v>
                  </c:pt>
                  <c:pt idx="16">
                    <c:v>0.99199999999999999</c:v>
                  </c:pt>
                  <c:pt idx="17">
                    <c:v>1.224</c:v>
                  </c:pt>
                  <c:pt idx="18">
                    <c:v>1.2290000000000001</c:v>
                  </c:pt>
                  <c:pt idx="19">
                    <c:v>1.1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$2:$A$21</c:f>
              <c:numCache>
                <c:formatCode>General</c:formatCode>
                <c:ptCount val="20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25</c:v>
                </c:pt>
                <c:pt idx="6">
                  <c:v>1.5</c:v>
                </c:pt>
                <c:pt idx="7">
                  <c:v>1.75</c:v>
                </c:pt>
                <c:pt idx="8">
                  <c:v>2</c:v>
                </c:pt>
                <c:pt idx="9">
                  <c:v>2.25</c:v>
                </c:pt>
                <c:pt idx="10">
                  <c:v>2.5</c:v>
                </c:pt>
                <c:pt idx="11">
                  <c:v>2.75</c:v>
                </c:pt>
                <c:pt idx="12">
                  <c:v>3</c:v>
                </c:pt>
                <c:pt idx="13">
                  <c:v>3.25</c:v>
                </c:pt>
                <c:pt idx="14">
                  <c:v>3.5</c:v>
                </c:pt>
                <c:pt idx="15">
                  <c:v>3.75</c:v>
                </c:pt>
                <c:pt idx="16">
                  <c:v>4</c:v>
                </c:pt>
                <c:pt idx="17">
                  <c:v>8</c:v>
                </c:pt>
                <c:pt idx="18">
                  <c:v>16</c:v>
                </c:pt>
                <c:pt idx="19">
                  <c:v>24</c:v>
                </c:pt>
              </c:numCache>
            </c:numRef>
          </c:xVal>
          <c:yVal>
            <c:numRef>
              <c:f>Sheet1!$H$2:$H$21</c:f>
              <c:numCache>
                <c:formatCode>General</c:formatCode>
                <c:ptCount val="20"/>
                <c:pt idx="0">
                  <c:v>100</c:v>
                </c:pt>
                <c:pt idx="4">
                  <c:v>99.263000000000005</c:v>
                </c:pt>
                <c:pt idx="8">
                  <c:v>100.054</c:v>
                </c:pt>
                <c:pt idx="12">
                  <c:v>100.258</c:v>
                </c:pt>
                <c:pt idx="16">
                  <c:v>99.778000000000006</c:v>
                </c:pt>
                <c:pt idx="17">
                  <c:v>98.445999999999998</c:v>
                </c:pt>
                <c:pt idx="18">
                  <c:v>97.337999999999994</c:v>
                </c:pt>
                <c:pt idx="19">
                  <c:v>96.59800000000001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8D14-FD4D-9E31-2F7CDF9112B9}"/>
            </c:ext>
          </c:extLst>
        </c:ser>
        <c:ser>
          <c:idx val="9"/>
          <c:order val="4"/>
          <c:tx>
            <c:v>POPC</c:v>
          </c:tx>
          <c:spPr>
            <a:ln w="19050" cap="rnd">
              <a:solidFill>
                <a:srgbClr val="FF40FF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FF40FF"/>
              </a:solidFill>
              <a:ln w="9525">
                <a:solidFill>
                  <a:srgbClr val="FF4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2:$K$21</c:f>
                <c:numCache>
                  <c:formatCode>General</c:formatCode>
                  <c:ptCount val="20"/>
                  <c:pt idx="0">
                    <c:v>0</c:v>
                  </c:pt>
                  <c:pt idx="4">
                    <c:v>1.2250000000000001</c:v>
                  </c:pt>
                  <c:pt idx="8">
                    <c:v>1.093</c:v>
                  </c:pt>
                  <c:pt idx="12">
                    <c:v>1.0009999999999999</c:v>
                  </c:pt>
                  <c:pt idx="16">
                    <c:v>1.002</c:v>
                  </c:pt>
                  <c:pt idx="17">
                    <c:v>1.4890000000000001</c:v>
                  </c:pt>
                  <c:pt idx="18">
                    <c:v>1.556</c:v>
                  </c:pt>
                  <c:pt idx="19">
                    <c:v>0.98899999999999999</c:v>
                  </c:pt>
                </c:numCache>
              </c:numRef>
            </c:plus>
            <c:minus>
              <c:numRef>
                <c:f>Sheet1!$K$2:$K$21</c:f>
                <c:numCache>
                  <c:formatCode>General</c:formatCode>
                  <c:ptCount val="20"/>
                  <c:pt idx="0">
                    <c:v>0</c:v>
                  </c:pt>
                  <c:pt idx="4">
                    <c:v>1.2250000000000001</c:v>
                  </c:pt>
                  <c:pt idx="8">
                    <c:v>1.093</c:v>
                  </c:pt>
                  <c:pt idx="12">
                    <c:v>1.0009999999999999</c:v>
                  </c:pt>
                  <c:pt idx="16">
                    <c:v>1.002</c:v>
                  </c:pt>
                  <c:pt idx="17">
                    <c:v>1.4890000000000001</c:v>
                  </c:pt>
                  <c:pt idx="18">
                    <c:v>1.556</c:v>
                  </c:pt>
                  <c:pt idx="19">
                    <c:v>0.988999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$2:$A$21</c:f>
              <c:numCache>
                <c:formatCode>General</c:formatCode>
                <c:ptCount val="20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25</c:v>
                </c:pt>
                <c:pt idx="6">
                  <c:v>1.5</c:v>
                </c:pt>
                <c:pt idx="7">
                  <c:v>1.75</c:v>
                </c:pt>
                <c:pt idx="8">
                  <c:v>2</c:v>
                </c:pt>
                <c:pt idx="9">
                  <c:v>2.25</c:v>
                </c:pt>
                <c:pt idx="10">
                  <c:v>2.5</c:v>
                </c:pt>
                <c:pt idx="11">
                  <c:v>2.75</c:v>
                </c:pt>
                <c:pt idx="12">
                  <c:v>3</c:v>
                </c:pt>
                <c:pt idx="13">
                  <c:v>3.25</c:v>
                </c:pt>
                <c:pt idx="14">
                  <c:v>3.5</c:v>
                </c:pt>
                <c:pt idx="15">
                  <c:v>3.75</c:v>
                </c:pt>
                <c:pt idx="16">
                  <c:v>4</c:v>
                </c:pt>
                <c:pt idx="17">
                  <c:v>8</c:v>
                </c:pt>
                <c:pt idx="18">
                  <c:v>16</c:v>
                </c:pt>
                <c:pt idx="19">
                  <c:v>24</c:v>
                </c:pt>
              </c:numCache>
            </c:numRef>
          </c:xVal>
          <c:yVal>
            <c:numRef>
              <c:f>Sheet1!$J$2:$J$21</c:f>
              <c:numCache>
                <c:formatCode>General</c:formatCode>
                <c:ptCount val="20"/>
                <c:pt idx="0">
                  <c:v>100</c:v>
                </c:pt>
                <c:pt idx="4">
                  <c:v>101.55800000000001</c:v>
                </c:pt>
                <c:pt idx="8">
                  <c:v>99.986000000000004</c:v>
                </c:pt>
                <c:pt idx="12">
                  <c:v>98.998000000000005</c:v>
                </c:pt>
                <c:pt idx="16">
                  <c:v>99.998000000000005</c:v>
                </c:pt>
                <c:pt idx="17">
                  <c:v>98.998000000000005</c:v>
                </c:pt>
                <c:pt idx="18">
                  <c:v>97.885999999999981</c:v>
                </c:pt>
                <c:pt idx="19">
                  <c:v>97.25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8D14-FD4D-9E31-2F7CDF9112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57585264"/>
        <c:axId val="1057587808"/>
      </c:scatterChart>
      <c:valAx>
        <c:axId val="1057585264"/>
        <c:scaling>
          <c:orientation val="minMax"/>
          <c:max val="2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Time</a:t>
                </a:r>
                <a:r>
                  <a:rPr lang="en-US" sz="1200" b="1" baseline="0">
                    <a:solidFill>
                      <a:schemeClr val="tx1"/>
                    </a:solidFill>
                  </a:rPr>
                  <a:t> (h)</a:t>
                </a:r>
                <a:endParaRPr lang="en-US" sz="1200" b="1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46434186827503499"/>
              <c:y val="0.956411516456125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57587808"/>
        <c:crosses val="autoZero"/>
        <c:crossBetween val="midCat"/>
        <c:majorUnit val="3"/>
      </c:valAx>
      <c:valAx>
        <c:axId val="1057587808"/>
        <c:scaling>
          <c:orientation val="minMax"/>
          <c:max val="106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Encapsulation</a:t>
                </a:r>
                <a:r>
                  <a:rPr lang="en-US" sz="1200" b="1" baseline="0">
                    <a:solidFill>
                      <a:schemeClr val="tx1"/>
                    </a:solidFill>
                  </a:rPr>
                  <a:t> (%)</a:t>
                </a:r>
                <a:endParaRPr lang="en-US" sz="1200" b="1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4539159862762699E-2"/>
              <c:y val="0.3893280179006399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5758526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7283473291021698"/>
          <c:y val="0.453147811651749"/>
          <c:w val="0.19126176301133099"/>
          <c:h val="0.207808286784665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2886701662292"/>
          <c:y val="3.05139982502187E-2"/>
          <c:w val="0.77967856181438799"/>
          <c:h val="0.92749999999999999"/>
        </c:manualLayout>
      </c:layout>
      <c:scatterChart>
        <c:scatterStyle val="smoothMarker"/>
        <c:varyColors val="0"/>
        <c:ser>
          <c:idx val="0"/>
          <c:order val="0"/>
          <c:tx>
            <c:v>Vesicles (OA-POPC (1:5))</c:v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K$2:$K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L$2:$L$53</c:f>
              <c:numCache>
                <c:formatCode>General</c:formatCode>
                <c:ptCount val="52"/>
                <c:pt idx="0">
                  <c:v>0</c:v>
                </c:pt>
                <c:pt idx="1">
                  <c:v>-6.7400000000000003E-3</c:v>
                </c:pt>
                <c:pt idx="2">
                  <c:v>-1.4239999999999999E-2</c:v>
                </c:pt>
                <c:pt idx="3">
                  <c:v>-2.1129999999999999E-2</c:v>
                </c:pt>
                <c:pt idx="4">
                  <c:v>-3.1550000000000002E-2</c:v>
                </c:pt>
                <c:pt idx="5">
                  <c:v>-2.223E-2</c:v>
                </c:pt>
                <c:pt idx="6">
                  <c:v>-1.7100000000000001E-2</c:v>
                </c:pt>
                <c:pt idx="7">
                  <c:v>-3.5740000000000001E-2</c:v>
                </c:pt>
                <c:pt idx="8">
                  <c:v>-3.5740000000000001E-2</c:v>
                </c:pt>
                <c:pt idx="9">
                  <c:v>-4.6210000000000001E-2</c:v>
                </c:pt>
                <c:pt idx="10">
                  <c:v>-3.773E-2</c:v>
                </c:pt>
                <c:pt idx="11">
                  <c:v>-3.9600000000000003E-2</c:v>
                </c:pt>
                <c:pt idx="12">
                  <c:v>-5.1389999999999998E-2</c:v>
                </c:pt>
                <c:pt idx="13">
                  <c:v>-4.3580000000000001E-2</c:v>
                </c:pt>
                <c:pt idx="14">
                  <c:v>-3.78E-2</c:v>
                </c:pt>
                <c:pt idx="15">
                  <c:v>-3.329E-2</c:v>
                </c:pt>
                <c:pt idx="16">
                  <c:v>-3.7539999999999997E-2</c:v>
                </c:pt>
                <c:pt idx="17">
                  <c:v>-3.0380000000000001E-2</c:v>
                </c:pt>
                <c:pt idx="18">
                  <c:v>-3.7670000000000002E-2</c:v>
                </c:pt>
                <c:pt idx="19">
                  <c:v>-4.1459999999999997E-2</c:v>
                </c:pt>
                <c:pt idx="20">
                  <c:v>-3.9019999999999999E-2</c:v>
                </c:pt>
                <c:pt idx="21">
                  <c:v>-4.9529999999999998E-2</c:v>
                </c:pt>
                <c:pt idx="22">
                  <c:v>-2.5659999999999999E-2</c:v>
                </c:pt>
                <c:pt idx="23">
                  <c:v>-4.5440000000000001E-2</c:v>
                </c:pt>
                <c:pt idx="24">
                  <c:v>-4.0689999999999997E-2</c:v>
                </c:pt>
                <c:pt idx="25">
                  <c:v>-4.088E-2</c:v>
                </c:pt>
                <c:pt idx="26">
                  <c:v>-3.3799999999999997E-2</c:v>
                </c:pt>
                <c:pt idx="27">
                  <c:v>-4.614E-2</c:v>
                </c:pt>
                <c:pt idx="28">
                  <c:v>-2.3009999999999999E-2</c:v>
                </c:pt>
                <c:pt idx="29">
                  <c:v>-3.483E-2</c:v>
                </c:pt>
                <c:pt idx="30">
                  <c:v>-3.2259999999999997E-2</c:v>
                </c:pt>
                <c:pt idx="31">
                  <c:v>-3.1739999999999997E-2</c:v>
                </c:pt>
                <c:pt idx="32">
                  <c:v>-2.3980000000000001E-2</c:v>
                </c:pt>
                <c:pt idx="33">
                  <c:v>-3.4450000000000001E-2</c:v>
                </c:pt>
                <c:pt idx="34">
                  <c:v>-3.7280000000000001E-2</c:v>
                </c:pt>
                <c:pt idx="35">
                  <c:v>-2.7799999999999998E-2</c:v>
                </c:pt>
                <c:pt idx="36">
                  <c:v>-4.2290000000000001E-2</c:v>
                </c:pt>
                <c:pt idx="37">
                  <c:v>-2.6179999999999998E-2</c:v>
                </c:pt>
                <c:pt idx="38">
                  <c:v>-3.9210000000000002E-2</c:v>
                </c:pt>
                <c:pt idx="39">
                  <c:v>-2.7220000000000001E-2</c:v>
                </c:pt>
                <c:pt idx="40">
                  <c:v>-2.793E-2</c:v>
                </c:pt>
                <c:pt idx="41">
                  <c:v>-3.032E-2</c:v>
                </c:pt>
                <c:pt idx="42">
                  <c:v>-4.5310000000000003E-2</c:v>
                </c:pt>
                <c:pt idx="43">
                  <c:v>-2.8580000000000001E-2</c:v>
                </c:pt>
                <c:pt idx="44">
                  <c:v>-3.7220000000000003E-2</c:v>
                </c:pt>
                <c:pt idx="45">
                  <c:v>-3.006E-2</c:v>
                </c:pt>
                <c:pt idx="46">
                  <c:v>-4.4670000000000001E-2</c:v>
                </c:pt>
                <c:pt idx="47">
                  <c:v>-4.5949999999999998E-2</c:v>
                </c:pt>
                <c:pt idx="48">
                  <c:v>-4.2169999999999999E-2</c:v>
                </c:pt>
                <c:pt idx="49">
                  <c:v>-4.0750000000000001E-2</c:v>
                </c:pt>
                <c:pt idx="50">
                  <c:v>-4.2419999999999999E-2</c:v>
                </c:pt>
                <c:pt idx="51">
                  <c:v>-4.4600000000000001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B1F-864B-B483-BD2205AAF919}"/>
            </c:ext>
          </c:extLst>
        </c:ser>
        <c:ser>
          <c:idx val="1"/>
          <c:order val="1"/>
          <c:tx>
            <c:v>Vesicles + K+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K$2:$K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M$2:$M$53</c:f>
              <c:numCache>
                <c:formatCode>General</c:formatCode>
                <c:ptCount val="52"/>
                <c:pt idx="0">
                  <c:v>0</c:v>
                </c:pt>
                <c:pt idx="1">
                  <c:v>0.15114</c:v>
                </c:pt>
                <c:pt idx="2">
                  <c:v>0.19084999999999999</c:v>
                </c:pt>
                <c:pt idx="3">
                  <c:v>0.22592999999999999</c:v>
                </c:pt>
                <c:pt idx="4">
                  <c:v>0.24709</c:v>
                </c:pt>
                <c:pt idx="5">
                  <c:v>0.27500999999999998</c:v>
                </c:pt>
                <c:pt idx="6">
                  <c:v>0.26811000000000001</c:v>
                </c:pt>
                <c:pt idx="7">
                  <c:v>0.27788000000000002</c:v>
                </c:pt>
                <c:pt idx="8">
                  <c:v>0.28393000000000002</c:v>
                </c:pt>
                <c:pt idx="9">
                  <c:v>0.29207</c:v>
                </c:pt>
                <c:pt idx="10">
                  <c:v>0.29622999999999999</c:v>
                </c:pt>
                <c:pt idx="11">
                  <c:v>0.32185999999999998</c:v>
                </c:pt>
                <c:pt idx="12">
                  <c:v>0.33029999999999998</c:v>
                </c:pt>
                <c:pt idx="13">
                  <c:v>0.34826000000000001</c:v>
                </c:pt>
                <c:pt idx="14">
                  <c:v>0.36620999999999998</c:v>
                </c:pt>
                <c:pt idx="15">
                  <c:v>0.36160999999999999</c:v>
                </c:pt>
                <c:pt idx="16">
                  <c:v>0.40765000000000001</c:v>
                </c:pt>
                <c:pt idx="17">
                  <c:v>0.42909999999999998</c:v>
                </c:pt>
                <c:pt idx="18">
                  <c:v>0.43479000000000001</c:v>
                </c:pt>
                <c:pt idx="19">
                  <c:v>0.4541</c:v>
                </c:pt>
                <c:pt idx="20">
                  <c:v>0.45906000000000002</c:v>
                </c:pt>
                <c:pt idx="21">
                  <c:v>0.48902000000000001</c:v>
                </c:pt>
                <c:pt idx="22">
                  <c:v>0.49242999999999998</c:v>
                </c:pt>
                <c:pt idx="23">
                  <c:v>0.51175999999999999</c:v>
                </c:pt>
                <c:pt idx="24">
                  <c:v>0.53713</c:v>
                </c:pt>
                <c:pt idx="25">
                  <c:v>0.53034999999999999</c:v>
                </c:pt>
                <c:pt idx="26">
                  <c:v>0.55042999999999997</c:v>
                </c:pt>
                <c:pt idx="27">
                  <c:v>0.56313000000000002</c:v>
                </c:pt>
                <c:pt idx="28">
                  <c:v>0.53978999999999999</c:v>
                </c:pt>
                <c:pt idx="29">
                  <c:v>0.56715000000000004</c:v>
                </c:pt>
                <c:pt idx="30">
                  <c:v>0.56211999999999995</c:v>
                </c:pt>
                <c:pt idx="31">
                  <c:v>0.57093000000000005</c:v>
                </c:pt>
                <c:pt idx="32">
                  <c:v>0.59145000000000003</c:v>
                </c:pt>
                <c:pt idx="33">
                  <c:v>0.58298000000000005</c:v>
                </c:pt>
                <c:pt idx="34">
                  <c:v>0.57033999999999996</c:v>
                </c:pt>
                <c:pt idx="35">
                  <c:v>0.60089000000000004</c:v>
                </c:pt>
                <c:pt idx="36">
                  <c:v>0.61550000000000005</c:v>
                </c:pt>
                <c:pt idx="37">
                  <c:v>0.61909999999999998</c:v>
                </c:pt>
                <c:pt idx="38">
                  <c:v>0.60668999999999995</c:v>
                </c:pt>
                <c:pt idx="39">
                  <c:v>0.62278999999999995</c:v>
                </c:pt>
                <c:pt idx="40">
                  <c:v>0.63055000000000005</c:v>
                </c:pt>
                <c:pt idx="41">
                  <c:v>0.64464999999999995</c:v>
                </c:pt>
                <c:pt idx="42">
                  <c:v>0.65691999999999995</c:v>
                </c:pt>
                <c:pt idx="43">
                  <c:v>0.62787000000000004</c:v>
                </c:pt>
                <c:pt idx="44">
                  <c:v>0.65988999999999998</c:v>
                </c:pt>
                <c:pt idx="45">
                  <c:v>0.64681999999999995</c:v>
                </c:pt>
                <c:pt idx="46">
                  <c:v>0.63693999999999995</c:v>
                </c:pt>
                <c:pt idx="47">
                  <c:v>0.66742000000000001</c:v>
                </c:pt>
                <c:pt idx="48">
                  <c:v>0.66356000000000004</c:v>
                </c:pt>
                <c:pt idx="49">
                  <c:v>0.67742999999999998</c:v>
                </c:pt>
                <c:pt idx="50">
                  <c:v>0.67796000000000001</c:v>
                </c:pt>
                <c:pt idx="51">
                  <c:v>0.678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B1F-864B-B483-BD2205AAF919}"/>
            </c:ext>
          </c:extLst>
        </c:ser>
        <c:ser>
          <c:idx val="2"/>
          <c:order val="2"/>
          <c:tx>
            <c:v>Vesicles + K+ + Valinomycin</c:v>
          </c:tx>
          <c:spPr>
            <a:ln w="19050" cap="rnd">
              <a:solidFill>
                <a:srgbClr val="0432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432FF"/>
              </a:solidFill>
              <a:ln w="9525">
                <a:solidFill>
                  <a:srgbClr val="0432FF"/>
                </a:solidFill>
              </a:ln>
              <a:effectLst/>
            </c:spPr>
          </c:marker>
          <c:xVal>
            <c:numRef>
              <c:f>Sheet1!$K$2:$K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N$2:$N$53</c:f>
              <c:numCache>
                <c:formatCode>General</c:formatCode>
                <c:ptCount val="52"/>
                <c:pt idx="0">
                  <c:v>0</c:v>
                </c:pt>
                <c:pt idx="1">
                  <c:v>0.31634000000000001</c:v>
                </c:pt>
                <c:pt idx="2">
                  <c:v>0.41826999999999998</c:v>
                </c:pt>
                <c:pt idx="3">
                  <c:v>0.4677</c:v>
                </c:pt>
                <c:pt idx="4">
                  <c:v>0.52324000000000004</c:v>
                </c:pt>
                <c:pt idx="5">
                  <c:v>0.55733999999999995</c:v>
                </c:pt>
                <c:pt idx="6">
                  <c:v>0.59711999999999998</c:v>
                </c:pt>
                <c:pt idx="7">
                  <c:v>0.63848000000000005</c:v>
                </c:pt>
                <c:pt idx="8">
                  <c:v>0.64563000000000004</c:v>
                </c:pt>
                <c:pt idx="9">
                  <c:v>0.66756000000000004</c:v>
                </c:pt>
                <c:pt idx="10">
                  <c:v>0.69535999999999998</c:v>
                </c:pt>
                <c:pt idx="11">
                  <c:v>0.71914</c:v>
                </c:pt>
                <c:pt idx="12">
                  <c:v>0.72533999999999998</c:v>
                </c:pt>
                <c:pt idx="13">
                  <c:v>0.76283999999999996</c:v>
                </c:pt>
                <c:pt idx="14">
                  <c:v>0.78039000000000003</c:v>
                </c:pt>
                <c:pt idx="15">
                  <c:v>0.75083</c:v>
                </c:pt>
                <c:pt idx="16">
                  <c:v>0.82328999999999997</c:v>
                </c:pt>
                <c:pt idx="17">
                  <c:v>0.78969</c:v>
                </c:pt>
                <c:pt idx="18">
                  <c:v>0.76378000000000001</c:v>
                </c:pt>
                <c:pt idx="19">
                  <c:v>0.74541000000000002</c:v>
                </c:pt>
                <c:pt idx="20">
                  <c:v>0.88371999999999995</c:v>
                </c:pt>
                <c:pt idx="21">
                  <c:v>0.89829999999999999</c:v>
                </c:pt>
                <c:pt idx="22">
                  <c:v>0.87749999999999995</c:v>
                </c:pt>
                <c:pt idx="23">
                  <c:v>0.89631000000000005</c:v>
                </c:pt>
                <c:pt idx="24">
                  <c:v>0.90815999999999997</c:v>
                </c:pt>
                <c:pt idx="25">
                  <c:v>0.98038999999999998</c:v>
                </c:pt>
                <c:pt idx="26">
                  <c:v>0.96399000000000001</c:v>
                </c:pt>
                <c:pt idx="27">
                  <c:v>1.02121</c:v>
                </c:pt>
                <c:pt idx="28">
                  <c:v>1.03043</c:v>
                </c:pt>
                <c:pt idx="29">
                  <c:v>1.0463100000000001</c:v>
                </c:pt>
                <c:pt idx="30">
                  <c:v>1.0629299999999999</c:v>
                </c:pt>
                <c:pt idx="31">
                  <c:v>1.0416700000000001</c:v>
                </c:pt>
                <c:pt idx="32">
                  <c:v>1.07304</c:v>
                </c:pt>
                <c:pt idx="33">
                  <c:v>1.06952</c:v>
                </c:pt>
                <c:pt idx="34">
                  <c:v>1.08941</c:v>
                </c:pt>
                <c:pt idx="35">
                  <c:v>1.0990899999999999</c:v>
                </c:pt>
                <c:pt idx="36">
                  <c:v>1.0749599999999999</c:v>
                </c:pt>
                <c:pt idx="37">
                  <c:v>1.08748</c:v>
                </c:pt>
                <c:pt idx="38">
                  <c:v>1.1293200000000001</c:v>
                </c:pt>
                <c:pt idx="39">
                  <c:v>1.1016699999999999</c:v>
                </c:pt>
                <c:pt idx="40">
                  <c:v>1.13259</c:v>
                </c:pt>
                <c:pt idx="41">
                  <c:v>1.1519900000000001</c:v>
                </c:pt>
                <c:pt idx="42">
                  <c:v>1.11649</c:v>
                </c:pt>
                <c:pt idx="43">
                  <c:v>1.0941399999999999</c:v>
                </c:pt>
                <c:pt idx="44">
                  <c:v>1.13828</c:v>
                </c:pt>
                <c:pt idx="45">
                  <c:v>1.18876</c:v>
                </c:pt>
                <c:pt idx="46">
                  <c:v>1.1766300000000001</c:v>
                </c:pt>
                <c:pt idx="47">
                  <c:v>1.1498999999999999</c:v>
                </c:pt>
                <c:pt idx="48">
                  <c:v>1.1471499999999999</c:v>
                </c:pt>
                <c:pt idx="49">
                  <c:v>1.1515500000000001</c:v>
                </c:pt>
                <c:pt idx="50">
                  <c:v>1.1660999999999999</c:v>
                </c:pt>
                <c:pt idx="51">
                  <c:v>1.141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B1F-864B-B483-BD2205AAF9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91272912"/>
        <c:axId val="1091268000"/>
      </c:scatterChart>
      <c:valAx>
        <c:axId val="1091272912"/>
        <c:scaling>
          <c:orientation val="minMax"/>
          <c:max val="10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1268000"/>
        <c:crosses val="autoZero"/>
        <c:crossBetween val="midCat"/>
        <c:majorUnit val="20"/>
      </c:valAx>
      <c:valAx>
        <c:axId val="1091268000"/>
        <c:scaling>
          <c:orientation val="minMax"/>
          <c:max val="2.5"/>
          <c:min val="-0.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1272912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104793391210699"/>
          <c:y val="3.05139982502187E-2"/>
          <c:w val="0.77967856181438799"/>
          <c:h val="0.92749999999999999"/>
        </c:manualLayout>
      </c:layout>
      <c:scatterChart>
        <c:scatterStyle val="smoothMarker"/>
        <c:varyColors val="0"/>
        <c:ser>
          <c:idx val="0"/>
          <c:order val="0"/>
          <c:tx>
            <c:v>Vesicles</c:v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A$2:$A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B$2:$B$53</c:f>
              <c:numCache>
                <c:formatCode>General</c:formatCode>
                <c:ptCount val="52"/>
                <c:pt idx="0">
                  <c:v>0</c:v>
                </c:pt>
                <c:pt idx="1">
                  <c:v>-1.0970000000000001E-2</c:v>
                </c:pt>
                <c:pt idx="2">
                  <c:v>-4.8900000000000002E-3</c:v>
                </c:pt>
                <c:pt idx="3">
                  <c:v>-1.231E-2</c:v>
                </c:pt>
                <c:pt idx="4">
                  <c:v>-7.1399999999999996E-3</c:v>
                </c:pt>
                <c:pt idx="5">
                  <c:v>-2.0559999999999998E-2</c:v>
                </c:pt>
                <c:pt idx="6">
                  <c:v>-2.4889999999999999E-2</c:v>
                </c:pt>
                <c:pt idx="7">
                  <c:v>-2.2190000000000001E-2</c:v>
                </c:pt>
                <c:pt idx="8">
                  <c:v>-2.3769999999999999E-2</c:v>
                </c:pt>
                <c:pt idx="9">
                  <c:v>-2.6509999999999999E-2</c:v>
                </c:pt>
                <c:pt idx="10">
                  <c:v>-2.4930000000000001E-2</c:v>
                </c:pt>
                <c:pt idx="11">
                  <c:v>-1.149E-2</c:v>
                </c:pt>
                <c:pt idx="12">
                  <c:v>-1.575E-2</c:v>
                </c:pt>
                <c:pt idx="13">
                  <c:v>-2.9069999999999999E-2</c:v>
                </c:pt>
                <c:pt idx="14">
                  <c:v>-1.644E-2</c:v>
                </c:pt>
                <c:pt idx="15">
                  <c:v>-2.069E-2</c:v>
                </c:pt>
                <c:pt idx="16">
                  <c:v>-1.3169999999999999E-2</c:v>
                </c:pt>
                <c:pt idx="17">
                  <c:v>-1.3559999999999999E-2</c:v>
                </c:pt>
                <c:pt idx="18">
                  <c:v>-2.707E-2</c:v>
                </c:pt>
                <c:pt idx="19">
                  <c:v>-3.4619999999999998E-2</c:v>
                </c:pt>
                <c:pt idx="20">
                  <c:v>-3.4619999999999998E-2</c:v>
                </c:pt>
                <c:pt idx="21">
                  <c:v>-3.2099999999999997E-2</c:v>
                </c:pt>
                <c:pt idx="22">
                  <c:v>-2.2620000000000001E-2</c:v>
                </c:pt>
                <c:pt idx="23">
                  <c:v>-3.5680000000000003E-2</c:v>
                </c:pt>
                <c:pt idx="24">
                  <c:v>-2.8989999999999998E-2</c:v>
                </c:pt>
                <c:pt idx="25">
                  <c:v>-3.134E-2</c:v>
                </c:pt>
                <c:pt idx="26">
                  <c:v>-3.168E-2</c:v>
                </c:pt>
                <c:pt idx="27">
                  <c:v>-3.8949999999999999E-2</c:v>
                </c:pt>
                <c:pt idx="28">
                  <c:v>-3.551E-2</c:v>
                </c:pt>
                <c:pt idx="29">
                  <c:v>-3.415E-2</c:v>
                </c:pt>
                <c:pt idx="30">
                  <c:v>-2.3560000000000001E-2</c:v>
                </c:pt>
                <c:pt idx="31">
                  <c:v>-4.367E-2</c:v>
                </c:pt>
                <c:pt idx="32">
                  <c:v>-3.4619999999999998E-2</c:v>
                </c:pt>
                <c:pt idx="33">
                  <c:v>-4.3920000000000001E-2</c:v>
                </c:pt>
                <c:pt idx="34">
                  <c:v>-2.5829999999999999E-2</c:v>
                </c:pt>
                <c:pt idx="35">
                  <c:v>-4.1500000000000002E-2</c:v>
                </c:pt>
                <c:pt idx="36">
                  <c:v>-3.8490000000000003E-2</c:v>
                </c:pt>
                <c:pt idx="37">
                  <c:v>-3.3509999999999998E-2</c:v>
                </c:pt>
                <c:pt idx="38">
                  <c:v>-3.236E-2</c:v>
                </c:pt>
                <c:pt idx="39">
                  <c:v>-2.8989999999999998E-2</c:v>
                </c:pt>
                <c:pt idx="40">
                  <c:v>-4.4940000000000001E-2</c:v>
                </c:pt>
                <c:pt idx="41">
                  <c:v>-4.5109999999999997E-2</c:v>
                </c:pt>
                <c:pt idx="42">
                  <c:v>-3.1040000000000002E-2</c:v>
                </c:pt>
                <c:pt idx="43">
                  <c:v>-3.6360000000000003E-2</c:v>
                </c:pt>
                <c:pt idx="44">
                  <c:v>-4.7309999999999998E-2</c:v>
                </c:pt>
                <c:pt idx="45">
                  <c:v>-3.9719999999999998E-2</c:v>
                </c:pt>
                <c:pt idx="46">
                  <c:v>-3.6700000000000003E-2</c:v>
                </c:pt>
                <c:pt idx="47">
                  <c:v>-4.4299999999999999E-2</c:v>
                </c:pt>
                <c:pt idx="48">
                  <c:v>-3.7850000000000002E-2</c:v>
                </c:pt>
                <c:pt idx="49">
                  <c:v>-4.6589999999999999E-2</c:v>
                </c:pt>
                <c:pt idx="50">
                  <c:v>-5.2589999999999998E-2</c:v>
                </c:pt>
                <c:pt idx="51">
                  <c:v>-5.5500000000000001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30F3-674E-872D-942A6BB9FD0E}"/>
            </c:ext>
          </c:extLst>
        </c:ser>
        <c:ser>
          <c:idx val="1"/>
          <c:order val="1"/>
          <c:tx>
            <c:v>Vesicles + K+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A$2:$A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C$2:$C$53</c:f>
              <c:numCache>
                <c:formatCode>General</c:formatCode>
                <c:ptCount val="52"/>
                <c:pt idx="0">
                  <c:v>0</c:v>
                </c:pt>
                <c:pt idx="1">
                  <c:v>0.23971000000000001</c:v>
                </c:pt>
                <c:pt idx="2">
                  <c:v>0.38751999999999998</c:v>
                </c:pt>
                <c:pt idx="3">
                  <c:v>0.48247000000000001</c:v>
                </c:pt>
                <c:pt idx="4">
                  <c:v>0.54108000000000001</c:v>
                </c:pt>
                <c:pt idx="5">
                  <c:v>0.60936000000000001</c:v>
                </c:pt>
                <c:pt idx="6">
                  <c:v>0.67695000000000005</c:v>
                </c:pt>
                <c:pt idx="7">
                  <c:v>0.73372000000000004</c:v>
                </c:pt>
                <c:pt idx="8">
                  <c:v>0.77339000000000002</c:v>
                </c:pt>
                <c:pt idx="9">
                  <c:v>0.79564999999999997</c:v>
                </c:pt>
                <c:pt idx="10">
                  <c:v>0.79937000000000002</c:v>
                </c:pt>
                <c:pt idx="11">
                  <c:v>0.77886</c:v>
                </c:pt>
                <c:pt idx="12">
                  <c:v>0.75085999999999997</c:v>
                </c:pt>
                <c:pt idx="13">
                  <c:v>0.77524000000000004</c:v>
                </c:pt>
                <c:pt idx="14">
                  <c:v>0.80825999999999998</c:v>
                </c:pt>
                <c:pt idx="15">
                  <c:v>0.77173999999999998</c:v>
                </c:pt>
                <c:pt idx="16">
                  <c:v>0.80564000000000002</c:v>
                </c:pt>
                <c:pt idx="17">
                  <c:v>0.81774000000000002</c:v>
                </c:pt>
                <c:pt idx="18">
                  <c:v>0.86851999999999996</c:v>
                </c:pt>
                <c:pt idx="19">
                  <c:v>0.84521000000000002</c:v>
                </c:pt>
                <c:pt idx="20">
                  <c:v>0.88780999999999999</c:v>
                </c:pt>
                <c:pt idx="21">
                  <c:v>0.89134999999999998</c:v>
                </c:pt>
                <c:pt idx="22">
                  <c:v>0.90303999999999995</c:v>
                </c:pt>
                <c:pt idx="23">
                  <c:v>0.87990999999999997</c:v>
                </c:pt>
                <c:pt idx="24">
                  <c:v>0.89637999999999995</c:v>
                </c:pt>
                <c:pt idx="25">
                  <c:v>0.89676999999999996</c:v>
                </c:pt>
                <c:pt idx="26">
                  <c:v>0.88754999999999995</c:v>
                </c:pt>
                <c:pt idx="27">
                  <c:v>0.86572000000000005</c:v>
                </c:pt>
                <c:pt idx="28">
                  <c:v>0.89244999999999997</c:v>
                </c:pt>
                <c:pt idx="29">
                  <c:v>0.91042999999999996</c:v>
                </c:pt>
                <c:pt idx="30">
                  <c:v>0.87043999999999999</c:v>
                </c:pt>
                <c:pt idx="31">
                  <c:v>0.90744999999999998</c:v>
                </c:pt>
                <c:pt idx="32">
                  <c:v>0.90959000000000001</c:v>
                </c:pt>
                <c:pt idx="33">
                  <c:v>0.88826000000000005</c:v>
                </c:pt>
                <c:pt idx="34">
                  <c:v>0.88349999999999995</c:v>
                </c:pt>
                <c:pt idx="35">
                  <c:v>0.89032</c:v>
                </c:pt>
                <c:pt idx="36">
                  <c:v>0.88556000000000001</c:v>
                </c:pt>
                <c:pt idx="37">
                  <c:v>0.89437999999999995</c:v>
                </c:pt>
                <c:pt idx="38">
                  <c:v>0.93064000000000002</c:v>
                </c:pt>
                <c:pt idx="39">
                  <c:v>0.87612999999999996</c:v>
                </c:pt>
                <c:pt idx="40">
                  <c:v>0.87363000000000002</c:v>
                </c:pt>
                <c:pt idx="41">
                  <c:v>0.88588</c:v>
                </c:pt>
                <c:pt idx="42">
                  <c:v>0.89522000000000002</c:v>
                </c:pt>
                <c:pt idx="43">
                  <c:v>0.89463999999999999</c:v>
                </c:pt>
                <c:pt idx="44">
                  <c:v>0.90400999999999998</c:v>
                </c:pt>
                <c:pt idx="45">
                  <c:v>0.86839999999999995</c:v>
                </c:pt>
                <c:pt idx="46">
                  <c:v>0.92888000000000004</c:v>
                </c:pt>
                <c:pt idx="47">
                  <c:v>0.87236000000000002</c:v>
                </c:pt>
                <c:pt idx="48">
                  <c:v>0.89458000000000004</c:v>
                </c:pt>
                <c:pt idx="49">
                  <c:v>0.88704000000000005</c:v>
                </c:pt>
                <c:pt idx="50">
                  <c:v>0.87714999999999999</c:v>
                </c:pt>
                <c:pt idx="51">
                  <c:v>0.8838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30F3-674E-872D-942A6BB9FD0E}"/>
            </c:ext>
          </c:extLst>
        </c:ser>
        <c:ser>
          <c:idx val="2"/>
          <c:order val="2"/>
          <c:tx>
            <c:v>Vesicles + K+ + Valinomycin</c:v>
          </c:tx>
          <c:spPr>
            <a:ln w="19050" cap="rnd">
              <a:solidFill>
                <a:srgbClr val="0432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432FF"/>
              </a:solidFill>
              <a:ln w="9525">
                <a:solidFill>
                  <a:srgbClr val="0432FF"/>
                </a:solidFill>
              </a:ln>
              <a:effectLst/>
            </c:spPr>
          </c:marker>
          <c:xVal>
            <c:numRef>
              <c:f>Sheet1!$A$2:$A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D$2:$D$53</c:f>
              <c:numCache>
                <c:formatCode>General</c:formatCode>
                <c:ptCount val="52"/>
                <c:pt idx="0">
                  <c:v>0</c:v>
                </c:pt>
                <c:pt idx="1">
                  <c:v>0.22927</c:v>
                </c:pt>
                <c:pt idx="2">
                  <c:v>0.44120999999999999</c:v>
                </c:pt>
                <c:pt idx="3">
                  <c:v>0.59050999999999998</c:v>
                </c:pt>
                <c:pt idx="4">
                  <c:v>0.63836000000000004</c:v>
                </c:pt>
                <c:pt idx="5">
                  <c:v>0.73248000000000002</c:v>
                </c:pt>
                <c:pt idx="6">
                  <c:v>0.73202</c:v>
                </c:pt>
                <c:pt idx="7">
                  <c:v>0.75546999999999997</c:v>
                </c:pt>
                <c:pt idx="8">
                  <c:v>0.79171999999999998</c:v>
                </c:pt>
                <c:pt idx="9">
                  <c:v>0.83601000000000003</c:v>
                </c:pt>
                <c:pt idx="10">
                  <c:v>0.92898999999999998</c:v>
                </c:pt>
                <c:pt idx="11">
                  <c:v>0.98146</c:v>
                </c:pt>
                <c:pt idx="12">
                  <c:v>0.93901000000000001</c:v>
                </c:pt>
                <c:pt idx="13">
                  <c:v>0.88832999999999995</c:v>
                </c:pt>
                <c:pt idx="14">
                  <c:v>0.84845999999999999</c:v>
                </c:pt>
                <c:pt idx="15">
                  <c:v>0.84601000000000004</c:v>
                </c:pt>
                <c:pt idx="16">
                  <c:v>0.91569</c:v>
                </c:pt>
                <c:pt idx="17">
                  <c:v>0.91476999999999997</c:v>
                </c:pt>
                <c:pt idx="18">
                  <c:v>0.91225000000000001</c:v>
                </c:pt>
                <c:pt idx="19">
                  <c:v>0.90839000000000003</c:v>
                </c:pt>
                <c:pt idx="20">
                  <c:v>0.92806</c:v>
                </c:pt>
                <c:pt idx="21">
                  <c:v>0.93764000000000003</c:v>
                </c:pt>
                <c:pt idx="22">
                  <c:v>0.97001000000000004</c:v>
                </c:pt>
                <c:pt idx="23">
                  <c:v>0.96223999999999998</c:v>
                </c:pt>
                <c:pt idx="24">
                  <c:v>0.95867000000000002</c:v>
                </c:pt>
                <c:pt idx="25">
                  <c:v>0.92190000000000005</c:v>
                </c:pt>
                <c:pt idx="26">
                  <c:v>0.95130999999999999</c:v>
                </c:pt>
                <c:pt idx="27">
                  <c:v>0.91617999999999999</c:v>
                </c:pt>
                <c:pt idx="28">
                  <c:v>0.94806999999999997</c:v>
                </c:pt>
                <c:pt idx="29">
                  <c:v>0.97441</c:v>
                </c:pt>
                <c:pt idx="30">
                  <c:v>0.93906999999999996</c:v>
                </c:pt>
                <c:pt idx="31">
                  <c:v>0.95579999999999998</c:v>
                </c:pt>
                <c:pt idx="32">
                  <c:v>0.96780999999999995</c:v>
                </c:pt>
                <c:pt idx="33">
                  <c:v>0.95648999999999995</c:v>
                </c:pt>
                <c:pt idx="34">
                  <c:v>0.95699000000000001</c:v>
                </c:pt>
                <c:pt idx="35">
                  <c:v>0.94801000000000002</c:v>
                </c:pt>
                <c:pt idx="36">
                  <c:v>0.98536999999999997</c:v>
                </c:pt>
                <c:pt idx="37">
                  <c:v>0.94272999999999996</c:v>
                </c:pt>
                <c:pt idx="38">
                  <c:v>0.91108999999999996</c:v>
                </c:pt>
                <c:pt idx="39">
                  <c:v>0.94906999999999997</c:v>
                </c:pt>
                <c:pt idx="40">
                  <c:v>0.91005000000000003</c:v>
                </c:pt>
                <c:pt idx="41">
                  <c:v>0.92405000000000004</c:v>
                </c:pt>
                <c:pt idx="42">
                  <c:v>0.92566000000000004</c:v>
                </c:pt>
                <c:pt idx="43">
                  <c:v>0.90368000000000004</c:v>
                </c:pt>
                <c:pt idx="44">
                  <c:v>0.93059000000000003</c:v>
                </c:pt>
                <c:pt idx="45">
                  <c:v>0.91108999999999996</c:v>
                </c:pt>
                <c:pt idx="46">
                  <c:v>0.94198999999999999</c:v>
                </c:pt>
                <c:pt idx="47">
                  <c:v>0.96392999999999995</c:v>
                </c:pt>
                <c:pt idx="48">
                  <c:v>0.91747000000000001</c:v>
                </c:pt>
                <c:pt idx="49">
                  <c:v>0.93213999999999997</c:v>
                </c:pt>
                <c:pt idx="50">
                  <c:v>0.90844999999999998</c:v>
                </c:pt>
                <c:pt idx="51">
                  <c:v>0.9394400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30F3-674E-872D-942A6BB9FD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82044128"/>
        <c:axId val="1182045488"/>
      </c:scatterChart>
      <c:valAx>
        <c:axId val="1182044128"/>
        <c:scaling>
          <c:orientation val="minMax"/>
          <c:max val="10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82045488"/>
        <c:crosses val="autoZero"/>
        <c:crossBetween val="midCat"/>
        <c:majorUnit val="20"/>
      </c:valAx>
      <c:valAx>
        <c:axId val="1182045488"/>
        <c:scaling>
          <c:orientation val="minMax"/>
          <c:max val="2.5"/>
          <c:min val="-0.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82044128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27083333333333"/>
          <c:y val="0.69097025371828502"/>
          <c:w val="0.72211538461538505"/>
          <c:h val="0.1701408573928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2886701662292"/>
          <c:y val="3.05139982502187E-2"/>
          <c:w val="0.77967856181438799"/>
          <c:h val="0.87749212598425197"/>
        </c:manualLayout>
      </c:layout>
      <c:scatterChart>
        <c:scatterStyle val="smoothMarker"/>
        <c:varyColors val="0"/>
        <c:ser>
          <c:idx val="0"/>
          <c:order val="0"/>
          <c:tx>
            <c:v>Vesicles (OA-POPC (1:10))</c:v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U$2:$U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V$2:$V$53</c:f>
              <c:numCache>
                <c:formatCode>General</c:formatCode>
                <c:ptCount val="52"/>
                <c:pt idx="0">
                  <c:v>0</c:v>
                </c:pt>
                <c:pt idx="1">
                  <c:v>6.7099999999999998E-3</c:v>
                </c:pt>
                <c:pt idx="2">
                  <c:v>4.7299999999999998E-3</c:v>
                </c:pt>
                <c:pt idx="3" formatCode="0.00E+00">
                  <c:v>-3.9387899999999997E-4</c:v>
                </c:pt>
                <c:pt idx="4">
                  <c:v>-8.0599999999999995E-3</c:v>
                </c:pt>
                <c:pt idx="5" formatCode="0.00E+00">
                  <c:v>9.8503499999999999E-4</c:v>
                </c:pt>
                <c:pt idx="6">
                  <c:v>-2.3689999999999999E-2</c:v>
                </c:pt>
                <c:pt idx="7">
                  <c:v>-2.077E-2</c:v>
                </c:pt>
                <c:pt idx="8">
                  <c:v>-8.26E-3</c:v>
                </c:pt>
                <c:pt idx="9">
                  <c:v>-1.7840000000000002E-2</c:v>
                </c:pt>
                <c:pt idx="10">
                  <c:v>-1.061E-2</c:v>
                </c:pt>
                <c:pt idx="11">
                  <c:v>-1.12E-2</c:v>
                </c:pt>
                <c:pt idx="12">
                  <c:v>-1.687E-2</c:v>
                </c:pt>
                <c:pt idx="13">
                  <c:v>-1.55E-2</c:v>
                </c:pt>
                <c:pt idx="14">
                  <c:v>-3.5340000000000003E-2</c:v>
                </c:pt>
                <c:pt idx="15">
                  <c:v>-3.9399999999999999E-3</c:v>
                </c:pt>
                <c:pt idx="16">
                  <c:v>-2.4279999999999999E-2</c:v>
                </c:pt>
                <c:pt idx="17">
                  <c:v>-1.7649999999999999E-2</c:v>
                </c:pt>
                <c:pt idx="18">
                  <c:v>-2.9520000000000001E-2</c:v>
                </c:pt>
                <c:pt idx="19">
                  <c:v>-2.913E-2</c:v>
                </c:pt>
                <c:pt idx="20">
                  <c:v>-1.9009999999999999E-2</c:v>
                </c:pt>
                <c:pt idx="21">
                  <c:v>-3.1269999999999999E-2</c:v>
                </c:pt>
                <c:pt idx="22">
                  <c:v>-1.804E-2</c:v>
                </c:pt>
                <c:pt idx="23">
                  <c:v>-3.4169999999999999E-2</c:v>
                </c:pt>
                <c:pt idx="24">
                  <c:v>-2.7189999999999999E-2</c:v>
                </c:pt>
                <c:pt idx="25">
                  <c:v>-2.486E-2</c:v>
                </c:pt>
                <c:pt idx="26">
                  <c:v>-4.2290000000000001E-2</c:v>
                </c:pt>
                <c:pt idx="27">
                  <c:v>-1.5890000000000001E-2</c:v>
                </c:pt>
                <c:pt idx="28">
                  <c:v>-3.1660000000000001E-2</c:v>
                </c:pt>
                <c:pt idx="29">
                  <c:v>-1.7840000000000002E-2</c:v>
                </c:pt>
                <c:pt idx="30">
                  <c:v>-2.4080000000000001E-2</c:v>
                </c:pt>
                <c:pt idx="31">
                  <c:v>-2.0959999999999999E-2</c:v>
                </c:pt>
                <c:pt idx="32">
                  <c:v>-1.823E-2</c:v>
                </c:pt>
                <c:pt idx="33">
                  <c:v>-1.2370000000000001E-2</c:v>
                </c:pt>
                <c:pt idx="34">
                  <c:v>-4.4220000000000002E-2</c:v>
                </c:pt>
                <c:pt idx="35">
                  <c:v>-2.622E-2</c:v>
                </c:pt>
                <c:pt idx="36">
                  <c:v>-1.3350000000000001E-2</c:v>
                </c:pt>
                <c:pt idx="37">
                  <c:v>-1.0410000000000001E-2</c:v>
                </c:pt>
                <c:pt idx="38">
                  <c:v>-3.7080000000000002E-2</c:v>
                </c:pt>
                <c:pt idx="39">
                  <c:v>-2.5829999999999999E-2</c:v>
                </c:pt>
                <c:pt idx="40">
                  <c:v>-2.9520000000000001E-2</c:v>
                </c:pt>
                <c:pt idx="41">
                  <c:v>-3.8620000000000002E-2</c:v>
                </c:pt>
                <c:pt idx="42">
                  <c:v>-2.4080000000000001E-2</c:v>
                </c:pt>
                <c:pt idx="43">
                  <c:v>-2.8549999999999999E-2</c:v>
                </c:pt>
                <c:pt idx="44">
                  <c:v>-3.107E-2</c:v>
                </c:pt>
                <c:pt idx="45">
                  <c:v>-5.3060000000000003E-2</c:v>
                </c:pt>
                <c:pt idx="46">
                  <c:v>-3.2820000000000002E-2</c:v>
                </c:pt>
                <c:pt idx="47">
                  <c:v>-3.6110000000000003E-2</c:v>
                </c:pt>
                <c:pt idx="48">
                  <c:v>-4.4990000000000002E-2</c:v>
                </c:pt>
                <c:pt idx="49">
                  <c:v>-3.2620000000000003E-2</c:v>
                </c:pt>
                <c:pt idx="50">
                  <c:v>-3.9780000000000003E-2</c:v>
                </c:pt>
                <c:pt idx="51">
                  <c:v>-3.0689999999999999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0DA-8D43-893D-93FFA0023C71}"/>
            </c:ext>
          </c:extLst>
        </c:ser>
        <c:ser>
          <c:idx val="1"/>
          <c:order val="1"/>
          <c:tx>
            <c:v>Vesicles + K+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U$2:$U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W$2:$W$53</c:f>
              <c:numCache>
                <c:formatCode>General</c:formatCode>
                <c:ptCount val="52"/>
                <c:pt idx="0">
                  <c:v>0</c:v>
                </c:pt>
                <c:pt idx="1">
                  <c:v>0.18079000000000001</c:v>
                </c:pt>
                <c:pt idx="2">
                  <c:v>0.30869000000000002</c:v>
                </c:pt>
                <c:pt idx="3">
                  <c:v>0.35061999999999999</c:v>
                </c:pt>
                <c:pt idx="4">
                  <c:v>0.37302000000000002</c:v>
                </c:pt>
                <c:pt idx="5">
                  <c:v>0.37098999999999999</c:v>
                </c:pt>
                <c:pt idx="6">
                  <c:v>0.40865000000000001</c:v>
                </c:pt>
                <c:pt idx="7">
                  <c:v>0.42496</c:v>
                </c:pt>
                <c:pt idx="8">
                  <c:v>0.45699000000000001</c:v>
                </c:pt>
                <c:pt idx="9">
                  <c:v>0.48144999999999999</c:v>
                </c:pt>
                <c:pt idx="10">
                  <c:v>0.49281999999999998</c:v>
                </c:pt>
                <c:pt idx="11">
                  <c:v>0.53188999999999997</c:v>
                </c:pt>
                <c:pt idx="12">
                  <c:v>0.57115000000000005</c:v>
                </c:pt>
                <c:pt idx="13">
                  <c:v>0.59736999999999996</c:v>
                </c:pt>
                <c:pt idx="14">
                  <c:v>0.62414000000000003</c:v>
                </c:pt>
                <c:pt idx="15">
                  <c:v>0.64664999999999995</c:v>
                </c:pt>
                <c:pt idx="16">
                  <c:v>0.71943000000000001</c:v>
                </c:pt>
                <c:pt idx="17">
                  <c:v>0.73019999999999996</c:v>
                </c:pt>
                <c:pt idx="18">
                  <c:v>0.75216000000000005</c:v>
                </c:pt>
                <c:pt idx="19">
                  <c:v>0.76041000000000003</c:v>
                </c:pt>
                <c:pt idx="20">
                  <c:v>0.80998999999999999</c:v>
                </c:pt>
                <c:pt idx="21">
                  <c:v>0.81927000000000005</c:v>
                </c:pt>
                <c:pt idx="22">
                  <c:v>0.83352000000000004</c:v>
                </c:pt>
                <c:pt idx="23">
                  <c:v>0.87902999999999998</c:v>
                </c:pt>
                <c:pt idx="24">
                  <c:v>0.82665999999999995</c:v>
                </c:pt>
                <c:pt idx="25">
                  <c:v>0.88604000000000005</c:v>
                </c:pt>
                <c:pt idx="26">
                  <c:v>0.89166999999999996</c:v>
                </c:pt>
                <c:pt idx="27">
                  <c:v>0.91146000000000005</c:v>
                </c:pt>
                <c:pt idx="28">
                  <c:v>0.92654999999999998</c:v>
                </c:pt>
                <c:pt idx="29">
                  <c:v>0.92369000000000001</c:v>
                </c:pt>
                <c:pt idx="30">
                  <c:v>0.96511999999999998</c:v>
                </c:pt>
                <c:pt idx="31">
                  <c:v>0.98170000000000002</c:v>
                </c:pt>
                <c:pt idx="32">
                  <c:v>1.0034099999999999</c:v>
                </c:pt>
                <c:pt idx="33">
                  <c:v>0.97675000000000001</c:v>
                </c:pt>
                <c:pt idx="34">
                  <c:v>0.99839999999999995</c:v>
                </c:pt>
                <c:pt idx="35">
                  <c:v>0.98931000000000002</c:v>
                </c:pt>
                <c:pt idx="36">
                  <c:v>1.0125500000000001</c:v>
                </c:pt>
                <c:pt idx="37">
                  <c:v>0.99811000000000005</c:v>
                </c:pt>
                <c:pt idx="38">
                  <c:v>1.0137400000000001</c:v>
                </c:pt>
                <c:pt idx="39">
                  <c:v>1.0551900000000001</c:v>
                </c:pt>
                <c:pt idx="40">
                  <c:v>1.0031099999999999</c:v>
                </c:pt>
                <c:pt idx="41">
                  <c:v>1.0482800000000001</c:v>
                </c:pt>
                <c:pt idx="42">
                  <c:v>1.06755</c:v>
                </c:pt>
                <c:pt idx="43">
                  <c:v>1.0939700000000001</c:v>
                </c:pt>
                <c:pt idx="44">
                  <c:v>1.0606100000000001</c:v>
                </c:pt>
                <c:pt idx="45">
                  <c:v>1.05338</c:v>
                </c:pt>
                <c:pt idx="46">
                  <c:v>1.0970200000000001</c:v>
                </c:pt>
                <c:pt idx="47">
                  <c:v>1.0921400000000001</c:v>
                </c:pt>
                <c:pt idx="48">
                  <c:v>1.14889</c:v>
                </c:pt>
                <c:pt idx="49">
                  <c:v>1.08361</c:v>
                </c:pt>
                <c:pt idx="50">
                  <c:v>1.0930500000000001</c:v>
                </c:pt>
                <c:pt idx="51">
                  <c:v>1.14765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0DA-8D43-893D-93FFA0023C71}"/>
            </c:ext>
          </c:extLst>
        </c:ser>
        <c:ser>
          <c:idx val="2"/>
          <c:order val="2"/>
          <c:tx>
            <c:v>Vesicles + K+ + Valinomycin</c:v>
          </c:tx>
          <c:spPr>
            <a:ln w="19050" cap="rnd">
              <a:solidFill>
                <a:srgbClr val="0432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432FF"/>
              </a:solidFill>
              <a:ln w="9525">
                <a:solidFill>
                  <a:srgbClr val="0432FF"/>
                </a:solidFill>
              </a:ln>
              <a:effectLst/>
            </c:spPr>
          </c:marker>
          <c:xVal>
            <c:numRef>
              <c:f>Sheet1!$U$2:$U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X$2:$X$53</c:f>
              <c:numCache>
                <c:formatCode>General</c:formatCode>
                <c:ptCount val="52"/>
                <c:pt idx="0">
                  <c:v>0</c:v>
                </c:pt>
                <c:pt idx="1">
                  <c:v>0.36185</c:v>
                </c:pt>
                <c:pt idx="2">
                  <c:v>0.54798000000000002</c:v>
                </c:pt>
                <c:pt idx="3">
                  <c:v>0.70508999999999999</c:v>
                </c:pt>
                <c:pt idx="4">
                  <c:v>0.82850000000000001</c:v>
                </c:pt>
                <c:pt idx="5">
                  <c:v>0.89280000000000004</c:v>
                </c:pt>
                <c:pt idx="6">
                  <c:v>0.96145000000000003</c:v>
                </c:pt>
                <c:pt idx="7">
                  <c:v>1.0662799999999999</c:v>
                </c:pt>
                <c:pt idx="8">
                  <c:v>1.0918000000000001</c:v>
                </c:pt>
                <c:pt idx="9">
                  <c:v>1.1636599999999999</c:v>
                </c:pt>
                <c:pt idx="10">
                  <c:v>1.2759799999999999</c:v>
                </c:pt>
                <c:pt idx="11">
                  <c:v>1.2947299999999999</c:v>
                </c:pt>
                <c:pt idx="12">
                  <c:v>1.3660099999999999</c:v>
                </c:pt>
                <c:pt idx="13">
                  <c:v>1.4166799999999999</c:v>
                </c:pt>
                <c:pt idx="14">
                  <c:v>1.51376</c:v>
                </c:pt>
                <c:pt idx="15">
                  <c:v>1.4644299999999999</c:v>
                </c:pt>
                <c:pt idx="16">
                  <c:v>1.63262</c:v>
                </c:pt>
                <c:pt idx="17">
                  <c:v>1.65777</c:v>
                </c:pt>
                <c:pt idx="18">
                  <c:v>1.5284800000000001</c:v>
                </c:pt>
                <c:pt idx="19">
                  <c:v>1.69075</c:v>
                </c:pt>
                <c:pt idx="20">
                  <c:v>1.7920499999999999</c:v>
                </c:pt>
                <c:pt idx="21">
                  <c:v>1.82023</c:v>
                </c:pt>
                <c:pt idx="22">
                  <c:v>1.78653</c:v>
                </c:pt>
                <c:pt idx="23">
                  <c:v>1.8402499999999999</c:v>
                </c:pt>
                <c:pt idx="24">
                  <c:v>1.8402499999999999</c:v>
                </c:pt>
                <c:pt idx="25">
                  <c:v>1.84426</c:v>
                </c:pt>
                <c:pt idx="26">
                  <c:v>1.92127</c:v>
                </c:pt>
                <c:pt idx="27">
                  <c:v>1.91262</c:v>
                </c:pt>
                <c:pt idx="28">
                  <c:v>2.0245899999999999</c:v>
                </c:pt>
                <c:pt idx="29">
                  <c:v>1.9196200000000001</c:v>
                </c:pt>
                <c:pt idx="30">
                  <c:v>1.94157</c:v>
                </c:pt>
                <c:pt idx="31">
                  <c:v>2.001609999999999</c:v>
                </c:pt>
                <c:pt idx="32">
                  <c:v>2.0318700000000001</c:v>
                </c:pt>
                <c:pt idx="33">
                  <c:v>1.9641</c:v>
                </c:pt>
                <c:pt idx="34">
                  <c:v>1.99525</c:v>
                </c:pt>
                <c:pt idx="35">
                  <c:v>1.97417</c:v>
                </c:pt>
                <c:pt idx="36">
                  <c:v>2.04345</c:v>
                </c:pt>
                <c:pt idx="37">
                  <c:v>1.9603299999999999</c:v>
                </c:pt>
                <c:pt idx="38">
                  <c:v>2.0233099999999999</c:v>
                </c:pt>
                <c:pt idx="39">
                  <c:v>2.039159999999999</c:v>
                </c:pt>
                <c:pt idx="40">
                  <c:v>1.98427</c:v>
                </c:pt>
                <c:pt idx="41">
                  <c:v>2.0075500000000002</c:v>
                </c:pt>
                <c:pt idx="42">
                  <c:v>2.0152100000000002</c:v>
                </c:pt>
                <c:pt idx="43">
                  <c:v>1.99949</c:v>
                </c:pt>
                <c:pt idx="44">
                  <c:v>1.94157</c:v>
                </c:pt>
                <c:pt idx="45">
                  <c:v>2.0318700000000001</c:v>
                </c:pt>
                <c:pt idx="46">
                  <c:v>2.0293000000000001</c:v>
                </c:pt>
                <c:pt idx="47">
                  <c:v>1.9867999999999999</c:v>
                </c:pt>
                <c:pt idx="48">
                  <c:v>2.059839999999999</c:v>
                </c:pt>
                <c:pt idx="49">
                  <c:v>2.0028800000000002</c:v>
                </c:pt>
                <c:pt idx="50">
                  <c:v>2.14533</c:v>
                </c:pt>
                <c:pt idx="51">
                  <c:v>2.0672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70DA-8D43-893D-93FFA0023C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93239328"/>
        <c:axId val="1192852256"/>
      </c:scatterChart>
      <c:valAx>
        <c:axId val="1193239328"/>
        <c:scaling>
          <c:orientation val="minMax"/>
          <c:max val="10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92852256"/>
        <c:crosses val="autoZero"/>
        <c:crossBetween val="midCat"/>
        <c:majorUnit val="20"/>
      </c:valAx>
      <c:valAx>
        <c:axId val="1192852256"/>
        <c:scaling>
          <c:orientation val="minMax"/>
          <c:max val="2.5"/>
          <c:min val="-0.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93239328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564233420549899"/>
          <c:y val="2.54283318751823E-2"/>
          <c:w val="0.75707345006717097"/>
          <c:h val="0.81063283756197102"/>
        </c:manualLayout>
      </c:layout>
      <c:scatterChart>
        <c:scatterStyle val="smoothMarker"/>
        <c:varyColors val="0"/>
        <c:ser>
          <c:idx val="0"/>
          <c:order val="0"/>
          <c:tx>
            <c:v>OA/DOPC (1:1)</c:v>
          </c:tx>
          <c:spPr>
            <a:ln w="19050" cap="rnd">
              <a:solidFill>
                <a:srgbClr val="0432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432FF"/>
              </a:solidFill>
              <a:ln w="9525">
                <a:solidFill>
                  <a:srgbClr val="0432FF"/>
                </a:solidFill>
              </a:ln>
              <a:effectLst/>
            </c:spPr>
          </c:marker>
          <c:xVal>
            <c:numRef>
              <c:f>Sheet1!$A$2:$A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C$2:$C$53</c:f>
              <c:numCache>
                <c:formatCode>General</c:formatCode>
                <c:ptCount val="52"/>
                <c:pt idx="0">
                  <c:v>0</c:v>
                </c:pt>
                <c:pt idx="1">
                  <c:v>0.23971000000000001</c:v>
                </c:pt>
                <c:pt idx="2">
                  <c:v>0.38751999999999998</c:v>
                </c:pt>
                <c:pt idx="3">
                  <c:v>0.48247000000000001</c:v>
                </c:pt>
                <c:pt idx="4">
                  <c:v>0.54108000000000001</c:v>
                </c:pt>
                <c:pt idx="5">
                  <c:v>0.60936000000000001</c:v>
                </c:pt>
                <c:pt idx="6">
                  <c:v>0.67695000000000005</c:v>
                </c:pt>
                <c:pt idx="7">
                  <c:v>0.73372000000000004</c:v>
                </c:pt>
                <c:pt idx="8">
                  <c:v>0.77339000000000002</c:v>
                </c:pt>
                <c:pt idx="9">
                  <c:v>0.79564999999999997</c:v>
                </c:pt>
                <c:pt idx="10">
                  <c:v>0.79937000000000002</c:v>
                </c:pt>
                <c:pt idx="11">
                  <c:v>0.77886</c:v>
                </c:pt>
                <c:pt idx="12">
                  <c:v>0.75085999999999997</c:v>
                </c:pt>
                <c:pt idx="13">
                  <c:v>0.77524000000000004</c:v>
                </c:pt>
                <c:pt idx="14">
                  <c:v>0.80825999999999998</c:v>
                </c:pt>
                <c:pt idx="15">
                  <c:v>0.77173999999999998</c:v>
                </c:pt>
                <c:pt idx="16">
                  <c:v>0.80564000000000002</c:v>
                </c:pt>
                <c:pt idx="17">
                  <c:v>0.81774000000000002</c:v>
                </c:pt>
                <c:pt idx="18">
                  <c:v>0.86851999999999996</c:v>
                </c:pt>
                <c:pt idx="19">
                  <c:v>0.84521000000000002</c:v>
                </c:pt>
                <c:pt idx="20">
                  <c:v>0.88780999999999999</c:v>
                </c:pt>
                <c:pt idx="21">
                  <c:v>0.89134999999999998</c:v>
                </c:pt>
                <c:pt idx="22">
                  <c:v>0.90303999999999995</c:v>
                </c:pt>
                <c:pt idx="23">
                  <c:v>0.87990999999999997</c:v>
                </c:pt>
                <c:pt idx="24">
                  <c:v>0.89637999999999995</c:v>
                </c:pt>
                <c:pt idx="25">
                  <c:v>0.89676999999999996</c:v>
                </c:pt>
                <c:pt idx="26">
                  <c:v>0.88754999999999995</c:v>
                </c:pt>
                <c:pt idx="27">
                  <c:v>0.86572000000000005</c:v>
                </c:pt>
                <c:pt idx="28">
                  <c:v>0.89244999999999997</c:v>
                </c:pt>
                <c:pt idx="29">
                  <c:v>0.91042999999999996</c:v>
                </c:pt>
                <c:pt idx="30">
                  <c:v>0.87043999999999999</c:v>
                </c:pt>
                <c:pt idx="31">
                  <c:v>0.90744999999999998</c:v>
                </c:pt>
                <c:pt idx="32">
                  <c:v>0.90959000000000001</c:v>
                </c:pt>
                <c:pt idx="33">
                  <c:v>0.88826000000000005</c:v>
                </c:pt>
                <c:pt idx="34">
                  <c:v>0.88349999999999995</c:v>
                </c:pt>
                <c:pt idx="35">
                  <c:v>0.89032</c:v>
                </c:pt>
                <c:pt idx="36">
                  <c:v>0.88556000000000001</c:v>
                </c:pt>
                <c:pt idx="37">
                  <c:v>0.89437999999999995</c:v>
                </c:pt>
                <c:pt idx="38">
                  <c:v>0.93064000000000002</c:v>
                </c:pt>
                <c:pt idx="39">
                  <c:v>0.87612999999999996</c:v>
                </c:pt>
                <c:pt idx="40">
                  <c:v>0.87363000000000002</c:v>
                </c:pt>
                <c:pt idx="41">
                  <c:v>0.88588</c:v>
                </c:pt>
                <c:pt idx="42">
                  <c:v>0.89522000000000002</c:v>
                </c:pt>
                <c:pt idx="43">
                  <c:v>0.89463999999999999</c:v>
                </c:pt>
                <c:pt idx="44">
                  <c:v>0.90400999999999998</c:v>
                </c:pt>
                <c:pt idx="45">
                  <c:v>0.86839999999999995</c:v>
                </c:pt>
                <c:pt idx="46">
                  <c:v>0.92888000000000004</c:v>
                </c:pt>
                <c:pt idx="47">
                  <c:v>0.87236000000000002</c:v>
                </c:pt>
                <c:pt idx="48">
                  <c:v>0.89458000000000004</c:v>
                </c:pt>
                <c:pt idx="49">
                  <c:v>0.88704000000000005</c:v>
                </c:pt>
                <c:pt idx="50">
                  <c:v>0.87714999999999999</c:v>
                </c:pt>
                <c:pt idx="51">
                  <c:v>0.8838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0F0-9048-8073-342F75896DB3}"/>
            </c:ext>
          </c:extLst>
        </c:ser>
        <c:ser>
          <c:idx val="1"/>
          <c:order val="1"/>
          <c:tx>
            <c:v>OA/DOPC (1:5)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heet1!$L$2:$L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N$2:$N$53</c:f>
              <c:numCache>
                <c:formatCode>General</c:formatCode>
                <c:ptCount val="52"/>
                <c:pt idx="0">
                  <c:v>0</c:v>
                </c:pt>
                <c:pt idx="1">
                  <c:v>0.15114</c:v>
                </c:pt>
                <c:pt idx="2">
                  <c:v>0.19084999999999999</c:v>
                </c:pt>
                <c:pt idx="3">
                  <c:v>0.22592999999999999</c:v>
                </c:pt>
                <c:pt idx="4">
                  <c:v>0.24709</c:v>
                </c:pt>
                <c:pt idx="5">
                  <c:v>0.26501000000000002</c:v>
                </c:pt>
                <c:pt idx="6">
                  <c:v>0.26811000000000001</c:v>
                </c:pt>
                <c:pt idx="7">
                  <c:v>0.27788000000000002</c:v>
                </c:pt>
                <c:pt idx="8">
                  <c:v>0.28393000000000002</c:v>
                </c:pt>
                <c:pt idx="9">
                  <c:v>0.29207</c:v>
                </c:pt>
                <c:pt idx="10">
                  <c:v>0.29622999999999999</c:v>
                </c:pt>
                <c:pt idx="11">
                  <c:v>0.32185999999999998</c:v>
                </c:pt>
                <c:pt idx="12">
                  <c:v>0.33029999999999998</c:v>
                </c:pt>
                <c:pt idx="13">
                  <c:v>0.34826000000000001</c:v>
                </c:pt>
                <c:pt idx="14">
                  <c:v>0.36620999999999998</c:v>
                </c:pt>
                <c:pt idx="15">
                  <c:v>0.36160999999999999</c:v>
                </c:pt>
                <c:pt idx="16">
                  <c:v>0.40765000000000001</c:v>
                </c:pt>
                <c:pt idx="17">
                  <c:v>0.42909999999999998</c:v>
                </c:pt>
                <c:pt idx="18">
                  <c:v>0.43479000000000001</c:v>
                </c:pt>
                <c:pt idx="19">
                  <c:v>0.4541</c:v>
                </c:pt>
                <c:pt idx="20">
                  <c:v>0.45906000000000002</c:v>
                </c:pt>
                <c:pt idx="21">
                  <c:v>0.48902000000000001</c:v>
                </c:pt>
                <c:pt idx="22">
                  <c:v>0.49242999999999998</c:v>
                </c:pt>
                <c:pt idx="23">
                  <c:v>0.51175999999999999</c:v>
                </c:pt>
                <c:pt idx="24">
                  <c:v>0.53713</c:v>
                </c:pt>
                <c:pt idx="25">
                  <c:v>0.53034999999999999</c:v>
                </c:pt>
                <c:pt idx="26">
                  <c:v>0.55042999999999997</c:v>
                </c:pt>
                <c:pt idx="27">
                  <c:v>0.56313000000000002</c:v>
                </c:pt>
                <c:pt idx="28">
                  <c:v>0.53978999999999999</c:v>
                </c:pt>
                <c:pt idx="29">
                  <c:v>0.56715000000000004</c:v>
                </c:pt>
                <c:pt idx="30">
                  <c:v>0.56211999999999995</c:v>
                </c:pt>
                <c:pt idx="31">
                  <c:v>0.57093000000000005</c:v>
                </c:pt>
                <c:pt idx="32">
                  <c:v>0.59145000000000003</c:v>
                </c:pt>
                <c:pt idx="33">
                  <c:v>0.58298000000000005</c:v>
                </c:pt>
                <c:pt idx="34">
                  <c:v>0.57033999999999996</c:v>
                </c:pt>
                <c:pt idx="35">
                  <c:v>0.60089000000000004</c:v>
                </c:pt>
                <c:pt idx="36">
                  <c:v>0.61550000000000005</c:v>
                </c:pt>
                <c:pt idx="37">
                  <c:v>0.61909999999999998</c:v>
                </c:pt>
                <c:pt idx="38">
                  <c:v>0.60668999999999995</c:v>
                </c:pt>
                <c:pt idx="39">
                  <c:v>0.62278999999999995</c:v>
                </c:pt>
                <c:pt idx="40">
                  <c:v>0.63055000000000005</c:v>
                </c:pt>
                <c:pt idx="41">
                  <c:v>0.64464999999999995</c:v>
                </c:pt>
                <c:pt idx="42">
                  <c:v>0.65691999999999995</c:v>
                </c:pt>
                <c:pt idx="43">
                  <c:v>0.62787000000000004</c:v>
                </c:pt>
                <c:pt idx="44">
                  <c:v>0.65988999999999998</c:v>
                </c:pt>
                <c:pt idx="45">
                  <c:v>0.64681999999999995</c:v>
                </c:pt>
                <c:pt idx="46">
                  <c:v>0.63693999999999995</c:v>
                </c:pt>
                <c:pt idx="47">
                  <c:v>0.66742000000000001</c:v>
                </c:pt>
                <c:pt idx="48">
                  <c:v>0.66356000000000004</c:v>
                </c:pt>
                <c:pt idx="49">
                  <c:v>0.67742999999999998</c:v>
                </c:pt>
                <c:pt idx="50">
                  <c:v>0.67796000000000001</c:v>
                </c:pt>
                <c:pt idx="51">
                  <c:v>0.678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0F0-9048-8073-342F75896DB3}"/>
            </c:ext>
          </c:extLst>
        </c:ser>
        <c:ser>
          <c:idx val="2"/>
          <c:order val="2"/>
          <c:tx>
            <c:v>OA/DOPC (1:10)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Sheet1!$X$2:$X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Z$2:$Z$53</c:f>
              <c:numCache>
                <c:formatCode>General</c:formatCode>
                <c:ptCount val="52"/>
                <c:pt idx="0">
                  <c:v>0</c:v>
                </c:pt>
                <c:pt idx="1">
                  <c:v>0.18079000000000001</c:v>
                </c:pt>
                <c:pt idx="2">
                  <c:v>0.30869000000000002</c:v>
                </c:pt>
                <c:pt idx="3">
                  <c:v>0.35061999999999999</c:v>
                </c:pt>
                <c:pt idx="4">
                  <c:v>0.37302000000000002</c:v>
                </c:pt>
                <c:pt idx="5">
                  <c:v>0.37098999999999999</c:v>
                </c:pt>
                <c:pt idx="6">
                  <c:v>0.40865000000000001</c:v>
                </c:pt>
                <c:pt idx="7">
                  <c:v>0.42496</c:v>
                </c:pt>
                <c:pt idx="8">
                  <c:v>0.45699000000000001</c:v>
                </c:pt>
                <c:pt idx="9">
                  <c:v>0.48144999999999999</c:v>
                </c:pt>
                <c:pt idx="10">
                  <c:v>0.49281999999999998</c:v>
                </c:pt>
                <c:pt idx="11">
                  <c:v>0.53188999999999997</c:v>
                </c:pt>
                <c:pt idx="12">
                  <c:v>0.57115000000000005</c:v>
                </c:pt>
                <c:pt idx="13">
                  <c:v>0.59736999999999996</c:v>
                </c:pt>
                <c:pt idx="14">
                  <c:v>0.62414000000000003</c:v>
                </c:pt>
                <c:pt idx="15">
                  <c:v>0.64664999999999995</c:v>
                </c:pt>
                <c:pt idx="16">
                  <c:v>0.71943000000000001</c:v>
                </c:pt>
                <c:pt idx="17">
                  <c:v>0.73019999999999996</c:v>
                </c:pt>
                <c:pt idx="18">
                  <c:v>0.75216000000000005</c:v>
                </c:pt>
                <c:pt idx="19">
                  <c:v>0.76041000000000003</c:v>
                </c:pt>
                <c:pt idx="20">
                  <c:v>0.80998999999999999</c:v>
                </c:pt>
                <c:pt idx="21">
                  <c:v>0.81927000000000005</c:v>
                </c:pt>
                <c:pt idx="22">
                  <c:v>0.83352000000000004</c:v>
                </c:pt>
                <c:pt idx="23">
                  <c:v>0.87902999999999998</c:v>
                </c:pt>
                <c:pt idx="24">
                  <c:v>0.82665999999999995</c:v>
                </c:pt>
                <c:pt idx="25">
                  <c:v>0.88604000000000005</c:v>
                </c:pt>
                <c:pt idx="26">
                  <c:v>0.89166999999999996</c:v>
                </c:pt>
                <c:pt idx="27">
                  <c:v>0.91146000000000005</c:v>
                </c:pt>
                <c:pt idx="28">
                  <c:v>0.92654999999999998</c:v>
                </c:pt>
                <c:pt idx="29">
                  <c:v>0.92369000000000001</c:v>
                </c:pt>
                <c:pt idx="30">
                  <c:v>0.96511999999999998</c:v>
                </c:pt>
                <c:pt idx="31">
                  <c:v>0.98170000000000002</c:v>
                </c:pt>
                <c:pt idx="32">
                  <c:v>1.0034099999999999</c:v>
                </c:pt>
                <c:pt idx="33">
                  <c:v>0.97675000000000001</c:v>
                </c:pt>
                <c:pt idx="34">
                  <c:v>0.99839999999999995</c:v>
                </c:pt>
                <c:pt idx="35">
                  <c:v>0.98931000000000002</c:v>
                </c:pt>
                <c:pt idx="36">
                  <c:v>1.0125500000000001</c:v>
                </c:pt>
                <c:pt idx="37">
                  <c:v>0.99811000000000005</c:v>
                </c:pt>
                <c:pt idx="38">
                  <c:v>1.0137400000000001</c:v>
                </c:pt>
                <c:pt idx="39">
                  <c:v>1.0551900000000001</c:v>
                </c:pt>
                <c:pt idx="40">
                  <c:v>1.0031099999999999</c:v>
                </c:pt>
                <c:pt idx="41">
                  <c:v>1.0482800000000001</c:v>
                </c:pt>
                <c:pt idx="42">
                  <c:v>1.06755</c:v>
                </c:pt>
                <c:pt idx="43">
                  <c:v>1.0939700000000001</c:v>
                </c:pt>
                <c:pt idx="44">
                  <c:v>1.0606100000000001</c:v>
                </c:pt>
                <c:pt idx="45">
                  <c:v>1.05338</c:v>
                </c:pt>
                <c:pt idx="46">
                  <c:v>1.0970200000000001</c:v>
                </c:pt>
                <c:pt idx="47">
                  <c:v>1.0921400000000001</c:v>
                </c:pt>
                <c:pt idx="48">
                  <c:v>1.14889</c:v>
                </c:pt>
                <c:pt idx="49">
                  <c:v>1.08361</c:v>
                </c:pt>
                <c:pt idx="50">
                  <c:v>1.0930500000000001</c:v>
                </c:pt>
                <c:pt idx="51">
                  <c:v>1.14765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E0F0-9048-8073-342F75896D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93246896"/>
        <c:axId val="1193248256"/>
      </c:scatterChart>
      <c:valAx>
        <c:axId val="1193246896"/>
        <c:scaling>
          <c:orientation val="minMax"/>
          <c:max val="100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93248256"/>
        <c:crosses val="autoZero"/>
        <c:crossBetween val="midCat"/>
        <c:majorUnit val="20"/>
      </c:valAx>
      <c:valAx>
        <c:axId val="1193248256"/>
        <c:scaling>
          <c:orientation val="minMax"/>
          <c:max val="1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[K</a:t>
                </a:r>
                <a:r>
                  <a:rPr lang="en-US" b="1" baseline="30000"/>
                  <a:t>+</a:t>
                </a:r>
                <a:r>
                  <a:rPr lang="en-US" b="1"/>
                  <a:t>] mM</a:t>
                </a:r>
              </a:p>
            </c:rich>
          </c:tx>
          <c:layout>
            <c:manualLayout>
              <c:xMode val="edge"/>
              <c:yMode val="edge"/>
              <c:x val="1.3873254999066401E-2"/>
              <c:y val="0.38760580499606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9324689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48597198287941801"/>
          <c:y val="0.61429316127150801"/>
          <c:w val="0.46388901681605599"/>
          <c:h val="0.1556729367162439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  <a:latin typeface="+mn-lt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940204569748601"/>
          <c:y val="3.8927507166570299E-2"/>
          <c:w val="0.76379240152039696"/>
          <c:h val="0.81063283756197102"/>
        </c:manualLayout>
      </c:layout>
      <c:scatterChart>
        <c:scatterStyle val="smoothMarker"/>
        <c:varyColors val="0"/>
        <c:ser>
          <c:idx val="0"/>
          <c:order val="0"/>
          <c:tx>
            <c:v>OA/DOPC (1:1)</c:v>
          </c:tx>
          <c:spPr>
            <a:ln w="19050" cap="rnd">
              <a:solidFill>
                <a:srgbClr val="0432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432FF"/>
              </a:solidFill>
              <a:ln w="9525">
                <a:solidFill>
                  <a:srgbClr val="0432FF"/>
                </a:solidFill>
              </a:ln>
              <a:effectLst/>
            </c:spPr>
          </c:marker>
          <c:xVal>
            <c:numRef>
              <c:f>Sheet1!$A$2:$A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D$2:$D$53</c:f>
              <c:numCache>
                <c:formatCode>General</c:formatCode>
                <c:ptCount val="52"/>
                <c:pt idx="0">
                  <c:v>0</c:v>
                </c:pt>
                <c:pt idx="1">
                  <c:v>0.22927</c:v>
                </c:pt>
                <c:pt idx="2">
                  <c:v>0.44120999999999999</c:v>
                </c:pt>
                <c:pt idx="3">
                  <c:v>0.59050999999999998</c:v>
                </c:pt>
                <c:pt idx="4">
                  <c:v>0.63836000000000004</c:v>
                </c:pt>
                <c:pt idx="5">
                  <c:v>0.73248000000000002</c:v>
                </c:pt>
                <c:pt idx="6">
                  <c:v>0.73202</c:v>
                </c:pt>
                <c:pt idx="7">
                  <c:v>0.75546999999999997</c:v>
                </c:pt>
                <c:pt idx="8">
                  <c:v>0.79171999999999998</c:v>
                </c:pt>
                <c:pt idx="9">
                  <c:v>0.83601000000000003</c:v>
                </c:pt>
                <c:pt idx="10">
                  <c:v>0.92898999999999998</c:v>
                </c:pt>
                <c:pt idx="11">
                  <c:v>0.98146</c:v>
                </c:pt>
                <c:pt idx="12">
                  <c:v>0.93901000000000001</c:v>
                </c:pt>
                <c:pt idx="13">
                  <c:v>0.88832999999999995</c:v>
                </c:pt>
                <c:pt idx="14">
                  <c:v>0.84845999999999999</c:v>
                </c:pt>
                <c:pt idx="15">
                  <c:v>0.84601000000000004</c:v>
                </c:pt>
                <c:pt idx="16">
                  <c:v>0.91569</c:v>
                </c:pt>
                <c:pt idx="17">
                  <c:v>0.91476999999999997</c:v>
                </c:pt>
                <c:pt idx="18">
                  <c:v>0.91225000000000001</c:v>
                </c:pt>
                <c:pt idx="19">
                  <c:v>0.90839000000000003</c:v>
                </c:pt>
                <c:pt idx="20">
                  <c:v>0.92806</c:v>
                </c:pt>
                <c:pt idx="21">
                  <c:v>0.93764000000000003</c:v>
                </c:pt>
                <c:pt idx="22">
                  <c:v>0.97001000000000004</c:v>
                </c:pt>
                <c:pt idx="23">
                  <c:v>0.96223999999999998</c:v>
                </c:pt>
                <c:pt idx="24">
                  <c:v>0.95867000000000002</c:v>
                </c:pt>
                <c:pt idx="25">
                  <c:v>0.92190000000000005</c:v>
                </c:pt>
                <c:pt idx="26">
                  <c:v>0.95130999999999999</c:v>
                </c:pt>
                <c:pt idx="27">
                  <c:v>0.91617999999999999</c:v>
                </c:pt>
                <c:pt idx="28">
                  <c:v>0.94806999999999997</c:v>
                </c:pt>
                <c:pt idx="29">
                  <c:v>0.97441</c:v>
                </c:pt>
                <c:pt idx="30">
                  <c:v>0.93906999999999996</c:v>
                </c:pt>
                <c:pt idx="31">
                  <c:v>0.95579999999999998</c:v>
                </c:pt>
                <c:pt idx="32">
                  <c:v>0.96780999999999995</c:v>
                </c:pt>
                <c:pt idx="33">
                  <c:v>0.95648999999999995</c:v>
                </c:pt>
                <c:pt idx="34">
                  <c:v>0.95699000000000001</c:v>
                </c:pt>
                <c:pt idx="35">
                  <c:v>0.94801000000000002</c:v>
                </c:pt>
                <c:pt idx="36">
                  <c:v>0.98536999999999997</c:v>
                </c:pt>
                <c:pt idx="37">
                  <c:v>0.94272999999999996</c:v>
                </c:pt>
                <c:pt idx="38">
                  <c:v>0.91108999999999996</c:v>
                </c:pt>
                <c:pt idx="39">
                  <c:v>0.94906999999999997</c:v>
                </c:pt>
                <c:pt idx="40">
                  <c:v>0.91005000000000003</c:v>
                </c:pt>
                <c:pt idx="41">
                  <c:v>0.92405000000000004</c:v>
                </c:pt>
                <c:pt idx="42">
                  <c:v>0.92566000000000004</c:v>
                </c:pt>
                <c:pt idx="43">
                  <c:v>0.90368000000000004</c:v>
                </c:pt>
                <c:pt idx="44">
                  <c:v>0.93059000000000003</c:v>
                </c:pt>
                <c:pt idx="45">
                  <c:v>0.91108999999999996</c:v>
                </c:pt>
                <c:pt idx="46">
                  <c:v>0.94198999999999999</c:v>
                </c:pt>
                <c:pt idx="47">
                  <c:v>0.96392999999999995</c:v>
                </c:pt>
                <c:pt idx="48">
                  <c:v>0.91747000000000001</c:v>
                </c:pt>
                <c:pt idx="49">
                  <c:v>0.93213999999999997</c:v>
                </c:pt>
                <c:pt idx="50">
                  <c:v>0.90844999999999998</c:v>
                </c:pt>
                <c:pt idx="51">
                  <c:v>0.9394400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19B5-FD43-AB5D-1FCE1EC093FA}"/>
            </c:ext>
          </c:extLst>
        </c:ser>
        <c:ser>
          <c:idx val="1"/>
          <c:order val="1"/>
          <c:tx>
            <c:v>OA/DOPC (1:5)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heet1!$L$2:$L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O$2:$O$53</c:f>
              <c:numCache>
                <c:formatCode>General</c:formatCode>
                <c:ptCount val="52"/>
                <c:pt idx="0">
                  <c:v>0</c:v>
                </c:pt>
                <c:pt idx="1">
                  <c:v>0.31634000000000001</c:v>
                </c:pt>
                <c:pt idx="2">
                  <c:v>0.41826999999999998</c:v>
                </c:pt>
                <c:pt idx="3">
                  <c:v>0.4677</c:v>
                </c:pt>
                <c:pt idx="4">
                  <c:v>0.52324000000000004</c:v>
                </c:pt>
                <c:pt idx="5">
                  <c:v>0.55733999999999995</c:v>
                </c:pt>
                <c:pt idx="6">
                  <c:v>0.59711999999999998</c:v>
                </c:pt>
                <c:pt idx="7">
                  <c:v>0.63848000000000005</c:v>
                </c:pt>
                <c:pt idx="8">
                  <c:v>0.64563000000000004</c:v>
                </c:pt>
                <c:pt idx="9">
                  <c:v>0.66756000000000004</c:v>
                </c:pt>
                <c:pt idx="10">
                  <c:v>0.69535999999999998</c:v>
                </c:pt>
                <c:pt idx="11">
                  <c:v>0.71914</c:v>
                </c:pt>
                <c:pt idx="12">
                  <c:v>0.72533999999999998</c:v>
                </c:pt>
                <c:pt idx="13">
                  <c:v>0.76283999999999996</c:v>
                </c:pt>
                <c:pt idx="14">
                  <c:v>0.78039000000000003</c:v>
                </c:pt>
                <c:pt idx="15">
                  <c:v>0.75083</c:v>
                </c:pt>
                <c:pt idx="16">
                  <c:v>0.82328999999999997</c:v>
                </c:pt>
                <c:pt idx="17">
                  <c:v>0.78969</c:v>
                </c:pt>
                <c:pt idx="18">
                  <c:v>0.76378000000000001</c:v>
                </c:pt>
                <c:pt idx="19">
                  <c:v>0.74541000000000002</c:v>
                </c:pt>
                <c:pt idx="20">
                  <c:v>0.88371999999999995</c:v>
                </c:pt>
                <c:pt idx="21">
                  <c:v>0.89829999999999999</c:v>
                </c:pt>
                <c:pt idx="22">
                  <c:v>0.87749999999999995</c:v>
                </c:pt>
                <c:pt idx="23">
                  <c:v>0.89631000000000005</c:v>
                </c:pt>
                <c:pt idx="24">
                  <c:v>0.90815999999999997</c:v>
                </c:pt>
                <c:pt idx="25">
                  <c:v>0.98038999999999998</c:v>
                </c:pt>
                <c:pt idx="26">
                  <c:v>0.96399000000000001</c:v>
                </c:pt>
                <c:pt idx="27">
                  <c:v>1.02121</c:v>
                </c:pt>
                <c:pt idx="28">
                  <c:v>1.03043</c:v>
                </c:pt>
                <c:pt idx="29">
                  <c:v>1.0463100000000001</c:v>
                </c:pt>
                <c:pt idx="30">
                  <c:v>1.0629299999999999</c:v>
                </c:pt>
                <c:pt idx="31">
                  <c:v>1.0416700000000001</c:v>
                </c:pt>
                <c:pt idx="32">
                  <c:v>1.07304</c:v>
                </c:pt>
                <c:pt idx="33">
                  <c:v>1.06952</c:v>
                </c:pt>
                <c:pt idx="34">
                  <c:v>1.08941</c:v>
                </c:pt>
                <c:pt idx="35">
                  <c:v>1.0990899999999999</c:v>
                </c:pt>
                <c:pt idx="36">
                  <c:v>1.0749599999999999</c:v>
                </c:pt>
                <c:pt idx="37">
                  <c:v>1.08748</c:v>
                </c:pt>
                <c:pt idx="38">
                  <c:v>1.1293200000000001</c:v>
                </c:pt>
                <c:pt idx="39">
                  <c:v>1.1016699999999999</c:v>
                </c:pt>
                <c:pt idx="40">
                  <c:v>1.13259</c:v>
                </c:pt>
                <c:pt idx="41">
                  <c:v>1.1519900000000001</c:v>
                </c:pt>
                <c:pt idx="42">
                  <c:v>1.11649</c:v>
                </c:pt>
                <c:pt idx="43">
                  <c:v>1.0941399999999999</c:v>
                </c:pt>
                <c:pt idx="44">
                  <c:v>1.13828</c:v>
                </c:pt>
                <c:pt idx="45">
                  <c:v>1.18876</c:v>
                </c:pt>
                <c:pt idx="46">
                  <c:v>1.1766300000000001</c:v>
                </c:pt>
                <c:pt idx="47">
                  <c:v>1.1498999999999999</c:v>
                </c:pt>
                <c:pt idx="48">
                  <c:v>1.1471499999999999</c:v>
                </c:pt>
                <c:pt idx="49">
                  <c:v>1.1515500000000001</c:v>
                </c:pt>
                <c:pt idx="50">
                  <c:v>1.1660999999999999</c:v>
                </c:pt>
                <c:pt idx="51">
                  <c:v>1.141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19B5-FD43-AB5D-1FCE1EC093FA}"/>
            </c:ext>
          </c:extLst>
        </c:ser>
        <c:ser>
          <c:idx val="2"/>
          <c:order val="2"/>
          <c:tx>
            <c:v>OA/DOPC (1:10)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Sheet1!$X$2:$X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AA$2:$AA$53</c:f>
              <c:numCache>
                <c:formatCode>General</c:formatCode>
                <c:ptCount val="52"/>
                <c:pt idx="0">
                  <c:v>0</c:v>
                </c:pt>
                <c:pt idx="1">
                  <c:v>0.36185</c:v>
                </c:pt>
                <c:pt idx="2">
                  <c:v>0.54798000000000002</c:v>
                </c:pt>
                <c:pt idx="3">
                  <c:v>0.70508999999999999</c:v>
                </c:pt>
                <c:pt idx="4">
                  <c:v>0.82850000000000001</c:v>
                </c:pt>
                <c:pt idx="5">
                  <c:v>0.89280000000000004</c:v>
                </c:pt>
                <c:pt idx="6">
                  <c:v>0.96145000000000003</c:v>
                </c:pt>
                <c:pt idx="7">
                  <c:v>1.0662799999999999</c:v>
                </c:pt>
                <c:pt idx="8">
                  <c:v>1.0918000000000001</c:v>
                </c:pt>
                <c:pt idx="9">
                  <c:v>1.1636599999999999</c:v>
                </c:pt>
                <c:pt idx="10">
                  <c:v>1.2759799999999999</c:v>
                </c:pt>
                <c:pt idx="11">
                  <c:v>1.2947299999999999</c:v>
                </c:pt>
                <c:pt idx="12">
                  <c:v>1.3660099999999999</c:v>
                </c:pt>
                <c:pt idx="13">
                  <c:v>1.4166799999999999</c:v>
                </c:pt>
                <c:pt idx="14">
                  <c:v>1.51376</c:v>
                </c:pt>
                <c:pt idx="15">
                  <c:v>1.4644299999999999</c:v>
                </c:pt>
                <c:pt idx="16">
                  <c:v>1.63262</c:v>
                </c:pt>
                <c:pt idx="17">
                  <c:v>1.65777</c:v>
                </c:pt>
                <c:pt idx="18">
                  <c:v>1.5284800000000001</c:v>
                </c:pt>
                <c:pt idx="19">
                  <c:v>1.69075</c:v>
                </c:pt>
                <c:pt idx="20">
                  <c:v>1.7920499999999999</c:v>
                </c:pt>
                <c:pt idx="21">
                  <c:v>1.82023</c:v>
                </c:pt>
                <c:pt idx="22">
                  <c:v>1.78653</c:v>
                </c:pt>
                <c:pt idx="23">
                  <c:v>1.8402499999999999</c:v>
                </c:pt>
                <c:pt idx="24">
                  <c:v>1.8402499999999999</c:v>
                </c:pt>
                <c:pt idx="25">
                  <c:v>1.84426</c:v>
                </c:pt>
                <c:pt idx="26">
                  <c:v>1.92127</c:v>
                </c:pt>
                <c:pt idx="27">
                  <c:v>1.91262</c:v>
                </c:pt>
                <c:pt idx="28">
                  <c:v>2.0245899999999999</c:v>
                </c:pt>
                <c:pt idx="29">
                  <c:v>1.9196200000000001</c:v>
                </c:pt>
                <c:pt idx="30">
                  <c:v>1.94157</c:v>
                </c:pt>
                <c:pt idx="31">
                  <c:v>2.001609999999999</c:v>
                </c:pt>
                <c:pt idx="32">
                  <c:v>2.0318700000000001</c:v>
                </c:pt>
                <c:pt idx="33">
                  <c:v>1.9641</c:v>
                </c:pt>
                <c:pt idx="34">
                  <c:v>1.99525</c:v>
                </c:pt>
                <c:pt idx="35">
                  <c:v>1.97417</c:v>
                </c:pt>
                <c:pt idx="36">
                  <c:v>2.04345</c:v>
                </c:pt>
                <c:pt idx="37">
                  <c:v>1.9603299999999999</c:v>
                </c:pt>
                <c:pt idx="38">
                  <c:v>2.0233099999999999</c:v>
                </c:pt>
                <c:pt idx="39">
                  <c:v>2.039159999999999</c:v>
                </c:pt>
                <c:pt idx="40">
                  <c:v>1.98427</c:v>
                </c:pt>
                <c:pt idx="41">
                  <c:v>2.0075500000000002</c:v>
                </c:pt>
                <c:pt idx="42">
                  <c:v>2.0152100000000002</c:v>
                </c:pt>
                <c:pt idx="43">
                  <c:v>1.99949</c:v>
                </c:pt>
                <c:pt idx="44">
                  <c:v>1.94157</c:v>
                </c:pt>
                <c:pt idx="45">
                  <c:v>2.0318700000000001</c:v>
                </c:pt>
                <c:pt idx="46">
                  <c:v>2.0293000000000001</c:v>
                </c:pt>
                <c:pt idx="47">
                  <c:v>1.9867999999999999</c:v>
                </c:pt>
                <c:pt idx="48">
                  <c:v>2.059839999999999</c:v>
                </c:pt>
                <c:pt idx="49">
                  <c:v>2.0028800000000002</c:v>
                </c:pt>
                <c:pt idx="50">
                  <c:v>2.14533</c:v>
                </c:pt>
                <c:pt idx="51">
                  <c:v>2.0672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19B5-FD43-AB5D-1FCE1EC093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91232592"/>
        <c:axId val="1091220704"/>
      </c:scatterChart>
      <c:valAx>
        <c:axId val="1091232592"/>
        <c:scaling>
          <c:orientation val="minMax"/>
          <c:max val="100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1220704"/>
        <c:crosses val="autoZero"/>
        <c:crossBetween val="midCat"/>
        <c:majorUnit val="20"/>
      </c:valAx>
      <c:valAx>
        <c:axId val="1091220704"/>
        <c:scaling>
          <c:orientation val="minMax"/>
          <c:max val="2.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[K</a:t>
                </a:r>
                <a:r>
                  <a:rPr lang="en-US" b="1" baseline="30000"/>
                  <a:t>+</a:t>
                </a:r>
                <a:r>
                  <a:rPr lang="en-US" b="1"/>
                  <a:t>] mM +</a:t>
                </a:r>
                <a:r>
                  <a:rPr lang="en-US" b="1" baseline="0"/>
                  <a:t> I</a:t>
                </a:r>
                <a:r>
                  <a:rPr lang="en-US" b="1"/>
                  <a:t>onophore</a:t>
                </a:r>
              </a:p>
            </c:rich>
          </c:tx>
          <c:layout>
            <c:manualLayout>
              <c:xMode val="edge"/>
              <c:yMode val="edge"/>
              <c:x val="4.5749325035464201E-3"/>
              <c:y val="0.217833524064190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123259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38071294990327398"/>
          <c:y val="0.61429316127150801"/>
          <c:w val="0.569147941200563"/>
          <c:h val="0.191647215896001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  <a:latin typeface="+mn-lt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104793391210699"/>
          <c:y val="3.05139982502187E-2"/>
          <c:w val="0.77967856181438799"/>
          <c:h val="0.91381189851268596"/>
        </c:manualLayout>
      </c:layout>
      <c:scatterChart>
        <c:scatterStyle val="smoothMarker"/>
        <c:varyColors val="0"/>
        <c:ser>
          <c:idx val="0"/>
          <c:order val="0"/>
          <c:tx>
            <c:v>Vesicles</c:v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F$2:$F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G$2:$G$53</c:f>
              <c:numCache>
                <c:formatCode>General</c:formatCode>
                <c:ptCount val="52"/>
                <c:pt idx="0">
                  <c:v>0</c:v>
                </c:pt>
                <c:pt idx="1">
                  <c:v>-3.4270000000000002E-2</c:v>
                </c:pt>
                <c:pt idx="2">
                  <c:v>1.295E-2</c:v>
                </c:pt>
                <c:pt idx="3">
                  <c:v>-1.5469999999999999E-2</c:v>
                </c:pt>
                <c:pt idx="4">
                  <c:v>-4.6589999999999999E-2</c:v>
                </c:pt>
                <c:pt idx="5">
                  <c:v>2.3349999999999999E-2</c:v>
                </c:pt>
                <c:pt idx="6">
                  <c:v>-7.7400000000000004E-3</c:v>
                </c:pt>
                <c:pt idx="7">
                  <c:v>-5.8020000000000002E-2</c:v>
                </c:pt>
                <c:pt idx="8" formatCode="0.00E+00">
                  <c:v>-8.61468E-4</c:v>
                </c:pt>
                <c:pt idx="9">
                  <c:v>1.295E-2</c:v>
                </c:pt>
                <c:pt idx="10">
                  <c:v>-3.0859999999999999E-2</c:v>
                </c:pt>
                <c:pt idx="11">
                  <c:v>-2.146E-2</c:v>
                </c:pt>
                <c:pt idx="12">
                  <c:v>-5.8869999999999999E-2</c:v>
                </c:pt>
                <c:pt idx="13">
                  <c:v>-6.9830000000000003E-2</c:v>
                </c:pt>
                <c:pt idx="14">
                  <c:v>-2.9579999999999999E-2</c:v>
                </c:pt>
                <c:pt idx="15">
                  <c:v>-4.5749999999999999E-2</c:v>
                </c:pt>
                <c:pt idx="16">
                  <c:v>-5.083E-2</c:v>
                </c:pt>
                <c:pt idx="17">
                  <c:v>-8.1170000000000006E-2</c:v>
                </c:pt>
                <c:pt idx="18">
                  <c:v>-4.829E-2</c:v>
                </c:pt>
                <c:pt idx="19">
                  <c:v>-7.0669999999999997E-2</c:v>
                </c:pt>
                <c:pt idx="20">
                  <c:v>-8.0759999999999998E-2</c:v>
                </c:pt>
                <c:pt idx="21">
                  <c:v>-2.8729999999999999E-2</c:v>
                </c:pt>
                <c:pt idx="22">
                  <c:v>-0.10123</c:v>
                </c:pt>
                <c:pt idx="23">
                  <c:v>-4.4049999999999999E-2</c:v>
                </c:pt>
                <c:pt idx="24">
                  <c:v>-7.0669999999999997E-2</c:v>
                </c:pt>
                <c:pt idx="25">
                  <c:v>-0.10331</c:v>
                </c:pt>
                <c:pt idx="26">
                  <c:v>-7.4459999999999998E-2</c:v>
                </c:pt>
                <c:pt idx="27">
                  <c:v>-4.4900000000000002E-2</c:v>
                </c:pt>
                <c:pt idx="28">
                  <c:v>-7.2779999999999997E-2</c:v>
                </c:pt>
                <c:pt idx="29">
                  <c:v>-5.8020000000000002E-2</c:v>
                </c:pt>
                <c:pt idx="30">
                  <c:v>-8.2430000000000003E-2</c:v>
                </c:pt>
                <c:pt idx="31">
                  <c:v>-5.8869999999999999E-2</c:v>
                </c:pt>
                <c:pt idx="32">
                  <c:v>-0.11867</c:v>
                </c:pt>
                <c:pt idx="33">
                  <c:v>-6.225E-2</c:v>
                </c:pt>
                <c:pt idx="34">
                  <c:v>-9.1219999999999996E-2</c:v>
                </c:pt>
                <c:pt idx="35">
                  <c:v>-0.10913</c:v>
                </c:pt>
                <c:pt idx="36">
                  <c:v>-9.1639999999999999E-2</c:v>
                </c:pt>
                <c:pt idx="37">
                  <c:v>-6.8150000000000002E-2</c:v>
                </c:pt>
                <c:pt idx="38">
                  <c:v>-7.7399999999999997E-2</c:v>
                </c:pt>
                <c:pt idx="39">
                  <c:v>-0.1004</c:v>
                </c:pt>
                <c:pt idx="40">
                  <c:v>-0.1137</c:v>
                </c:pt>
                <c:pt idx="41">
                  <c:v>-0.14052999999999999</c:v>
                </c:pt>
                <c:pt idx="42">
                  <c:v>-9.665E-2</c:v>
                </c:pt>
                <c:pt idx="43">
                  <c:v>-0.12446</c:v>
                </c:pt>
                <c:pt idx="44">
                  <c:v>-0.13600999999999999</c:v>
                </c:pt>
                <c:pt idx="45">
                  <c:v>-0.11536</c:v>
                </c:pt>
                <c:pt idx="46">
                  <c:v>-0.11246</c:v>
                </c:pt>
                <c:pt idx="47">
                  <c:v>-0.10456</c:v>
                </c:pt>
                <c:pt idx="48">
                  <c:v>-0.12734999999999999</c:v>
                </c:pt>
                <c:pt idx="49">
                  <c:v>-0.11411</c:v>
                </c:pt>
                <c:pt idx="50">
                  <c:v>-0.14299999999999999</c:v>
                </c:pt>
                <c:pt idx="51">
                  <c:v>-0.14832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3C0-BC40-AF02-6F5B603F0664}"/>
            </c:ext>
          </c:extLst>
        </c:ser>
        <c:ser>
          <c:idx val="1"/>
          <c:order val="1"/>
          <c:tx>
            <c:v>Vesicles + Na+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F$2:$F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H$2:$H$53</c:f>
              <c:numCache>
                <c:formatCode>General</c:formatCode>
                <c:ptCount val="52"/>
                <c:pt idx="0">
                  <c:v>0</c:v>
                </c:pt>
                <c:pt idx="1">
                  <c:v>3.8772600000000002</c:v>
                </c:pt>
                <c:pt idx="2">
                  <c:v>5.4622900000000003</c:v>
                </c:pt>
                <c:pt idx="3">
                  <c:v>6.4920299999999997</c:v>
                </c:pt>
                <c:pt idx="4">
                  <c:v>7.20723</c:v>
                </c:pt>
                <c:pt idx="5">
                  <c:v>7.8813199999999997</c:v>
                </c:pt>
                <c:pt idx="6">
                  <c:v>7.3002399999999996</c:v>
                </c:pt>
                <c:pt idx="7">
                  <c:v>7.4016200000000003</c:v>
                </c:pt>
                <c:pt idx="8">
                  <c:v>6.5273399999999846</c:v>
                </c:pt>
                <c:pt idx="9">
                  <c:v>6.0761900000000004</c:v>
                </c:pt>
                <c:pt idx="10">
                  <c:v>5.5167000000000002</c:v>
                </c:pt>
                <c:pt idx="11">
                  <c:v>5.2908299999999997</c:v>
                </c:pt>
                <c:pt idx="12">
                  <c:v>5.2945899999999746</c:v>
                </c:pt>
                <c:pt idx="13">
                  <c:v>5.1122799999999966</c:v>
                </c:pt>
                <c:pt idx="14">
                  <c:v>5.5388700000000002</c:v>
                </c:pt>
                <c:pt idx="15">
                  <c:v>5.6403600000000003</c:v>
                </c:pt>
                <c:pt idx="16">
                  <c:v>5.7680499999999997</c:v>
                </c:pt>
                <c:pt idx="17">
                  <c:v>5.9306000000000001</c:v>
                </c:pt>
                <c:pt idx="18">
                  <c:v>6.3797800000000002</c:v>
                </c:pt>
                <c:pt idx="19">
                  <c:v>6.8737500000000002</c:v>
                </c:pt>
                <c:pt idx="20">
                  <c:v>6.3139799999999946</c:v>
                </c:pt>
                <c:pt idx="21">
                  <c:v>5.8763800000000002</c:v>
                </c:pt>
                <c:pt idx="22">
                  <c:v>5.8597999999999999</c:v>
                </c:pt>
                <c:pt idx="23">
                  <c:v>5.4352799999999997</c:v>
                </c:pt>
                <c:pt idx="24">
                  <c:v>5.4700300000000004</c:v>
                </c:pt>
                <c:pt idx="25">
                  <c:v>5.3398399999999997</c:v>
                </c:pt>
                <c:pt idx="26">
                  <c:v>5.1940799999999756</c:v>
                </c:pt>
                <c:pt idx="27">
                  <c:v>5.30837</c:v>
                </c:pt>
                <c:pt idx="28">
                  <c:v>5.20146</c:v>
                </c:pt>
                <c:pt idx="29">
                  <c:v>5.3297499999999998</c:v>
                </c:pt>
                <c:pt idx="30">
                  <c:v>5.1268399999999854</c:v>
                </c:pt>
                <c:pt idx="31">
                  <c:v>5.1463200000000002</c:v>
                </c:pt>
                <c:pt idx="32">
                  <c:v>5.1719799999999996</c:v>
                </c:pt>
                <c:pt idx="33">
                  <c:v>5.1548599999999736</c:v>
                </c:pt>
                <c:pt idx="34">
                  <c:v>5.1414400000000002</c:v>
                </c:pt>
                <c:pt idx="35">
                  <c:v>5.2385299999999999</c:v>
                </c:pt>
                <c:pt idx="36">
                  <c:v>5.0268799999999976</c:v>
                </c:pt>
                <c:pt idx="37">
                  <c:v>5.0724200000000002</c:v>
                </c:pt>
                <c:pt idx="38">
                  <c:v>4.9746199999999998</c:v>
                </c:pt>
                <c:pt idx="39">
                  <c:v>4.8081199999999846</c:v>
                </c:pt>
                <c:pt idx="40">
                  <c:v>4.9053100000000001</c:v>
                </c:pt>
                <c:pt idx="41">
                  <c:v>4.9076399999999998</c:v>
                </c:pt>
                <c:pt idx="42">
                  <c:v>5.0892999999999997</c:v>
                </c:pt>
                <c:pt idx="43">
                  <c:v>4.9451400000000003</c:v>
                </c:pt>
                <c:pt idx="44">
                  <c:v>5.0568</c:v>
                </c:pt>
                <c:pt idx="45">
                  <c:v>4.8541799999999746</c:v>
                </c:pt>
                <c:pt idx="46">
                  <c:v>4.8322500000000002</c:v>
                </c:pt>
                <c:pt idx="47">
                  <c:v>4.9817200000000001</c:v>
                </c:pt>
                <c:pt idx="48">
                  <c:v>4.7488099999999998</c:v>
                </c:pt>
                <c:pt idx="49">
                  <c:v>4.87852</c:v>
                </c:pt>
                <c:pt idx="50">
                  <c:v>4.9580900000000003</c:v>
                </c:pt>
                <c:pt idx="51">
                  <c:v>4.98052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3C0-BC40-AF02-6F5B603F0664}"/>
            </c:ext>
          </c:extLst>
        </c:ser>
        <c:ser>
          <c:idx val="2"/>
          <c:order val="2"/>
          <c:tx>
            <c:v>Vesicles + Na+ + Monensin</c:v>
          </c:tx>
          <c:spPr>
            <a:ln w="19050" cap="rnd">
              <a:solidFill>
                <a:srgbClr val="0432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432FF"/>
              </a:solidFill>
              <a:ln w="9525">
                <a:solidFill>
                  <a:srgbClr val="0432FF"/>
                </a:solidFill>
              </a:ln>
              <a:effectLst/>
            </c:spPr>
          </c:marker>
          <c:xVal>
            <c:numRef>
              <c:f>Sheet1!$F$2:$F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I$2:$I$53</c:f>
              <c:numCache>
                <c:formatCode>General</c:formatCode>
                <c:ptCount val="52"/>
                <c:pt idx="0">
                  <c:v>0</c:v>
                </c:pt>
                <c:pt idx="1">
                  <c:v>3.33616</c:v>
                </c:pt>
                <c:pt idx="2">
                  <c:v>4.8586600000000004</c:v>
                </c:pt>
                <c:pt idx="3">
                  <c:v>6.3992300000000002</c:v>
                </c:pt>
                <c:pt idx="4">
                  <c:v>7.3617600000000003</c:v>
                </c:pt>
                <c:pt idx="5">
                  <c:v>7.5203699999999998</c:v>
                </c:pt>
                <c:pt idx="6">
                  <c:v>7.5292000000000003</c:v>
                </c:pt>
                <c:pt idx="7">
                  <c:v>7.4851900000000002</c:v>
                </c:pt>
                <c:pt idx="8">
                  <c:v>7.5433399999999997</c:v>
                </c:pt>
                <c:pt idx="9">
                  <c:v>6.8817500000000003</c:v>
                </c:pt>
                <c:pt idx="10">
                  <c:v>6.2453500000000002</c:v>
                </c:pt>
                <c:pt idx="11">
                  <c:v>5.9597600000000002</c:v>
                </c:pt>
                <c:pt idx="12">
                  <c:v>5.5748300000000004</c:v>
                </c:pt>
                <c:pt idx="13">
                  <c:v>5.0510599999999997</c:v>
                </c:pt>
                <c:pt idx="14">
                  <c:v>4.98773</c:v>
                </c:pt>
                <c:pt idx="15">
                  <c:v>5.0605099999999954</c:v>
                </c:pt>
                <c:pt idx="16">
                  <c:v>5.4115700000000002</c:v>
                </c:pt>
                <c:pt idx="17">
                  <c:v>5.40151</c:v>
                </c:pt>
                <c:pt idx="18">
                  <c:v>5.7083000000000004</c:v>
                </c:pt>
                <c:pt idx="19">
                  <c:v>6.2020799999999996</c:v>
                </c:pt>
                <c:pt idx="20">
                  <c:v>6.1405799999999946</c:v>
                </c:pt>
                <c:pt idx="21">
                  <c:v>6.4454099999999999</c:v>
                </c:pt>
                <c:pt idx="22">
                  <c:v>5.9680499999999999</c:v>
                </c:pt>
                <c:pt idx="23">
                  <c:v>5.4760600000000004</c:v>
                </c:pt>
                <c:pt idx="24">
                  <c:v>5.5503</c:v>
                </c:pt>
                <c:pt idx="25">
                  <c:v>5.48752</c:v>
                </c:pt>
                <c:pt idx="26">
                  <c:v>5.3217299999999996</c:v>
                </c:pt>
                <c:pt idx="27">
                  <c:v>5.3877199999999856</c:v>
                </c:pt>
                <c:pt idx="28">
                  <c:v>5.2381799999999998</c:v>
                </c:pt>
                <c:pt idx="29">
                  <c:v>5.22234</c:v>
                </c:pt>
                <c:pt idx="30">
                  <c:v>5.5425700000000004</c:v>
                </c:pt>
                <c:pt idx="31">
                  <c:v>5.5425700000000004</c:v>
                </c:pt>
                <c:pt idx="32">
                  <c:v>5.5890700000000004</c:v>
                </c:pt>
                <c:pt idx="33">
                  <c:v>5.4557500000000001</c:v>
                </c:pt>
                <c:pt idx="34">
                  <c:v>5.6660999999999957</c:v>
                </c:pt>
                <c:pt idx="35">
                  <c:v>5.59816</c:v>
                </c:pt>
                <c:pt idx="36">
                  <c:v>5.4342499999999996</c:v>
                </c:pt>
                <c:pt idx="37">
                  <c:v>5.40151</c:v>
                </c:pt>
                <c:pt idx="38">
                  <c:v>5.22356</c:v>
                </c:pt>
                <c:pt idx="39">
                  <c:v>5.22234</c:v>
                </c:pt>
                <c:pt idx="40">
                  <c:v>5.3167799999999996</c:v>
                </c:pt>
                <c:pt idx="41">
                  <c:v>5.6516599999999997</c:v>
                </c:pt>
                <c:pt idx="42">
                  <c:v>5.5066600000000001</c:v>
                </c:pt>
                <c:pt idx="43">
                  <c:v>5.0687799999999976</c:v>
                </c:pt>
                <c:pt idx="44">
                  <c:v>5.3589899999999746</c:v>
                </c:pt>
                <c:pt idx="45">
                  <c:v>5.1294599999999946</c:v>
                </c:pt>
                <c:pt idx="46">
                  <c:v>5.3852200000000003</c:v>
                </c:pt>
                <c:pt idx="47">
                  <c:v>5.1294599999999946</c:v>
                </c:pt>
                <c:pt idx="48">
                  <c:v>5.14384</c:v>
                </c:pt>
                <c:pt idx="49">
                  <c:v>5.0984499999999997</c:v>
                </c:pt>
                <c:pt idx="50">
                  <c:v>5.2150499999999997</c:v>
                </c:pt>
                <c:pt idx="51">
                  <c:v>4.88377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53C0-BC40-AF02-6F5B603F06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91082384"/>
        <c:axId val="1091072992"/>
      </c:scatterChart>
      <c:valAx>
        <c:axId val="1091082384"/>
        <c:scaling>
          <c:orientation val="minMax"/>
          <c:max val="10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1072992"/>
        <c:crosses val="autoZero"/>
        <c:crossBetween val="midCat"/>
        <c:majorUnit val="20"/>
      </c:valAx>
      <c:valAx>
        <c:axId val="1091072992"/>
        <c:scaling>
          <c:orientation val="minMax"/>
          <c:max val="15"/>
          <c:min val="-0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1082384"/>
        <c:crosses val="autoZero"/>
        <c:crossBetween val="midCat"/>
        <c:majorUnit val="2.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3975662897906999"/>
          <c:y val="0.64097025371828498"/>
          <c:w val="0.70211025304529195"/>
          <c:h val="0.20902974628171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68985126859099"/>
          <c:y val="3.05139982502187E-2"/>
          <c:w val="0.77086570428696399"/>
          <c:h val="0.89076684164479403"/>
        </c:manualLayout>
      </c:layout>
      <c:scatterChart>
        <c:scatterStyle val="smoothMarker"/>
        <c:varyColors val="0"/>
        <c:ser>
          <c:idx val="0"/>
          <c:order val="0"/>
          <c:tx>
            <c:v>Vesicles (OA-POPC (1:10))</c:v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Z$2:$Z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AA$2:$AA$53</c:f>
              <c:numCache>
                <c:formatCode>General</c:formatCode>
                <c:ptCount val="52"/>
                <c:pt idx="0">
                  <c:v>0</c:v>
                </c:pt>
                <c:pt idx="1">
                  <c:v>-7.4940000000000007E-2</c:v>
                </c:pt>
                <c:pt idx="2">
                  <c:v>-3.245E-2</c:v>
                </c:pt>
                <c:pt idx="3">
                  <c:v>-7.1980000000000002E-2</c:v>
                </c:pt>
                <c:pt idx="4">
                  <c:v>-5.6009999999999997E-2</c:v>
                </c:pt>
                <c:pt idx="5">
                  <c:v>-7.9750000000000001E-2</c:v>
                </c:pt>
                <c:pt idx="6">
                  <c:v>-6.8640000000000007E-2</c:v>
                </c:pt>
                <c:pt idx="7">
                  <c:v>-8.1960000000000005E-2</c:v>
                </c:pt>
                <c:pt idx="8">
                  <c:v>-7.3459999999999998E-2</c:v>
                </c:pt>
                <c:pt idx="9">
                  <c:v>-0.12994</c:v>
                </c:pt>
                <c:pt idx="10">
                  <c:v>-0.11829000000000001</c:v>
                </c:pt>
                <c:pt idx="11">
                  <c:v>-0.12812000000000001</c:v>
                </c:pt>
                <c:pt idx="12">
                  <c:v>-0.14080999999999999</c:v>
                </c:pt>
                <c:pt idx="13">
                  <c:v>-0.1361</c:v>
                </c:pt>
                <c:pt idx="14">
                  <c:v>-0.11318</c:v>
                </c:pt>
                <c:pt idx="15">
                  <c:v>-0.15597</c:v>
                </c:pt>
                <c:pt idx="16">
                  <c:v>-0.21443999999999999</c:v>
                </c:pt>
                <c:pt idx="17">
                  <c:v>-0.18071000000000001</c:v>
                </c:pt>
                <c:pt idx="18">
                  <c:v>-0.18998000000000001</c:v>
                </c:pt>
                <c:pt idx="19">
                  <c:v>-0.14660000000000001</c:v>
                </c:pt>
                <c:pt idx="20">
                  <c:v>-0.20843</c:v>
                </c:pt>
                <c:pt idx="21">
                  <c:v>-0.16819000000000001</c:v>
                </c:pt>
                <c:pt idx="22">
                  <c:v>-0.17857000000000001</c:v>
                </c:pt>
                <c:pt idx="23">
                  <c:v>-0.20064000000000001</c:v>
                </c:pt>
                <c:pt idx="24">
                  <c:v>-0.25683</c:v>
                </c:pt>
                <c:pt idx="25">
                  <c:v>-0.20737</c:v>
                </c:pt>
                <c:pt idx="26">
                  <c:v>-0.21301999999999999</c:v>
                </c:pt>
                <c:pt idx="27">
                  <c:v>-0.16891</c:v>
                </c:pt>
                <c:pt idx="28">
                  <c:v>-0.21196000000000001</c:v>
                </c:pt>
                <c:pt idx="29">
                  <c:v>-0.21407999999999999</c:v>
                </c:pt>
                <c:pt idx="30">
                  <c:v>-0.19744999999999999</c:v>
                </c:pt>
                <c:pt idx="31">
                  <c:v>-0.19034000000000001</c:v>
                </c:pt>
                <c:pt idx="32">
                  <c:v>-0.19389000000000001</c:v>
                </c:pt>
                <c:pt idx="33">
                  <c:v>-0.22852</c:v>
                </c:pt>
                <c:pt idx="34">
                  <c:v>-0.14588000000000001</c:v>
                </c:pt>
                <c:pt idx="35">
                  <c:v>-0.17141999999999999</c:v>
                </c:pt>
                <c:pt idx="36">
                  <c:v>-0.2243</c:v>
                </c:pt>
                <c:pt idx="37">
                  <c:v>-0.13392999999999999</c:v>
                </c:pt>
                <c:pt idx="38">
                  <c:v>-0.13320000000000001</c:v>
                </c:pt>
                <c:pt idx="39">
                  <c:v>-0.15705</c:v>
                </c:pt>
                <c:pt idx="40">
                  <c:v>-0.12339</c:v>
                </c:pt>
                <c:pt idx="41">
                  <c:v>-0.17571000000000001</c:v>
                </c:pt>
                <c:pt idx="42">
                  <c:v>-0.14226</c:v>
                </c:pt>
                <c:pt idx="43">
                  <c:v>-0.1</c:v>
                </c:pt>
                <c:pt idx="44">
                  <c:v>-0.14008999999999999</c:v>
                </c:pt>
                <c:pt idx="45">
                  <c:v>-0.11099000000000001</c:v>
                </c:pt>
                <c:pt idx="46">
                  <c:v>-8.7499999999999994E-2</c:v>
                </c:pt>
                <c:pt idx="47">
                  <c:v>-0.13972999999999999</c:v>
                </c:pt>
                <c:pt idx="48">
                  <c:v>-0.14080999999999999</c:v>
                </c:pt>
                <c:pt idx="49">
                  <c:v>-0.15812999999999999</c:v>
                </c:pt>
                <c:pt idx="50">
                  <c:v>-0.25544</c:v>
                </c:pt>
                <c:pt idx="51">
                  <c:v>-0.288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B1B-8343-B68B-2B20B7184A7A}"/>
            </c:ext>
          </c:extLst>
        </c:ser>
        <c:ser>
          <c:idx val="1"/>
          <c:order val="1"/>
          <c:tx>
            <c:v>Vesicles + Na+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Z$2:$Z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AB$2:$AB$53</c:f>
              <c:numCache>
                <c:formatCode>General</c:formatCode>
                <c:ptCount val="52"/>
                <c:pt idx="0">
                  <c:v>0</c:v>
                </c:pt>
                <c:pt idx="1">
                  <c:v>0.77610999999999997</c:v>
                </c:pt>
                <c:pt idx="2">
                  <c:v>1.3458600000000001</c:v>
                </c:pt>
                <c:pt idx="3">
                  <c:v>2.0249100000000002</c:v>
                </c:pt>
                <c:pt idx="4">
                  <c:v>2.409419999999999</c:v>
                </c:pt>
                <c:pt idx="5">
                  <c:v>2.4816500000000001</c:v>
                </c:pt>
                <c:pt idx="6">
                  <c:v>2.7121300000000002</c:v>
                </c:pt>
                <c:pt idx="7">
                  <c:v>3.09754</c:v>
                </c:pt>
                <c:pt idx="8">
                  <c:v>3.2257199999999999</c:v>
                </c:pt>
                <c:pt idx="9">
                  <c:v>3.5005199999999999</c:v>
                </c:pt>
                <c:pt idx="10">
                  <c:v>3.69523</c:v>
                </c:pt>
                <c:pt idx="11">
                  <c:v>3.5571199999999998</c:v>
                </c:pt>
                <c:pt idx="12">
                  <c:v>3.6311300000000002</c:v>
                </c:pt>
                <c:pt idx="13">
                  <c:v>3.875989999999998</c:v>
                </c:pt>
                <c:pt idx="14">
                  <c:v>3.9990700000000001</c:v>
                </c:pt>
                <c:pt idx="15">
                  <c:v>3.9756499999999639</c:v>
                </c:pt>
                <c:pt idx="16">
                  <c:v>3.80254</c:v>
                </c:pt>
                <c:pt idx="17">
                  <c:v>3.8347600000000002</c:v>
                </c:pt>
                <c:pt idx="18">
                  <c:v>3.8531399999999998</c:v>
                </c:pt>
                <c:pt idx="19">
                  <c:v>3.99546</c:v>
                </c:pt>
                <c:pt idx="20">
                  <c:v>3.9936600000000002</c:v>
                </c:pt>
                <c:pt idx="21">
                  <c:v>3.98915</c:v>
                </c:pt>
                <c:pt idx="22">
                  <c:v>4.0207899999999954</c:v>
                </c:pt>
                <c:pt idx="23">
                  <c:v>4.08284</c:v>
                </c:pt>
                <c:pt idx="24">
                  <c:v>4.0883500000000002</c:v>
                </c:pt>
                <c:pt idx="25">
                  <c:v>3.9738500000000001</c:v>
                </c:pt>
                <c:pt idx="26">
                  <c:v>4.2736700000000001</c:v>
                </c:pt>
                <c:pt idx="27">
                  <c:v>4.2243399999999944</c:v>
                </c:pt>
                <c:pt idx="28">
                  <c:v>4.5717800000000004</c:v>
                </c:pt>
                <c:pt idx="29">
                  <c:v>4.5105899999999846</c:v>
                </c:pt>
                <c:pt idx="30">
                  <c:v>4.5225699999999964</c:v>
                </c:pt>
                <c:pt idx="31">
                  <c:v>4.5506399999999996</c:v>
                </c:pt>
                <c:pt idx="32">
                  <c:v>4.8227799999999856</c:v>
                </c:pt>
                <c:pt idx="33">
                  <c:v>4.7461399999999996</c:v>
                </c:pt>
                <c:pt idx="34">
                  <c:v>4.5879499999999984</c:v>
                </c:pt>
                <c:pt idx="35">
                  <c:v>4.5576799999999986</c:v>
                </c:pt>
                <c:pt idx="36">
                  <c:v>4.6153499999999976</c:v>
                </c:pt>
                <c:pt idx="37">
                  <c:v>4.8259499999999846</c:v>
                </c:pt>
                <c:pt idx="38">
                  <c:v>4.8027299999999986</c:v>
                </c:pt>
                <c:pt idx="39">
                  <c:v>5.0472599999999996</c:v>
                </c:pt>
                <c:pt idx="40">
                  <c:v>5.2138499999999999</c:v>
                </c:pt>
                <c:pt idx="41">
                  <c:v>5.0066499999999996</c:v>
                </c:pt>
                <c:pt idx="42">
                  <c:v>4.7357199999999997</c:v>
                </c:pt>
                <c:pt idx="43">
                  <c:v>4.6245099999999528</c:v>
                </c:pt>
                <c:pt idx="44">
                  <c:v>4.7880000000000003</c:v>
                </c:pt>
                <c:pt idx="45">
                  <c:v>4.99573</c:v>
                </c:pt>
                <c:pt idx="46">
                  <c:v>4.8791099999999998</c:v>
                </c:pt>
                <c:pt idx="47">
                  <c:v>4.9349499999999997</c:v>
                </c:pt>
                <c:pt idx="48">
                  <c:v>4.9468300000000003</c:v>
                </c:pt>
                <c:pt idx="49">
                  <c:v>4.8429099999999856</c:v>
                </c:pt>
                <c:pt idx="50">
                  <c:v>4.8027299999999986</c:v>
                </c:pt>
                <c:pt idx="51">
                  <c:v>5.08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B1B-8343-B68B-2B20B7184A7A}"/>
            </c:ext>
          </c:extLst>
        </c:ser>
        <c:ser>
          <c:idx val="2"/>
          <c:order val="2"/>
          <c:tx>
            <c:v>Vesicles + Na+ + Monensin</c:v>
          </c:tx>
          <c:spPr>
            <a:ln w="19050" cap="rnd">
              <a:solidFill>
                <a:srgbClr val="0432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432FF"/>
              </a:solidFill>
              <a:ln w="9525">
                <a:solidFill>
                  <a:srgbClr val="0432FF"/>
                </a:solidFill>
              </a:ln>
              <a:effectLst/>
            </c:spPr>
          </c:marker>
          <c:xVal>
            <c:numRef>
              <c:f>Sheet1!$Z$2:$Z$53</c:f>
              <c:numCache>
                <c:formatCode>General</c:formatCode>
                <c:ptCount val="5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  <c:pt idx="22">
                  <c:v>44</c:v>
                </c:pt>
                <c:pt idx="23">
                  <c:v>46</c:v>
                </c:pt>
                <c:pt idx="24">
                  <c:v>48</c:v>
                </c:pt>
                <c:pt idx="25">
                  <c:v>50</c:v>
                </c:pt>
                <c:pt idx="26">
                  <c:v>52</c:v>
                </c:pt>
                <c:pt idx="27">
                  <c:v>54</c:v>
                </c:pt>
                <c:pt idx="28">
                  <c:v>56</c:v>
                </c:pt>
                <c:pt idx="29">
                  <c:v>58</c:v>
                </c:pt>
                <c:pt idx="30">
                  <c:v>60</c:v>
                </c:pt>
                <c:pt idx="31">
                  <c:v>62</c:v>
                </c:pt>
                <c:pt idx="32">
                  <c:v>64</c:v>
                </c:pt>
                <c:pt idx="33">
                  <c:v>66</c:v>
                </c:pt>
                <c:pt idx="34">
                  <c:v>68</c:v>
                </c:pt>
                <c:pt idx="35">
                  <c:v>70</c:v>
                </c:pt>
                <c:pt idx="36">
                  <c:v>72</c:v>
                </c:pt>
                <c:pt idx="37">
                  <c:v>74</c:v>
                </c:pt>
                <c:pt idx="38">
                  <c:v>76</c:v>
                </c:pt>
                <c:pt idx="39">
                  <c:v>78</c:v>
                </c:pt>
                <c:pt idx="40">
                  <c:v>80</c:v>
                </c:pt>
                <c:pt idx="41">
                  <c:v>82</c:v>
                </c:pt>
                <c:pt idx="42">
                  <c:v>84</c:v>
                </c:pt>
                <c:pt idx="43">
                  <c:v>86</c:v>
                </c:pt>
                <c:pt idx="44">
                  <c:v>88</c:v>
                </c:pt>
                <c:pt idx="45">
                  <c:v>90</c:v>
                </c:pt>
                <c:pt idx="46">
                  <c:v>92</c:v>
                </c:pt>
                <c:pt idx="47">
                  <c:v>94</c:v>
                </c:pt>
                <c:pt idx="48">
                  <c:v>96</c:v>
                </c:pt>
                <c:pt idx="49">
                  <c:v>98</c:v>
                </c:pt>
                <c:pt idx="50">
                  <c:v>100</c:v>
                </c:pt>
                <c:pt idx="51">
                  <c:v>102</c:v>
                </c:pt>
              </c:numCache>
            </c:numRef>
          </c:xVal>
          <c:yVal>
            <c:numRef>
              <c:f>Sheet1!$AC$2:$AC$53</c:f>
              <c:numCache>
                <c:formatCode>General</c:formatCode>
                <c:ptCount val="52"/>
                <c:pt idx="0">
                  <c:v>0</c:v>
                </c:pt>
                <c:pt idx="1">
                  <c:v>2.16683</c:v>
                </c:pt>
                <c:pt idx="2">
                  <c:v>5.7904299999999997</c:v>
                </c:pt>
                <c:pt idx="3">
                  <c:v>9.6634900000000012</c:v>
                </c:pt>
                <c:pt idx="4">
                  <c:v>11.60017</c:v>
                </c:pt>
                <c:pt idx="5">
                  <c:v>12.06621</c:v>
                </c:pt>
                <c:pt idx="6">
                  <c:v>12.78462</c:v>
                </c:pt>
                <c:pt idx="7">
                  <c:v>13.17686</c:v>
                </c:pt>
                <c:pt idx="8">
                  <c:v>12.781029999999999</c:v>
                </c:pt>
                <c:pt idx="9">
                  <c:v>12.27455</c:v>
                </c:pt>
                <c:pt idx="10">
                  <c:v>11.628590000000001</c:v>
                </c:pt>
                <c:pt idx="11">
                  <c:v>12.342779999999999</c:v>
                </c:pt>
                <c:pt idx="12">
                  <c:v>12.561070000000001</c:v>
                </c:pt>
                <c:pt idx="13">
                  <c:v>11.95069</c:v>
                </c:pt>
                <c:pt idx="14">
                  <c:v>11.549860000000001</c:v>
                </c:pt>
                <c:pt idx="15">
                  <c:v>11.57498</c:v>
                </c:pt>
                <c:pt idx="16">
                  <c:v>12.05625</c:v>
                </c:pt>
                <c:pt idx="17">
                  <c:v>10.728</c:v>
                </c:pt>
                <c:pt idx="18">
                  <c:v>10.74511</c:v>
                </c:pt>
                <c:pt idx="19">
                  <c:v>11.16351</c:v>
                </c:pt>
                <c:pt idx="20">
                  <c:v>10.773709999999999</c:v>
                </c:pt>
                <c:pt idx="21">
                  <c:v>10.97077</c:v>
                </c:pt>
                <c:pt idx="22">
                  <c:v>10.99132</c:v>
                </c:pt>
                <c:pt idx="23">
                  <c:v>11.80753</c:v>
                </c:pt>
                <c:pt idx="24">
                  <c:v>12.339359999999999</c:v>
                </c:pt>
                <c:pt idx="25">
                  <c:v>11.817220000000001</c:v>
                </c:pt>
                <c:pt idx="26">
                  <c:v>11.41916</c:v>
                </c:pt>
                <c:pt idx="27">
                  <c:v>11.49361</c:v>
                </c:pt>
                <c:pt idx="28">
                  <c:v>11.19055</c:v>
                </c:pt>
                <c:pt idx="29">
                  <c:v>10.903600000000001</c:v>
                </c:pt>
                <c:pt idx="30">
                  <c:v>11.60017</c:v>
                </c:pt>
                <c:pt idx="31">
                  <c:v>12.933009999999999</c:v>
                </c:pt>
                <c:pt idx="32">
                  <c:v>13.4887</c:v>
                </c:pt>
                <c:pt idx="33">
                  <c:v>14.1067</c:v>
                </c:pt>
                <c:pt idx="34">
                  <c:v>13.065239999999999</c:v>
                </c:pt>
                <c:pt idx="35">
                  <c:v>11.062150000000001</c:v>
                </c:pt>
                <c:pt idx="36">
                  <c:v>11.12462</c:v>
                </c:pt>
                <c:pt idx="37">
                  <c:v>10.67404</c:v>
                </c:pt>
                <c:pt idx="38">
                  <c:v>10.131779999999999</c:v>
                </c:pt>
                <c:pt idx="39">
                  <c:v>12.18324</c:v>
                </c:pt>
                <c:pt idx="40">
                  <c:v>12.196709999999999</c:v>
                </c:pt>
                <c:pt idx="41">
                  <c:v>12.315429999999999</c:v>
                </c:pt>
                <c:pt idx="42">
                  <c:v>11.62227</c:v>
                </c:pt>
                <c:pt idx="43">
                  <c:v>12.01322</c:v>
                </c:pt>
                <c:pt idx="44">
                  <c:v>11.41916</c:v>
                </c:pt>
                <c:pt idx="45">
                  <c:v>11.717610000000001</c:v>
                </c:pt>
                <c:pt idx="46">
                  <c:v>11.58756</c:v>
                </c:pt>
                <c:pt idx="47">
                  <c:v>11.094810000000001</c:v>
                </c:pt>
                <c:pt idx="48">
                  <c:v>11.299530000000001</c:v>
                </c:pt>
                <c:pt idx="49">
                  <c:v>12.220330000000001</c:v>
                </c:pt>
                <c:pt idx="50">
                  <c:v>12.179869999999999</c:v>
                </c:pt>
                <c:pt idx="51">
                  <c:v>11.2873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DB1B-8343-B68B-2B20B7184A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91029760"/>
        <c:axId val="1091031392"/>
      </c:scatterChart>
      <c:valAx>
        <c:axId val="1091029760"/>
        <c:scaling>
          <c:orientation val="minMax"/>
          <c:max val="10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1031392"/>
        <c:crosses val="autoZero"/>
        <c:crossBetween val="midCat"/>
        <c:majorUnit val="20"/>
      </c:valAx>
      <c:valAx>
        <c:axId val="1091031392"/>
        <c:scaling>
          <c:orientation val="minMax"/>
          <c:max val="15"/>
          <c:min val="-0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91029760"/>
        <c:crosses val="autoZero"/>
        <c:crossBetween val="midCat"/>
        <c:majorUnit val="2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image" Target="../media/image2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5ABB36-2EC0-F24D-AA0E-B084417641A3}" type="datetimeFigureOut">
              <a:rPr lang="en-US" smtClean="0"/>
              <a:t>4/26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C00502-171B-AF43-AAC4-178120C0B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553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C00502-171B-AF43-AAC4-178120C0BB9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811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C00502-171B-AF43-AAC4-178120C0BB9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95080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C00502-171B-AF43-AAC4-178120C0BB9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78625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C00502-171B-AF43-AAC4-178120C0BB9D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35646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1A956C-43EA-A44B-9404-B48079645103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6335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6EBE9-1F57-B34D-A00C-68DF281E3517}" type="datetime1">
              <a:rPr lang="en-US" smtClean="0"/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1CB92-9702-B148-96E8-27B75B4B59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6194-3F7B-6E4D-9EEB-88A9CF75E767}" type="datetime1">
              <a:rPr lang="en-US" smtClean="0"/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1CB92-9702-B148-96E8-27B75B4B59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1F4C86-630B-224C-A701-7FCBF65EFE26}" type="datetime1">
              <a:rPr lang="en-US" smtClean="0"/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1CB92-9702-B148-96E8-27B75B4B59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8451-2B9E-1846-B4B3-3521FBE7C0B0}" type="datetime1">
              <a:rPr lang="en-US" smtClean="0"/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1CB92-9702-B148-96E8-27B75B4B59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73D60-8B82-C248-9B3E-7965F37C78B6}" type="datetime1">
              <a:rPr lang="en-US" smtClean="0"/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1CB92-9702-B148-96E8-27B75B4B59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7A776-2829-A74A-B8B0-60C621C4B29F}" type="datetime1">
              <a:rPr lang="en-US" smtClean="0"/>
              <a:t>4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1CB92-9702-B148-96E8-27B75B4B59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9FB8A-42C9-774A-8B3D-9C32F2BDD529}" type="datetime1">
              <a:rPr lang="en-US" smtClean="0"/>
              <a:t>4/2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1CB92-9702-B148-96E8-27B75B4B59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C03CD-4334-4A46-8AAC-358868ACE660}" type="datetime1">
              <a:rPr lang="en-US" smtClean="0"/>
              <a:t>4/2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1CB92-9702-B148-96E8-27B75B4B59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678E-3A0D-0741-B88A-01D942F00020}" type="datetime1">
              <a:rPr lang="en-US" smtClean="0"/>
              <a:t>4/2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1CB92-9702-B148-96E8-27B75B4B59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CFE10-BD58-EB4C-A373-C19BA72B32E5}" type="datetime1">
              <a:rPr lang="en-US" smtClean="0"/>
              <a:t>4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1CB92-9702-B148-96E8-27B75B4B59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D4C1D-A305-5A46-84F8-CC94B46A98A0}" type="datetime1">
              <a:rPr lang="en-US" smtClean="0"/>
              <a:t>4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1CB92-9702-B148-96E8-27B75B4B59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D3CF9-63F7-9B45-A080-74D8F32CD7EB}" type="datetime1">
              <a:rPr lang="en-US" smtClean="0"/>
              <a:t>4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01CB92-9702-B148-96E8-27B75B4B59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893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7" Type="http://schemas.openxmlformats.org/officeDocument/2006/relationships/chart" Target="../charts/chart7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6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7" Type="http://schemas.openxmlformats.org/officeDocument/2006/relationships/image" Target="../media/image3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2.wmf"/><Relationship Id="rId4" Type="http://schemas.openxmlformats.org/officeDocument/2006/relationships/oleObject" Target="../embeddings/oleObject1.bin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2032000" y="2030412"/>
          <a:ext cx="5080000" cy="27971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/>
          <p:cNvSpPr/>
          <p:nvPr/>
        </p:nvSpPr>
        <p:spPr>
          <a:xfrm>
            <a:off x="108858" y="4979352"/>
            <a:ext cx="890451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b="1" kern="100" dirty="0">
                <a:latin typeface="Palatino Linotype" panose="02040502050505030304" pitchFamily="18" charset="0"/>
                <a:ea typeface="SimSun" charset="-122"/>
              </a:rPr>
              <a:t>Figure S1. </a:t>
            </a:r>
            <a:r>
              <a:rPr lang="en-US" kern="100" dirty="0">
                <a:latin typeface="Palatino Linotype" panose="02040502050505030304" pitchFamily="18" charset="0"/>
                <a:ea typeface="SimSun" charset="-122"/>
              </a:rPr>
              <a:t>A representative column purification of a sample of PBFI-</a:t>
            </a:r>
            <a:r>
              <a:rPr lang="en-US" kern="100" dirty="0" err="1">
                <a:latin typeface="Palatino Linotype" panose="02040502050505030304" pitchFamily="18" charset="0"/>
                <a:ea typeface="SimSun" charset="-122"/>
              </a:rPr>
              <a:t>pyranine</a:t>
            </a:r>
            <a:r>
              <a:rPr lang="en-US" kern="100" dirty="0">
                <a:latin typeface="Palatino Linotype" panose="02040502050505030304" pitchFamily="18" charset="0"/>
                <a:ea typeface="SimSun" charset="-122"/>
              </a:rPr>
              <a:t>-loaded vesicles (</a:t>
            </a:r>
            <a:r>
              <a:rPr lang="en-GB" kern="100" dirty="0">
                <a:latin typeface="Palatino Linotype" panose="02040502050505030304" pitchFamily="18" charset="0"/>
                <a:ea typeface="SimSun" charset="-122"/>
              </a:rPr>
              <a:t>OA/DOPC (1:5)).</a:t>
            </a:r>
            <a:endParaRPr lang="en-US" sz="1400" kern="100" dirty="0">
              <a:effectLst/>
              <a:latin typeface="Palatino Linotype" panose="02040502050505030304" pitchFamily="18" charset="0"/>
              <a:ea typeface="SimSun" charset="-122"/>
            </a:endParaRP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1CB92-9702-B148-96E8-27B75B4B593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9624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1CB92-9702-B148-96E8-27B75B4B5931}" type="slidenum">
              <a:rPr lang="en-US" smtClean="0"/>
              <a:t>2</a:t>
            </a:fld>
            <a:endParaRPr lang="en-US"/>
          </a:p>
        </p:txBody>
      </p:sp>
      <p:pic>
        <p:nvPicPr>
          <p:cNvPr id="13" name="Picture 12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680" y="440084"/>
            <a:ext cx="7891670" cy="59162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52903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/>
          </p:nvPr>
        </p:nvGraphicFramePr>
        <p:xfrm>
          <a:off x="1424322" y="836712"/>
          <a:ext cx="6295355" cy="4457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/>
          <p:cNvSpPr/>
          <p:nvPr/>
        </p:nvSpPr>
        <p:spPr>
          <a:xfrm>
            <a:off x="141515" y="5436551"/>
            <a:ext cx="881742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b="1" kern="100" dirty="0">
                <a:latin typeface="Palatino Linotype" panose="02040502050505030304" pitchFamily="18" charset="0"/>
                <a:ea typeface="SimSun" charset="-122"/>
              </a:rPr>
              <a:t>Figure S3. </a:t>
            </a:r>
            <a:r>
              <a:rPr lang="en-US" kern="100" dirty="0" err="1">
                <a:latin typeface="Palatino Linotype" panose="02040502050505030304" pitchFamily="18" charset="0"/>
                <a:ea typeface="SimSun" charset="-122"/>
              </a:rPr>
              <a:t>Calcein</a:t>
            </a:r>
            <a:r>
              <a:rPr lang="en-US" kern="100" dirty="0">
                <a:latin typeface="Palatino Linotype" panose="02040502050505030304" pitchFamily="18" charset="0"/>
                <a:ea typeface="SimSun" charset="-122"/>
              </a:rPr>
              <a:t> leakage assay to determine stability (permeability) of membranes of various lipids.</a:t>
            </a:r>
            <a:endParaRPr lang="en-US" sz="1400" kern="100" dirty="0">
              <a:effectLst/>
              <a:latin typeface="Palatino Linotype" panose="02040502050505030304" pitchFamily="18" charset="0"/>
              <a:ea typeface="SimSun" charset="-122"/>
            </a:endParaRP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1CB92-9702-B148-96E8-27B75B4B593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9965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6316" y="5355201"/>
            <a:ext cx="89535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b="1" kern="100" dirty="0">
                <a:latin typeface="Palatino Linotype" panose="02040502050505030304" pitchFamily="18" charset="0"/>
                <a:ea typeface="宋体" charset="-122"/>
              </a:rPr>
              <a:t>Figure S4</a:t>
            </a:r>
            <a:r>
              <a:rPr lang="en-US" sz="1600" kern="100" dirty="0">
                <a:latin typeface="Palatino Linotype" panose="02040502050505030304" pitchFamily="18" charset="0"/>
                <a:ea typeface="宋体" charset="-122"/>
              </a:rPr>
              <a:t>. Permeability of K</a:t>
            </a:r>
            <a:r>
              <a:rPr lang="en-US" sz="1600" kern="100" baseline="30000" dirty="0">
                <a:latin typeface="Palatino Linotype" panose="02040502050505030304" pitchFamily="18" charset="0"/>
                <a:ea typeface="宋体" charset="-122"/>
              </a:rPr>
              <a:t>+</a:t>
            </a:r>
            <a:r>
              <a:rPr lang="en-US" sz="1600" kern="100" dirty="0">
                <a:latin typeface="Palatino Linotype" panose="02040502050505030304" pitchFamily="18" charset="0"/>
                <a:ea typeface="宋体" charset="-122"/>
              </a:rPr>
              <a:t> across mixed OA/DOPC membranes in the absence (a) and presence (e) of ionophore: comparison of various OA/DOPC compositions. (b)-(d) permeability in the absence and presence of valinomycin, a K</a:t>
            </a:r>
            <a:r>
              <a:rPr lang="en-US" sz="1600" kern="100" baseline="30000" dirty="0">
                <a:latin typeface="Palatino Linotype" panose="02040502050505030304" pitchFamily="18" charset="0"/>
                <a:ea typeface="宋体" charset="-122"/>
              </a:rPr>
              <a:t>+</a:t>
            </a:r>
            <a:r>
              <a:rPr lang="en-US" sz="1600" kern="100" dirty="0">
                <a:latin typeface="Palatino Linotype" panose="02040502050505030304" pitchFamily="18" charset="0"/>
                <a:ea typeface="宋体" charset="-122"/>
              </a:rPr>
              <a:t>-ion transporter across membranes, as a positive control for OA/DOPC ratios of 1:1 (b); (1:5) (c) and (1:10) (d).</a:t>
            </a:r>
            <a:endParaRPr lang="en-US" sz="1600" kern="100" dirty="0">
              <a:effectLst/>
              <a:latin typeface="Palatino Linotype" panose="02040502050505030304" pitchFamily="18" charset="0"/>
              <a:ea typeface="宋体" charset="-122"/>
            </a:endParaRPr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2"/>
          </p:nvPr>
        </p:nvSpPr>
        <p:spPr>
          <a:xfrm>
            <a:off x="6942791" y="6492875"/>
            <a:ext cx="2057400" cy="365125"/>
          </a:xfrm>
        </p:spPr>
        <p:txBody>
          <a:bodyPr/>
          <a:lstStyle/>
          <a:p>
            <a:fld id="{8F01CB92-9702-B148-96E8-27B75B4B5931}" type="slidenum">
              <a:rPr lang="en-US" smtClean="0"/>
              <a:t>4</a:t>
            </a:fld>
            <a:endParaRPr lang="en-US" dirty="0"/>
          </a:p>
        </p:txBody>
      </p:sp>
      <p:grpSp>
        <p:nvGrpSpPr>
          <p:cNvPr id="13" name="Group 12"/>
          <p:cNvGrpSpPr/>
          <p:nvPr/>
        </p:nvGrpSpPr>
        <p:grpSpPr>
          <a:xfrm>
            <a:off x="0" y="0"/>
            <a:ext cx="9320231" cy="5464495"/>
            <a:chOff x="0" y="0"/>
            <a:chExt cx="9320231" cy="5464495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3827976"/>
                </p:ext>
              </p:extLst>
            </p:nvPr>
          </p:nvGraphicFramePr>
          <p:xfrm>
            <a:off x="4656791" y="461942"/>
            <a:ext cx="237744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3535533"/>
                </p:ext>
              </p:extLst>
            </p:nvPr>
          </p:nvGraphicFramePr>
          <p:xfrm>
            <a:off x="2368201" y="491619"/>
            <a:ext cx="237744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08606106"/>
                </p:ext>
              </p:extLst>
            </p:nvPr>
          </p:nvGraphicFramePr>
          <p:xfrm>
            <a:off x="6942791" y="506726"/>
            <a:ext cx="2377440" cy="22714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3" name="TextBox 2"/>
            <p:cNvSpPr txBox="1"/>
            <p:nvPr/>
          </p:nvSpPr>
          <p:spPr>
            <a:xfrm>
              <a:off x="3047909" y="339457"/>
              <a:ext cx="11411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OA/DOPC (1:1)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409285" y="324589"/>
              <a:ext cx="11411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OA/DOPC (1:5)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685841" y="343174"/>
              <a:ext cx="12196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OA/DOPC (1:10)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093715" y="2992510"/>
              <a:ext cx="8803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Time (min)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93910" y="19744"/>
              <a:ext cx="43633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a)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682946" y="19744"/>
              <a:ext cx="4475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b)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981099" y="0"/>
              <a:ext cx="4235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(c)</a:t>
              </a:r>
              <a:endParaRPr lang="en-US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215959" y="0"/>
              <a:ext cx="4475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d)</a:t>
              </a:r>
            </a:p>
          </p:txBody>
        </p:sp>
        <p:graphicFrame>
          <p:nvGraphicFramePr>
            <p:cNvPr id="21" name="Chart 2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74702170"/>
                </p:ext>
              </p:extLst>
            </p:nvPr>
          </p:nvGraphicFramePr>
          <p:xfrm>
            <a:off x="1" y="3080110"/>
            <a:ext cx="2639028" cy="238438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22" name="Chart 2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6019429"/>
                </p:ext>
              </p:extLst>
            </p:nvPr>
          </p:nvGraphicFramePr>
          <p:xfrm>
            <a:off x="0" y="522514"/>
            <a:ext cx="2453833" cy="226698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23" name="TextBox 22"/>
            <p:cNvSpPr txBox="1"/>
            <p:nvPr/>
          </p:nvSpPr>
          <p:spPr>
            <a:xfrm>
              <a:off x="468086" y="2806489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(e)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6368120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89098" y="5288340"/>
            <a:ext cx="8973879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b="1" kern="100" dirty="0">
                <a:latin typeface="Palatino Linotype" panose="02040502050505030304" pitchFamily="18" charset="0"/>
                <a:ea typeface="宋体" charset="-122"/>
              </a:rPr>
              <a:t>Figure S5</a:t>
            </a:r>
            <a:r>
              <a:rPr lang="en-US" sz="1600" kern="100" dirty="0">
                <a:latin typeface="Palatino Linotype" panose="02040502050505030304" pitchFamily="18" charset="0"/>
                <a:ea typeface="宋体" charset="-122"/>
              </a:rPr>
              <a:t>. Permeability of Na</a:t>
            </a:r>
            <a:r>
              <a:rPr lang="en-US" sz="1600" kern="100" baseline="30000" dirty="0">
                <a:latin typeface="Palatino Linotype" panose="02040502050505030304" pitchFamily="18" charset="0"/>
                <a:ea typeface="宋体" charset="-122"/>
              </a:rPr>
              <a:t>+</a:t>
            </a:r>
            <a:r>
              <a:rPr lang="en-US" sz="1600" kern="100" dirty="0">
                <a:latin typeface="Palatino Linotype" panose="02040502050505030304" pitchFamily="18" charset="0"/>
                <a:ea typeface="宋体" charset="-122"/>
              </a:rPr>
              <a:t> across mixed OA/DOPC membranes in the absence (a) and presence (e) of ionophore: comparison of various OA/DOPC compositions. (b)-(d) permeability in the absence and presence of </a:t>
            </a:r>
            <a:r>
              <a:rPr lang="en-US" sz="1600" kern="100" dirty="0" err="1">
                <a:latin typeface="Palatino Linotype" panose="02040502050505030304" pitchFamily="18" charset="0"/>
                <a:ea typeface="宋体" charset="-122"/>
              </a:rPr>
              <a:t>monensin</a:t>
            </a:r>
            <a:r>
              <a:rPr lang="en-US" sz="1600" kern="100" dirty="0">
                <a:latin typeface="Palatino Linotype" panose="02040502050505030304" pitchFamily="18" charset="0"/>
                <a:ea typeface="宋体" charset="-122"/>
              </a:rPr>
              <a:t>, a Na</a:t>
            </a:r>
            <a:r>
              <a:rPr lang="en-US" sz="1600" kern="100" baseline="30000" dirty="0">
                <a:latin typeface="Palatino Linotype" panose="02040502050505030304" pitchFamily="18" charset="0"/>
                <a:ea typeface="宋体" charset="-122"/>
              </a:rPr>
              <a:t>+</a:t>
            </a:r>
            <a:r>
              <a:rPr lang="en-US" sz="1600" kern="100" dirty="0">
                <a:latin typeface="Palatino Linotype" panose="02040502050505030304" pitchFamily="18" charset="0"/>
                <a:ea typeface="宋体" charset="-122"/>
              </a:rPr>
              <a:t>-ion transporter across membranes, as a positive control for OA/DOPC ratios of 1:1 (b); (1:5) (c) and (1:10) (d).</a:t>
            </a:r>
            <a:endParaRPr lang="en-US" sz="1600" kern="100" dirty="0">
              <a:effectLst/>
              <a:latin typeface="Palatino Linotype" panose="02040502050505030304" pitchFamily="18" charset="0"/>
              <a:ea typeface="宋体" charset="-122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7101140" y="6492875"/>
            <a:ext cx="2057400" cy="365125"/>
          </a:xfrm>
        </p:spPr>
        <p:txBody>
          <a:bodyPr/>
          <a:lstStyle/>
          <a:p>
            <a:fld id="{8F01CB92-9702-B148-96E8-27B75B4B5931}" type="slidenum">
              <a:rPr lang="en-US" smtClean="0"/>
              <a:t>5</a:t>
            </a:fld>
            <a:endParaRPr lang="en-US" dirty="0"/>
          </a:p>
        </p:txBody>
      </p:sp>
      <p:grpSp>
        <p:nvGrpSpPr>
          <p:cNvPr id="5" name="Group 4"/>
          <p:cNvGrpSpPr/>
          <p:nvPr/>
        </p:nvGrpSpPr>
        <p:grpSpPr>
          <a:xfrm>
            <a:off x="0" y="0"/>
            <a:ext cx="9310940" cy="5393803"/>
            <a:chOff x="0" y="0"/>
            <a:chExt cx="9310940" cy="5393803"/>
          </a:xfrm>
        </p:grpSpPr>
        <p:graphicFrame>
          <p:nvGraphicFramePr>
            <p:cNvPr id="9" name="Chart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70348321"/>
                </p:ext>
              </p:extLst>
            </p:nvPr>
          </p:nvGraphicFramePr>
          <p:xfrm>
            <a:off x="2361501" y="423088"/>
            <a:ext cx="237744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1" name="Chart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24714486"/>
                </p:ext>
              </p:extLst>
            </p:nvPr>
          </p:nvGraphicFramePr>
          <p:xfrm>
            <a:off x="6933500" y="420392"/>
            <a:ext cx="237744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" name="TextBox 1"/>
            <p:cNvSpPr txBox="1"/>
            <p:nvPr/>
          </p:nvSpPr>
          <p:spPr>
            <a:xfrm>
              <a:off x="4450792" y="2759149"/>
              <a:ext cx="8803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Time (min)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196468" y="185251"/>
              <a:ext cx="11411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OA/DOPC (1:1)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556809" y="170383"/>
              <a:ext cx="11411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OA/DOPC (1:5)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7812098" y="188968"/>
              <a:ext cx="12196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OA/DOPC (1:10)</a:t>
              </a:r>
            </a:p>
          </p:txBody>
        </p:sp>
        <p:graphicFrame>
          <p:nvGraphicFramePr>
            <p:cNvPr id="40" name="Chart 3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21794597"/>
                </p:ext>
              </p:extLst>
            </p:nvPr>
          </p:nvGraphicFramePr>
          <p:xfrm>
            <a:off x="4658655" y="404563"/>
            <a:ext cx="237744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5" name="TextBox 24"/>
            <p:cNvSpPr txBox="1"/>
            <p:nvPr/>
          </p:nvSpPr>
          <p:spPr>
            <a:xfrm>
              <a:off x="337454" y="85060"/>
              <a:ext cx="43633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(a)</a:t>
              </a:r>
              <a:endParaRPr lang="en-US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682946" y="85060"/>
              <a:ext cx="4475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b)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915783" y="0"/>
              <a:ext cx="4235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(c)</a:t>
              </a:r>
              <a:endParaRPr lang="en-US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215959" y="0"/>
              <a:ext cx="4475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d)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18214" y="2895599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e)</a:t>
              </a:r>
            </a:p>
          </p:txBody>
        </p:sp>
        <p:graphicFrame>
          <p:nvGraphicFramePr>
            <p:cNvPr id="20" name="Chart 1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30947211"/>
                </p:ext>
              </p:extLst>
            </p:nvPr>
          </p:nvGraphicFramePr>
          <p:xfrm>
            <a:off x="0" y="428263"/>
            <a:ext cx="2384385" cy="232651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21" name="Chart 2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36597414"/>
                </p:ext>
              </p:extLst>
            </p:nvPr>
          </p:nvGraphicFramePr>
          <p:xfrm>
            <a:off x="0" y="3206187"/>
            <a:ext cx="2558005" cy="21876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106531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4118679"/>
              </p:ext>
            </p:extLst>
          </p:nvPr>
        </p:nvGraphicFramePr>
        <p:xfrm>
          <a:off x="1523396" y="138404"/>
          <a:ext cx="6281661" cy="31775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8488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33660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6017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600" b="1" dirty="0">
                          <a:latin typeface="+mn-lt"/>
                        </a:rPr>
                        <a:t>p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600" dirty="0">
                          <a:latin typeface="+mn-lt"/>
                        </a:rPr>
                        <a:t>Na</a:t>
                      </a:r>
                      <a:r>
                        <a:rPr lang="en-US" sz="1600" baseline="30000" dirty="0">
                          <a:latin typeface="+mn-lt"/>
                        </a:rPr>
                        <a:t>+</a:t>
                      </a:r>
                      <a:r>
                        <a:rPr lang="en-US" sz="1600" dirty="0">
                          <a:latin typeface="+mn-lt"/>
                        </a:rPr>
                        <a:t> </a:t>
                      </a:r>
                      <a:r>
                        <a:rPr lang="en-US" sz="1600" i="1" dirty="0" err="1">
                          <a:latin typeface="+mn-lt"/>
                        </a:rPr>
                        <a:t>K</a:t>
                      </a:r>
                      <a:r>
                        <a:rPr lang="en-US" sz="1600" baseline="-25000" dirty="0" err="1">
                          <a:latin typeface="+mn-lt"/>
                        </a:rPr>
                        <a:t>d</a:t>
                      </a:r>
                      <a:r>
                        <a:rPr lang="en-US" sz="1600" dirty="0">
                          <a:latin typeface="+mn-lt"/>
                        </a:rPr>
                        <a:t> (</a:t>
                      </a:r>
                      <a:r>
                        <a:rPr lang="en-US" sz="1600" dirty="0" err="1">
                          <a:latin typeface="+mn-lt"/>
                        </a:rPr>
                        <a:t>mM</a:t>
                      </a:r>
                      <a:r>
                        <a:rPr lang="en-US" sz="1600" dirty="0">
                          <a:latin typeface="+mn-lt"/>
                        </a:rPr>
                        <a:t>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+mn-lt"/>
                        </a:rPr>
                        <a:t>K</a:t>
                      </a:r>
                      <a:r>
                        <a:rPr lang="en-US" sz="1600" baseline="30000" dirty="0">
                          <a:latin typeface="+mn-lt"/>
                        </a:rPr>
                        <a:t>+</a:t>
                      </a:r>
                      <a:r>
                        <a:rPr lang="en-US" sz="1600" dirty="0">
                          <a:latin typeface="+mn-lt"/>
                        </a:rPr>
                        <a:t> </a:t>
                      </a:r>
                      <a:r>
                        <a:rPr lang="en-US" sz="1600" i="1" dirty="0" err="1">
                          <a:latin typeface="+mn-lt"/>
                        </a:rPr>
                        <a:t>K</a:t>
                      </a:r>
                      <a:r>
                        <a:rPr lang="en-US" sz="1600" baseline="-25000" dirty="0" err="1">
                          <a:latin typeface="+mn-lt"/>
                        </a:rPr>
                        <a:t>d</a:t>
                      </a:r>
                      <a:r>
                        <a:rPr lang="en-US" sz="1600" dirty="0">
                          <a:latin typeface="+mn-lt"/>
                        </a:rPr>
                        <a:t> (</a:t>
                      </a:r>
                      <a:r>
                        <a:rPr lang="en-US" sz="1600" dirty="0" err="1">
                          <a:latin typeface="+mn-lt"/>
                        </a:rPr>
                        <a:t>mM</a:t>
                      </a:r>
                      <a:r>
                        <a:rPr lang="en-US" sz="1600" dirty="0">
                          <a:latin typeface="+mn-lt"/>
                        </a:rPr>
                        <a:t>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61839">
                <a:tc>
                  <a:txBody>
                    <a:bodyPr/>
                    <a:lstStyle/>
                    <a:p>
                      <a:pPr algn="l" fontAlgn="ctr">
                        <a:lnSpc>
                          <a:spcPct val="200000"/>
                        </a:lnSpc>
                      </a:pPr>
                      <a:r>
                        <a:rPr lang="hr-H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7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r-H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6.105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</a:t>
                      </a:r>
                      <a:r>
                        <a:rPr lang="en-US" sz="14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ru-RU" sz="1400" u="none" strike="noStrike" dirty="0">
                          <a:effectLst/>
                        </a:rPr>
                        <a:t>0.535</a:t>
                      </a:r>
                      <a:endParaRPr lang="ru-RU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r-H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4.448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</a:t>
                      </a:r>
                      <a:r>
                        <a:rPr lang="en-US" sz="14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nb-NO" sz="1400" u="none" strike="noStrike" dirty="0">
                          <a:effectLst/>
                        </a:rPr>
                        <a:t>0.397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61839">
                <a:tc>
                  <a:txBody>
                    <a:bodyPr/>
                    <a:lstStyle/>
                    <a:p>
                      <a:pPr algn="l" fontAlgn="ctr">
                        <a:lnSpc>
                          <a:spcPct val="200000"/>
                        </a:lnSpc>
                      </a:pPr>
                      <a:r>
                        <a:rPr lang="hr-H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0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5.590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</a:t>
                      </a:r>
                      <a:r>
                        <a:rPr lang="en-US" sz="14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r-HR" sz="1400" u="none" strike="noStrike" dirty="0">
                          <a:effectLst/>
                        </a:rPr>
                        <a:t>0.526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r-H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4.533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</a:t>
                      </a:r>
                      <a:r>
                        <a:rPr lang="en-US" sz="14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nb-NO" sz="1400" u="none" strike="noStrike" dirty="0">
                          <a:effectLst/>
                        </a:rPr>
                        <a:t>0.466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61839">
                <a:tc>
                  <a:txBody>
                    <a:bodyPr/>
                    <a:lstStyle/>
                    <a:p>
                      <a:pPr algn="l" fontAlgn="ctr">
                        <a:lnSpc>
                          <a:spcPct val="200000"/>
                        </a:lnSpc>
                      </a:pPr>
                      <a:r>
                        <a:rPr lang="hr-H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5.834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</a:t>
                      </a:r>
                      <a:r>
                        <a:rPr lang="en-US" sz="14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nb-NO" sz="1400" u="none" strike="noStrike" dirty="0">
                          <a:effectLst/>
                        </a:rPr>
                        <a:t>0.520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uk-U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4.39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2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</a:t>
                      </a:r>
                      <a:r>
                        <a:rPr lang="en-US" sz="14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uk-UA" sz="1400" u="none" strike="noStrike" dirty="0">
                          <a:effectLst/>
                        </a:rPr>
                        <a:t>0.398</a:t>
                      </a:r>
                      <a:endParaRPr lang="uk-UA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61839">
                <a:tc>
                  <a:txBody>
                    <a:bodyPr/>
                    <a:lstStyle/>
                    <a:p>
                      <a:pPr algn="l" fontAlgn="ctr">
                        <a:lnSpc>
                          <a:spcPct val="200000"/>
                        </a:lnSpc>
                      </a:pPr>
                      <a:r>
                        <a:rPr lang="hr-H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.0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r-H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6.116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</a:t>
                      </a:r>
                      <a:r>
                        <a:rPr lang="en-US" sz="14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nb-NO" sz="1400" u="none" strike="noStrike" dirty="0">
                          <a:effectLst/>
                        </a:rPr>
                        <a:t>0.623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r-H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4.151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</a:t>
                      </a:r>
                      <a:r>
                        <a:rPr lang="en-US" sz="14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is-IS" sz="1400" u="none" strike="noStrike" dirty="0">
                          <a:effectLst/>
                        </a:rPr>
                        <a:t>0.422</a:t>
                      </a:r>
                      <a:endParaRPr lang="is-I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61839">
                <a:tc>
                  <a:txBody>
                    <a:bodyPr/>
                    <a:lstStyle/>
                    <a:p>
                      <a:pPr algn="l" fontAlgn="ctr">
                        <a:lnSpc>
                          <a:spcPct val="200000"/>
                        </a:lnSpc>
                      </a:pPr>
                      <a:r>
                        <a:rPr lang="hr-H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.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r-H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5.914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</a:t>
                      </a:r>
                      <a:r>
                        <a:rPr lang="en-US" sz="14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cs-CZ" sz="1400" u="none" strike="noStrike" dirty="0">
                          <a:effectLst/>
                        </a:rPr>
                        <a:t>0.522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3.613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</a:t>
                      </a:r>
                      <a:r>
                        <a:rPr lang="en-US" sz="14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nb-NO" sz="1400" u="none" strike="noStrike" dirty="0">
                          <a:effectLst/>
                        </a:rPr>
                        <a:t>0.375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61839">
                <a:tc>
                  <a:txBody>
                    <a:bodyPr/>
                    <a:lstStyle/>
                    <a:p>
                      <a:pPr algn="l" fontAlgn="ctr">
                        <a:lnSpc>
                          <a:spcPct val="200000"/>
                        </a:lnSpc>
                      </a:pPr>
                      <a:r>
                        <a:rPr lang="hr-H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.0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r-H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6.631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</a:t>
                      </a:r>
                      <a:r>
                        <a:rPr lang="en-US" sz="14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nb-NO" sz="1400" u="none" strike="noStrike" dirty="0">
                          <a:effectLst/>
                        </a:rPr>
                        <a:t>0.635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3.403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</a:t>
                      </a:r>
                      <a:r>
                        <a:rPr lang="en-US" sz="14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it-IT" sz="1400" u="none" strike="noStrike" dirty="0">
                          <a:effectLst/>
                        </a:rPr>
                        <a:t>0.359</a:t>
                      </a:r>
                      <a:r>
                        <a:rPr lang="it-IT" sz="1400" u="none" strike="noStrike" baseline="0" dirty="0">
                          <a:effectLst/>
                        </a:rPr>
                        <a:t> </a:t>
                      </a:r>
                      <a:endParaRPr lang="it-I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graphicFrame>
        <p:nvGraphicFramePr>
          <p:cNvPr id="5" name="对象 3"/>
          <p:cNvGraphicFramePr>
            <a:graphicFrameLocks noChangeAspect="1"/>
          </p:cNvGraphicFramePr>
          <p:nvPr>
            <p:extLst/>
          </p:nvPr>
        </p:nvGraphicFramePr>
        <p:xfrm>
          <a:off x="107504" y="3284984"/>
          <a:ext cx="4187424" cy="29260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6" name="Graph" r:id="rId4" imgW="4153680" imgH="2901600" progId="Origin50.Graph">
                  <p:embed/>
                </p:oleObj>
              </mc:Choice>
              <mc:Fallback>
                <p:oleObj name="Graph" r:id="rId4" imgW="4153680" imgH="29016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7504" y="3284984"/>
                        <a:ext cx="4187424" cy="29260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8" name="Group 7"/>
          <p:cNvGrpSpPr/>
          <p:nvPr/>
        </p:nvGrpSpPr>
        <p:grpSpPr>
          <a:xfrm>
            <a:off x="4849072" y="3284984"/>
            <a:ext cx="4187424" cy="2926080"/>
            <a:chOff x="4956576" y="3429000"/>
            <a:chExt cx="4187424" cy="2926080"/>
          </a:xfrm>
        </p:grpSpPr>
        <p:graphicFrame>
          <p:nvGraphicFramePr>
            <p:cNvPr id="6" name="对象 3"/>
            <p:cNvGraphicFramePr>
              <a:graphicFrameLocks noChangeAspect="1"/>
            </p:cNvGraphicFramePr>
            <p:nvPr>
              <p:extLst/>
            </p:nvPr>
          </p:nvGraphicFramePr>
          <p:xfrm>
            <a:off x="4956576" y="3429000"/>
            <a:ext cx="4187424" cy="292608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87" name="Graph" r:id="rId6" imgW="4153680" imgH="2901600" progId="Origin50.Graph">
                    <p:embed/>
                  </p:oleObj>
                </mc:Choice>
                <mc:Fallback>
                  <p:oleObj name="Graph" r:id="rId6" imgW="4153680" imgH="2901600" progId="Origin50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956576" y="3429000"/>
                          <a:ext cx="4187424" cy="292608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" name="TextBox 1"/>
            <p:cNvSpPr txBox="1"/>
            <p:nvPr/>
          </p:nvSpPr>
          <p:spPr>
            <a:xfrm rot="16200000">
              <a:off x="5177795" y="4613316"/>
              <a:ext cx="470000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100" dirty="0" err="1"/>
                <a:t>K</a:t>
              </a:r>
              <a:r>
                <a:rPr lang="en-US" sz="1100" baseline="-25000" dirty="0" err="1"/>
                <a:t>d</a:t>
              </a:r>
              <a:r>
                <a:rPr lang="en-US" sz="1100" dirty="0"/>
                <a:t>, </a:t>
              </a:r>
              <a:r>
                <a:rPr lang="en-US" sz="1100" baseline="-25000" dirty="0"/>
                <a:t>K+</a:t>
              </a:r>
            </a:p>
          </p:txBody>
        </p:sp>
      </p:grpSp>
      <p:sp>
        <p:nvSpPr>
          <p:cNvPr id="4" name="Rectangle 3"/>
          <p:cNvSpPr/>
          <p:nvPr/>
        </p:nvSpPr>
        <p:spPr>
          <a:xfrm>
            <a:off x="0" y="6035266"/>
            <a:ext cx="9644742" cy="5162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600" b="1" kern="100" dirty="0">
                <a:latin typeface="Palatino Linotype" panose="02040502050505030304" pitchFamily="18" charset="0"/>
                <a:ea typeface="SimSun" charset="-122"/>
              </a:rPr>
              <a:t>Table S1: The </a:t>
            </a:r>
            <a:r>
              <a:rPr lang="en-US" sz="1600" kern="100" dirty="0">
                <a:latin typeface="Palatino Linotype" panose="02040502050505030304" pitchFamily="18" charset="0"/>
                <a:ea typeface="SimSun" charset="-122"/>
              </a:rPr>
              <a:t>dissociation constant, </a:t>
            </a:r>
            <a:r>
              <a:rPr lang="en-US" sz="1600" i="1" kern="100" dirty="0" err="1">
                <a:latin typeface="Palatino Linotype" panose="02040502050505030304" pitchFamily="18" charset="0"/>
                <a:ea typeface="SimSun" charset="-122"/>
              </a:rPr>
              <a:t>K</a:t>
            </a:r>
            <a:r>
              <a:rPr lang="en-US" sz="1600" i="1" kern="100" baseline="-25000" dirty="0" err="1">
                <a:latin typeface="Palatino Linotype" panose="02040502050505030304" pitchFamily="18" charset="0"/>
                <a:ea typeface="SimSun" charset="-122"/>
              </a:rPr>
              <a:t>d</a:t>
            </a:r>
            <a:r>
              <a:rPr lang="en-US" sz="1600" i="1" kern="100" dirty="0">
                <a:latin typeface="Palatino Linotype" panose="02040502050505030304" pitchFamily="18" charset="0"/>
                <a:ea typeface="SimSun" charset="-122"/>
              </a:rPr>
              <a:t>,</a:t>
            </a:r>
            <a:r>
              <a:rPr lang="en-US" sz="1600" i="1" kern="100" baseline="-25000" dirty="0">
                <a:latin typeface="Palatino Linotype" panose="02040502050505030304" pitchFamily="18" charset="0"/>
                <a:ea typeface="SimSun" charset="-122"/>
              </a:rPr>
              <a:t> </a:t>
            </a:r>
            <a:r>
              <a:rPr lang="en-US" sz="1600" kern="100" dirty="0">
                <a:latin typeface="Palatino Linotype" panose="02040502050505030304" pitchFamily="18" charset="0"/>
                <a:ea typeface="SimSun" charset="-122"/>
              </a:rPr>
              <a:t>for calculating the concentration of intra-vesicular Na</a:t>
            </a:r>
            <a:r>
              <a:rPr lang="en-US" sz="1600" kern="100" baseline="30000" dirty="0">
                <a:latin typeface="Palatino Linotype" panose="02040502050505030304" pitchFamily="18" charset="0"/>
                <a:ea typeface="SimSun" charset="-122"/>
              </a:rPr>
              <a:t>+</a:t>
            </a:r>
            <a:r>
              <a:rPr lang="en-US" sz="1600" kern="100" dirty="0">
                <a:latin typeface="Palatino Linotype" panose="02040502050505030304" pitchFamily="18" charset="0"/>
                <a:ea typeface="SimSun" charset="-122"/>
              </a:rPr>
              <a:t> or K</a:t>
            </a:r>
            <a:r>
              <a:rPr lang="en-US" sz="1600" kern="100" baseline="30000" dirty="0">
                <a:latin typeface="Palatino Linotype" panose="02040502050505030304" pitchFamily="18" charset="0"/>
                <a:ea typeface="SimSun" charset="-122"/>
              </a:rPr>
              <a:t>+</a:t>
            </a:r>
            <a:r>
              <a:rPr lang="en-US" sz="1600" kern="100" dirty="0">
                <a:latin typeface="Palatino Linotype" panose="02040502050505030304" pitchFamily="18" charset="0"/>
                <a:ea typeface="SimSun" charset="-122"/>
              </a:rPr>
              <a:t>. </a:t>
            </a:r>
            <a:endParaRPr lang="en-US" sz="1200" kern="100" dirty="0">
              <a:effectLst/>
              <a:latin typeface="Palatino Linotype" panose="02040502050505030304" pitchFamily="18" charset="0"/>
              <a:ea typeface="SimSun" charset="-122"/>
            </a:endParaRPr>
          </a:p>
        </p:txBody>
      </p:sp>
      <p:sp>
        <p:nvSpPr>
          <p:cNvPr id="9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7086600" y="6492875"/>
            <a:ext cx="2057400" cy="365125"/>
          </a:xfrm>
        </p:spPr>
        <p:txBody>
          <a:bodyPr/>
          <a:lstStyle/>
          <a:p>
            <a:r>
              <a:rPr lang="en-US" dirty="0"/>
              <a:t>11</a:t>
            </a:r>
          </a:p>
        </p:txBody>
      </p:sp>
    </p:spTree>
    <p:extLst>
      <p:ext uri="{BB962C8B-B14F-4D97-AF65-F5344CB8AC3E}">
        <p14:creationId xmlns:p14="http://schemas.microsoft.com/office/powerpoint/2010/main" val="17758713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192547"/>
              </p:ext>
            </p:extLst>
          </p:nvPr>
        </p:nvGraphicFramePr>
        <p:xfrm>
          <a:off x="752354" y="1396999"/>
          <a:ext cx="7836059" cy="369764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194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1943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1943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1943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1943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1943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11943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554032">
                <a:tc>
                  <a:txBody>
                    <a:bodyPr/>
                    <a:lstStyle/>
                    <a:p>
                      <a:r>
                        <a:rPr lang="en-US" sz="1400" baseline="0" dirty="0">
                          <a:latin typeface="+mn-lt"/>
                        </a:rPr>
                        <a:t>[Na</a:t>
                      </a:r>
                      <a:r>
                        <a:rPr lang="en-US" sz="1400" baseline="30000" dirty="0">
                          <a:latin typeface="+mn-lt"/>
                        </a:rPr>
                        <a:t>+</a:t>
                      </a:r>
                      <a:r>
                        <a:rPr lang="en-US" sz="1400" baseline="0" dirty="0">
                          <a:latin typeface="+mn-lt"/>
                        </a:rPr>
                        <a:t>] or [K</a:t>
                      </a:r>
                      <a:r>
                        <a:rPr lang="en-US" sz="1400" baseline="30000" dirty="0">
                          <a:latin typeface="+mn-lt"/>
                        </a:rPr>
                        <a:t>+</a:t>
                      </a:r>
                      <a:r>
                        <a:rPr lang="en-US" sz="1400" baseline="0" dirty="0">
                          <a:latin typeface="+mn-lt"/>
                        </a:rPr>
                        <a:t>] (</a:t>
                      </a:r>
                      <a:r>
                        <a:rPr lang="en-US" sz="1400" baseline="0" dirty="0" err="1">
                          <a:latin typeface="+mn-lt"/>
                        </a:rPr>
                        <a:t>mM</a:t>
                      </a:r>
                      <a:r>
                        <a:rPr lang="en-US" sz="1400" baseline="0" dirty="0">
                          <a:latin typeface="+mn-lt"/>
                        </a:rPr>
                        <a:t>)</a:t>
                      </a:r>
                      <a:endParaRPr lang="en-US" sz="14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 gridSpan="2">
                  <a:txBody>
                    <a:bodyPr/>
                    <a:lstStyle/>
                    <a:p>
                      <a:r>
                        <a:rPr lang="en-US" sz="1400" dirty="0">
                          <a:latin typeface="+mn-lt"/>
                        </a:rPr>
                        <a:t>OA/DOPC (1:1)</a:t>
                      </a:r>
                    </a:p>
                    <a:p>
                      <a:r>
                        <a:rPr lang="en-US" sz="1400" dirty="0">
                          <a:latin typeface="+mn-lt"/>
                        </a:rPr>
                        <a:t>Z-average  (nm)</a:t>
                      </a:r>
                    </a:p>
                  </a:txBody>
                  <a:tcPr marL="68580" marR="68580" marT="34290" marB="34290"/>
                </a:tc>
                <a:tc hMerge="1">
                  <a:txBody>
                    <a:bodyPr/>
                    <a:lstStyle/>
                    <a:p>
                      <a:endParaRPr lang="en-US" sz="14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 grid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+mn-lt"/>
                        </a:rPr>
                        <a:t>OA/DOPC (1:5) </a:t>
                      </a:r>
                    </a:p>
                    <a:p>
                      <a:r>
                        <a:rPr lang="en-US" sz="1400" dirty="0">
                          <a:latin typeface="+mn-lt"/>
                        </a:rPr>
                        <a:t>Z-average  (nm)</a:t>
                      </a:r>
                    </a:p>
                  </a:txBody>
                  <a:tcPr marL="68580" marR="68580" marT="34290" marB="34290"/>
                </a:tc>
                <a:tc h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 grid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+mn-lt"/>
                        </a:rPr>
                        <a:t>OA/DOPC (1:10) </a:t>
                      </a:r>
                    </a:p>
                    <a:p>
                      <a:r>
                        <a:rPr lang="en-US" sz="1400" dirty="0">
                          <a:latin typeface="+mn-lt"/>
                        </a:rPr>
                        <a:t>Z-average  (nm)</a:t>
                      </a:r>
                    </a:p>
                  </a:txBody>
                  <a:tcPr marL="68580" marR="68580" marT="34290" marB="34290"/>
                </a:tc>
                <a:tc h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5517">
                <a:tc>
                  <a:txBody>
                    <a:bodyPr/>
                    <a:lstStyle/>
                    <a:p>
                      <a:endParaRPr lang="en-US" sz="1400" dirty="0">
                        <a:latin typeface="+mn-lt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+mn-lt"/>
                        </a:rPr>
                        <a:t>Na</a:t>
                      </a:r>
                      <a:r>
                        <a:rPr lang="en-US" sz="1400" b="1" baseline="30000" dirty="0">
                          <a:latin typeface="+mn-lt"/>
                        </a:rPr>
                        <a:t>+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+mn-lt"/>
                        </a:rPr>
                        <a:t>K</a:t>
                      </a:r>
                      <a:r>
                        <a:rPr lang="en-US" sz="1400" b="1" baseline="30000" dirty="0">
                          <a:latin typeface="+mn-lt"/>
                        </a:rPr>
                        <a:t>+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+mn-lt"/>
                        </a:rPr>
                        <a:t>Na</a:t>
                      </a:r>
                      <a:r>
                        <a:rPr lang="en-US" sz="1400" b="1" baseline="30000" dirty="0">
                          <a:latin typeface="+mn-lt"/>
                        </a:rPr>
                        <a:t>+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+mn-lt"/>
                        </a:rPr>
                        <a:t>K</a:t>
                      </a:r>
                      <a:r>
                        <a:rPr lang="en-US" sz="1400" b="1" baseline="30000" dirty="0">
                          <a:latin typeface="+mn-lt"/>
                        </a:rPr>
                        <a:t>+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+mn-lt"/>
                        </a:rPr>
                        <a:t>Na</a:t>
                      </a:r>
                      <a:r>
                        <a:rPr lang="en-US" sz="1400" b="1" baseline="30000" dirty="0">
                          <a:latin typeface="+mn-lt"/>
                        </a:rPr>
                        <a:t>+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+mn-lt"/>
                        </a:rPr>
                        <a:t>K</a:t>
                      </a:r>
                      <a:r>
                        <a:rPr lang="en-US" sz="1400" b="1" baseline="30000" dirty="0">
                          <a:latin typeface="+mn-lt"/>
                        </a:rPr>
                        <a:t>+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76350"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+mn-lt"/>
                        </a:rPr>
                        <a:t>0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0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</a:t>
                      </a:r>
                      <a:r>
                        <a:rPr lang="en-US" sz="14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6</a:t>
                      </a: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0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</a:t>
                      </a:r>
                      <a:r>
                        <a:rPr lang="en-US" sz="14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</a:t>
                      </a: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0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1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1.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1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0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76350"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+mn-lt"/>
                        </a:rPr>
                        <a:t>40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uk-U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1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8</a:t>
                      </a:r>
                      <a:endParaRPr lang="uk-UA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uk-U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9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8</a:t>
                      </a:r>
                      <a:endParaRPr lang="uk-UA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2</a:t>
                      </a:r>
                      <a:r>
                        <a:rPr lang="is-I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2</a:t>
                      </a:r>
                      <a:endParaRPr lang="is-I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1</a:t>
                      </a:r>
                      <a:r>
                        <a:rPr lang="is-I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1.6</a:t>
                      </a:r>
                      <a:endParaRPr lang="is-I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1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1.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9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76350"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+mn-lt"/>
                        </a:rPr>
                        <a:t>50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uk-U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1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5</a:t>
                      </a:r>
                      <a:endParaRPr lang="uk-UA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uk-U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6</a:t>
                      </a:r>
                      <a:endParaRPr lang="uk-UA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1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1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1.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9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1.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6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76350"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+mn-lt"/>
                        </a:rPr>
                        <a:t>75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cs-CZ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9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5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cs-CZ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9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7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8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</a:t>
                      </a:r>
                      <a:endParaRPr lang="ru-RU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0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9</a:t>
                      </a:r>
                      <a:endParaRPr lang="ru-RU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7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1.9</a:t>
                      </a:r>
                      <a:endParaRPr lang="is-I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5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9</a:t>
                      </a:r>
                    </a:p>
                    <a:p>
                      <a:pPr algn="l" fontAlgn="b"/>
                      <a:endParaRPr lang="en-US" sz="1400" b="0" i="0" u="none" strike="noStrike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63" marR="4763" marT="4763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76350"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+mn-lt"/>
                        </a:rPr>
                        <a:t>200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5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1.0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6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9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l" fontAlgn="b"/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9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1.8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l" fontAlgn="b"/>
                      <a:endParaRPr lang="ru-RU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4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4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l" fontAlgn="b"/>
                      <a:endParaRPr lang="ru-RU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8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1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3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9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l" fontAlgn="b"/>
                      <a:endParaRPr lang="en-US" sz="1400" b="0" i="0" u="none" strike="noStrike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63" marR="4763" marT="4763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76350"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+mn-lt"/>
                        </a:rPr>
                        <a:t>400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4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6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l" fontAlgn="b"/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6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7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5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0.7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l" fontAlgn="b"/>
                      <a:endParaRPr lang="ru-RU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1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1.1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l" fontAlgn="b"/>
                      <a:endParaRPr lang="ru-RU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4763" marR="4763" marT="4763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0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 1.2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l" fontAlgn="b"/>
                      <a:endParaRPr lang="en-US" sz="1400" b="0" i="0" u="none" strike="noStrike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63" marR="4763" marT="4763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30629" y="5542117"/>
            <a:ext cx="8665028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  <a:ea typeface="Times New Roman" charset="0"/>
                <a:cs typeface="Times New Roman" charset="0"/>
              </a:rPr>
              <a:t> </a:t>
            </a:r>
            <a:r>
              <a:rPr lang="en-US" sz="1600" b="1" dirty="0">
                <a:latin typeface="Palatino Linotype" panose="02040502050505030304" pitchFamily="18" charset="0"/>
                <a:ea typeface="Times New Roman" charset="0"/>
                <a:cs typeface="Times New Roman" charset="0"/>
              </a:rPr>
              <a:t>Table S2:</a:t>
            </a:r>
            <a:r>
              <a:rPr lang="en-US" sz="1600" dirty="0">
                <a:latin typeface="Palatino Linotype" panose="02040502050505030304" pitchFamily="18" charset="0"/>
                <a:ea typeface="Times New Roman" charset="0"/>
                <a:cs typeface="Times New Roman" charset="0"/>
              </a:rPr>
              <a:t> Effect of Na</a:t>
            </a:r>
            <a:r>
              <a:rPr lang="en-US" sz="1600" baseline="30000" dirty="0">
                <a:latin typeface="Palatino Linotype" panose="02040502050505030304" pitchFamily="18" charset="0"/>
                <a:ea typeface="Times New Roman" charset="0"/>
                <a:cs typeface="Times New Roman" charset="0"/>
              </a:rPr>
              <a:t>+</a:t>
            </a:r>
            <a:r>
              <a:rPr lang="en-US" sz="1600" dirty="0">
                <a:latin typeface="Palatino Linotype" panose="02040502050505030304" pitchFamily="18" charset="0"/>
                <a:ea typeface="Times New Roman" charset="0"/>
                <a:cs typeface="Times New Roman" charset="0"/>
              </a:rPr>
              <a:t> and K</a:t>
            </a:r>
            <a:r>
              <a:rPr lang="en-US" sz="1600" baseline="30000" dirty="0">
                <a:latin typeface="Palatino Linotype" panose="02040502050505030304" pitchFamily="18" charset="0"/>
                <a:ea typeface="Times New Roman" charset="0"/>
                <a:cs typeface="Times New Roman" charset="0"/>
              </a:rPr>
              <a:t>+</a:t>
            </a:r>
            <a:r>
              <a:rPr lang="en-US" sz="1600" dirty="0">
                <a:latin typeface="Palatino Linotype" panose="02040502050505030304" pitchFamily="18" charset="0"/>
                <a:ea typeface="Times New Roman" charset="0"/>
                <a:cs typeface="Times New Roman" charset="0"/>
              </a:rPr>
              <a:t> on the size of vesicles to determine if osmotic pressure affects vesicle size by changing membrane </a:t>
            </a:r>
            <a:r>
              <a:rPr lang="en-US" sz="1600" dirty="0" smtClean="0">
                <a:latin typeface="Palatino Linotype" panose="02040502050505030304" pitchFamily="18" charset="0"/>
                <a:ea typeface="Times New Roman" charset="0"/>
                <a:cs typeface="Times New Roman" charset="0"/>
              </a:rPr>
              <a:t>structure</a:t>
            </a:r>
            <a:r>
              <a:rPr lang="en-US" sz="1600" dirty="0">
                <a:latin typeface="Palatino Linotype" panose="02040502050505030304" pitchFamily="18" charset="0"/>
                <a:ea typeface="Times New Roman" charset="0"/>
                <a:cs typeface="Times New Roman" charset="0"/>
              </a:rPr>
              <a:t>.</a:t>
            </a: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1CB92-9702-B148-96E8-27B75B4B5931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228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3</TotalTime>
  <Words>536</Words>
  <Application>Microsoft Office PowerPoint</Application>
  <PresentationFormat>On-screen Show (4:3)</PresentationFormat>
  <Paragraphs>121</Paragraphs>
  <Slides>7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6" baseType="lpstr">
      <vt:lpstr>SimSun</vt:lpstr>
      <vt:lpstr>SimSun</vt:lpstr>
      <vt:lpstr>Arial</vt:lpstr>
      <vt:lpstr>Calibri</vt:lpstr>
      <vt:lpstr>Calibri Light</vt:lpstr>
      <vt:lpstr>Palatino Linotype</vt:lpstr>
      <vt:lpstr>Times New Roman</vt:lpstr>
      <vt:lpstr>Office Theme</vt:lpstr>
      <vt:lpstr>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DPI</cp:lastModifiedBy>
  <cp:revision>115</cp:revision>
  <dcterms:created xsi:type="dcterms:W3CDTF">2019-05-19T07:21:10Z</dcterms:created>
  <dcterms:modified xsi:type="dcterms:W3CDTF">2020-04-26T03:59:17Z</dcterms:modified>
</cp:coreProperties>
</file>